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7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FA3EAC-110E-EAAB-11AA-7ADDDCC5E8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513DEC2-EC39-DB32-F60B-B1A0D8551F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97866E6-B65F-FFA4-AFDE-D811C944C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85DC06-24B2-AFD0-C51D-610A63C27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92059E-E7DE-96F4-8F8E-FABE81C4A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2666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2F4D41-EBF3-B62D-EDF0-C76812F8D2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E2E3E9D-3979-97A7-0F5E-2135B8C941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942134-185A-22EB-BA45-596B3F633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0A5FFD-A294-6E01-0669-017998EA8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C0C278-59D0-5472-40C4-DAFD091AE1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8414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22417CA-73A6-DEA2-E693-F7A0242A8E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AE2E29C-D424-5463-6DBC-C6877008FF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1C0ADD-4E8B-22DF-9C0C-22D48B6B2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3898E5-61F0-0BE0-F9CB-079350776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2684E2-35D7-9852-EEA7-7C218D628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8532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84A4E5-2C55-1FC6-007E-64F5A1204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2062B3D-CED1-16EA-07A1-805BCD4F9D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391A624-A3F7-854C-F727-45B048182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1CB003-C3BB-967D-8DA6-4A5F21F3D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7A9EF5-AC56-79D2-25A0-025A2076C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0249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CB16CD-B119-5279-EF85-F79389537D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81DE6F8-1BE3-1937-1EDF-3B22DB6BBA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C5493C-7018-8090-5017-B63D4D2265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524C52-241D-4728-996B-7587A8BB6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FFF79F8-F2AC-EA1F-44DD-C804DC08B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9666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289AC4-7FE4-1CF4-936F-6C2F5C7FCC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47AE372-9D2F-E9AF-3B5D-C0054DBDE0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9D65925-ADC1-F522-1C5C-33A9C17EB7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5A00A7B-D76A-F1D5-101E-295E3E2B4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ABEDF4B-9267-BFA4-5EE9-02D792649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76BCF77-5C0E-28E0-82FC-346247CBB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9532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1D18EE-C303-1CC1-BA11-393B58D40E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68B6E17-85C2-8971-1591-ED5313BC3B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96F797E-7626-2B80-948B-BAFCB3960A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914416B-DAC8-5466-D697-C8FCD218EC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F152E96-69ED-A746-E8FF-5A5EA50C92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035CD9F-E837-C0FC-BEC6-AD0F08351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A00D56B-99A3-9509-29DF-BFEA54FF5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90F1E4E-A3B3-8846-787D-864791FC0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1690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214E8D-D3D7-FA87-EEB6-E50D3234D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580541D-758C-635E-B316-81B25899A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88DA2C9-D89E-F6BC-35DB-8784F4CDE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22231FB-F605-D7AB-259C-EC463B8E8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1207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AAE7959-E125-DCB6-E122-4C4BAAE92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DF818F4-74C7-E96E-E8E1-528F8DB50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2ACC135-77AC-C297-D01F-E78BB1157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282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8EDC44-5BC6-8EE1-2BBE-525D7F5948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F1FE81-A457-FD0E-307A-0D37C8CA20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389FC3-24B8-EF32-3493-F3048224A2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39B537-B645-2FFB-F477-772C9730B9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F4E3028-8FBC-130A-F7F9-194D4D3AF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A0BB29-7D76-5B56-4652-23DD0E10E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6875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59D0A4-3A2D-E667-F0A8-8F10FF76E4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8254330-39E5-46AB-2A1B-6CE3525EF5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13B8A2A-1FF4-1672-E7CD-120D042821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865A9E8-FE50-761C-CF44-CCDE0EA3F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3B98CE9-8D4A-6B88-4FDE-2255E15A5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CA002B-4998-1AF9-ACA5-CC1B25C00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128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157953B-DBF5-6592-50E8-382F112F23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D82C9B9-6799-3AF2-06FA-2167562BD0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BC31B1-5CF1-D42C-EA5B-DDA3A06F46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2F2119-C58F-4CF3-ABAA-5CA897EFAA23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AE450C-D5C4-7E41-12F5-8209E2A26E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4655EF-9C1C-96AC-CFB7-980568F455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CD653-9D09-46D4-9E4A-599ACA8D33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4298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组合 67">
            <a:extLst>
              <a:ext uri="{FF2B5EF4-FFF2-40B4-BE49-F238E27FC236}">
                <a16:creationId xmlns:a16="http://schemas.microsoft.com/office/drawing/2014/main" id="{ED98669C-ADAF-E1BC-FED3-FE59C35AB06D}"/>
              </a:ext>
            </a:extLst>
          </p:cNvPr>
          <p:cNvGrpSpPr/>
          <p:nvPr/>
        </p:nvGrpSpPr>
        <p:grpSpPr>
          <a:xfrm>
            <a:off x="5119210" y="739068"/>
            <a:ext cx="5873662" cy="4774515"/>
            <a:chOff x="5119210" y="739068"/>
            <a:chExt cx="5873662" cy="4774515"/>
          </a:xfrm>
          <a:effectLst>
            <a:outerShdw blurRad="63500" sx="102000" sy="102000" algn="ctr" rotWithShape="0">
              <a:prstClr val="black">
                <a:alpha val="40000"/>
              </a:prstClr>
            </a:outerShdw>
          </a:effectLst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2E1CF101-A673-C301-3E6C-C0D64CD6AC08}"/>
                </a:ext>
              </a:extLst>
            </p:cNvPr>
            <p:cNvGrpSpPr/>
            <p:nvPr/>
          </p:nvGrpSpPr>
          <p:grpSpPr>
            <a:xfrm>
              <a:off x="7363709" y="739068"/>
              <a:ext cx="606425" cy="841375"/>
              <a:chOff x="4403726" y="1663700"/>
              <a:chExt cx="606425" cy="841375"/>
            </a:xfrm>
            <a:solidFill>
              <a:schemeClr val="accent5"/>
            </a:solidFill>
          </p:grpSpPr>
          <p:sp>
            <p:nvSpPr>
              <p:cNvPr id="6" name="Freeform 15">
                <a:extLst>
                  <a:ext uri="{FF2B5EF4-FFF2-40B4-BE49-F238E27FC236}">
                    <a16:creationId xmlns:a16="http://schemas.microsoft.com/office/drawing/2014/main" id="{75D74A42-824F-7DE1-4238-A12F25CD732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03726" y="2098675"/>
                <a:ext cx="606425" cy="406400"/>
              </a:xfrm>
              <a:custGeom>
                <a:avLst/>
                <a:gdLst>
                  <a:gd name="T0" fmla="*/ 1 w 348"/>
                  <a:gd name="T1" fmla="*/ 119 h 233"/>
                  <a:gd name="T2" fmla="*/ 1 w 348"/>
                  <a:gd name="T3" fmla="*/ 233 h 233"/>
                  <a:gd name="T4" fmla="*/ 47 w 348"/>
                  <a:gd name="T5" fmla="*/ 233 h 233"/>
                  <a:gd name="T6" fmla="*/ 47 w 348"/>
                  <a:gd name="T7" fmla="*/ 141 h 233"/>
                  <a:gd name="T8" fmla="*/ 52 w 348"/>
                  <a:gd name="T9" fmla="*/ 148 h 233"/>
                  <a:gd name="T10" fmla="*/ 52 w 348"/>
                  <a:gd name="T11" fmla="*/ 148 h 233"/>
                  <a:gd name="T12" fmla="*/ 70 w 348"/>
                  <a:gd name="T13" fmla="*/ 233 h 233"/>
                  <a:gd name="T14" fmla="*/ 279 w 348"/>
                  <a:gd name="T15" fmla="*/ 233 h 233"/>
                  <a:gd name="T16" fmla="*/ 290 w 348"/>
                  <a:gd name="T17" fmla="*/ 153 h 233"/>
                  <a:gd name="T18" fmla="*/ 291 w 348"/>
                  <a:gd name="T19" fmla="*/ 152 h 233"/>
                  <a:gd name="T20" fmla="*/ 297 w 348"/>
                  <a:gd name="T21" fmla="*/ 141 h 233"/>
                  <a:gd name="T22" fmla="*/ 300 w 348"/>
                  <a:gd name="T23" fmla="*/ 233 h 233"/>
                  <a:gd name="T24" fmla="*/ 345 w 348"/>
                  <a:gd name="T25" fmla="*/ 233 h 233"/>
                  <a:gd name="T26" fmla="*/ 340 w 348"/>
                  <a:gd name="T27" fmla="*/ 82 h 233"/>
                  <a:gd name="T28" fmla="*/ 233 w 348"/>
                  <a:gd name="T29" fmla="*/ 10 h 233"/>
                  <a:gd name="T30" fmla="*/ 225 w 348"/>
                  <a:gd name="T31" fmla="*/ 15 h 233"/>
                  <a:gd name="T32" fmla="*/ 198 w 348"/>
                  <a:gd name="T33" fmla="*/ 177 h 233"/>
                  <a:gd name="T34" fmla="*/ 188 w 348"/>
                  <a:gd name="T35" fmla="*/ 57 h 233"/>
                  <a:gd name="T36" fmla="*/ 191 w 348"/>
                  <a:gd name="T37" fmla="*/ 44 h 233"/>
                  <a:gd name="T38" fmla="*/ 185 w 348"/>
                  <a:gd name="T39" fmla="*/ 29 h 233"/>
                  <a:gd name="T40" fmla="*/ 170 w 348"/>
                  <a:gd name="T41" fmla="*/ 29 h 233"/>
                  <a:gd name="T42" fmla="*/ 164 w 348"/>
                  <a:gd name="T43" fmla="*/ 44 h 233"/>
                  <a:gd name="T44" fmla="*/ 167 w 348"/>
                  <a:gd name="T45" fmla="*/ 55 h 233"/>
                  <a:gd name="T46" fmla="*/ 156 w 348"/>
                  <a:gd name="T47" fmla="*/ 168 h 233"/>
                  <a:gd name="T48" fmla="*/ 155 w 348"/>
                  <a:gd name="T49" fmla="*/ 175 h 233"/>
                  <a:gd name="T50" fmla="*/ 122 w 348"/>
                  <a:gd name="T51" fmla="*/ 10 h 233"/>
                  <a:gd name="T52" fmla="*/ 117 w 348"/>
                  <a:gd name="T53" fmla="*/ 10 h 233"/>
                  <a:gd name="T54" fmla="*/ 1 w 348"/>
                  <a:gd name="T55" fmla="*/ 119 h 2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348" h="233">
                    <a:moveTo>
                      <a:pt x="1" y="119"/>
                    </a:moveTo>
                    <a:cubicBezTo>
                      <a:pt x="0" y="129"/>
                      <a:pt x="0" y="178"/>
                      <a:pt x="1" y="233"/>
                    </a:cubicBezTo>
                    <a:cubicBezTo>
                      <a:pt x="47" y="233"/>
                      <a:pt x="47" y="233"/>
                      <a:pt x="47" y="233"/>
                    </a:cubicBezTo>
                    <a:cubicBezTo>
                      <a:pt x="46" y="181"/>
                      <a:pt x="45" y="139"/>
                      <a:pt x="47" y="141"/>
                    </a:cubicBezTo>
                    <a:cubicBezTo>
                      <a:pt x="49" y="144"/>
                      <a:pt x="51" y="146"/>
                      <a:pt x="52" y="148"/>
                    </a:cubicBezTo>
                    <a:cubicBezTo>
                      <a:pt x="52" y="148"/>
                      <a:pt x="52" y="148"/>
                      <a:pt x="52" y="148"/>
                    </a:cubicBezTo>
                    <a:cubicBezTo>
                      <a:pt x="70" y="233"/>
                      <a:pt x="70" y="233"/>
                      <a:pt x="70" y="233"/>
                    </a:cubicBezTo>
                    <a:cubicBezTo>
                      <a:pt x="279" y="233"/>
                      <a:pt x="279" y="233"/>
                      <a:pt x="279" y="233"/>
                    </a:cubicBezTo>
                    <a:cubicBezTo>
                      <a:pt x="290" y="153"/>
                      <a:pt x="290" y="153"/>
                      <a:pt x="290" y="153"/>
                    </a:cubicBezTo>
                    <a:cubicBezTo>
                      <a:pt x="290" y="153"/>
                      <a:pt x="291" y="152"/>
                      <a:pt x="291" y="152"/>
                    </a:cubicBezTo>
                    <a:cubicBezTo>
                      <a:pt x="293" y="148"/>
                      <a:pt x="295" y="144"/>
                      <a:pt x="297" y="141"/>
                    </a:cubicBezTo>
                    <a:cubicBezTo>
                      <a:pt x="299" y="137"/>
                      <a:pt x="300" y="181"/>
                      <a:pt x="300" y="233"/>
                    </a:cubicBezTo>
                    <a:cubicBezTo>
                      <a:pt x="345" y="233"/>
                      <a:pt x="345" y="233"/>
                      <a:pt x="345" y="233"/>
                    </a:cubicBezTo>
                    <a:cubicBezTo>
                      <a:pt x="348" y="167"/>
                      <a:pt x="347" y="102"/>
                      <a:pt x="340" y="82"/>
                    </a:cubicBezTo>
                    <a:cubicBezTo>
                      <a:pt x="336" y="68"/>
                      <a:pt x="286" y="0"/>
                      <a:pt x="233" y="10"/>
                    </a:cubicBezTo>
                    <a:cubicBezTo>
                      <a:pt x="233" y="10"/>
                      <a:pt x="230" y="12"/>
                      <a:pt x="225" y="15"/>
                    </a:cubicBezTo>
                    <a:cubicBezTo>
                      <a:pt x="198" y="177"/>
                      <a:pt x="198" y="177"/>
                      <a:pt x="198" y="177"/>
                    </a:cubicBezTo>
                    <a:cubicBezTo>
                      <a:pt x="188" y="57"/>
                      <a:pt x="188" y="57"/>
                      <a:pt x="188" y="57"/>
                    </a:cubicBezTo>
                    <a:cubicBezTo>
                      <a:pt x="191" y="44"/>
                      <a:pt x="191" y="44"/>
                      <a:pt x="191" y="44"/>
                    </a:cubicBezTo>
                    <a:cubicBezTo>
                      <a:pt x="185" y="29"/>
                      <a:pt x="185" y="29"/>
                      <a:pt x="185" y="29"/>
                    </a:cubicBezTo>
                    <a:cubicBezTo>
                      <a:pt x="170" y="29"/>
                      <a:pt x="170" y="29"/>
                      <a:pt x="170" y="29"/>
                    </a:cubicBezTo>
                    <a:cubicBezTo>
                      <a:pt x="164" y="44"/>
                      <a:pt x="164" y="44"/>
                      <a:pt x="164" y="44"/>
                    </a:cubicBezTo>
                    <a:cubicBezTo>
                      <a:pt x="167" y="55"/>
                      <a:pt x="167" y="55"/>
                      <a:pt x="167" y="55"/>
                    </a:cubicBezTo>
                    <a:cubicBezTo>
                      <a:pt x="156" y="168"/>
                      <a:pt x="156" y="168"/>
                      <a:pt x="156" y="168"/>
                    </a:cubicBezTo>
                    <a:cubicBezTo>
                      <a:pt x="155" y="175"/>
                      <a:pt x="155" y="175"/>
                      <a:pt x="155" y="175"/>
                    </a:cubicBezTo>
                    <a:cubicBezTo>
                      <a:pt x="122" y="10"/>
                      <a:pt x="122" y="10"/>
                      <a:pt x="122" y="10"/>
                    </a:cubicBezTo>
                    <a:cubicBezTo>
                      <a:pt x="120" y="10"/>
                      <a:pt x="119" y="10"/>
                      <a:pt x="117" y="10"/>
                    </a:cubicBezTo>
                    <a:cubicBezTo>
                      <a:pt x="63" y="20"/>
                      <a:pt x="4" y="54"/>
                      <a:pt x="1" y="119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Freeform 16">
                <a:extLst>
                  <a:ext uri="{FF2B5EF4-FFF2-40B4-BE49-F238E27FC236}">
                    <a16:creationId xmlns:a16="http://schemas.microsoft.com/office/drawing/2014/main" id="{030F7FFA-A6C3-21C7-C34B-2A9136AB97C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73576" y="1663700"/>
                <a:ext cx="485775" cy="477838"/>
              </a:xfrm>
              <a:custGeom>
                <a:avLst/>
                <a:gdLst>
                  <a:gd name="T0" fmla="*/ 0 w 279"/>
                  <a:gd name="T1" fmla="*/ 237 h 274"/>
                  <a:gd name="T2" fmla="*/ 52 w 279"/>
                  <a:gd name="T3" fmla="*/ 255 h 274"/>
                  <a:gd name="T4" fmla="*/ 80 w 279"/>
                  <a:gd name="T5" fmla="*/ 244 h 274"/>
                  <a:gd name="T6" fmla="*/ 70 w 279"/>
                  <a:gd name="T7" fmla="*/ 170 h 274"/>
                  <a:gd name="T8" fmla="*/ 136 w 279"/>
                  <a:gd name="T9" fmla="*/ 253 h 274"/>
                  <a:gd name="T10" fmla="*/ 204 w 279"/>
                  <a:gd name="T11" fmla="*/ 160 h 274"/>
                  <a:gd name="T12" fmla="*/ 198 w 279"/>
                  <a:gd name="T13" fmla="*/ 244 h 274"/>
                  <a:gd name="T14" fmla="*/ 226 w 279"/>
                  <a:gd name="T15" fmla="*/ 255 h 274"/>
                  <a:gd name="T16" fmla="*/ 279 w 279"/>
                  <a:gd name="T17" fmla="*/ 237 h 274"/>
                  <a:gd name="T18" fmla="*/ 246 w 279"/>
                  <a:gd name="T19" fmla="*/ 178 h 274"/>
                  <a:gd name="T20" fmla="*/ 229 w 279"/>
                  <a:gd name="T21" fmla="*/ 62 h 274"/>
                  <a:gd name="T22" fmla="*/ 137 w 279"/>
                  <a:gd name="T23" fmla="*/ 13 h 274"/>
                  <a:gd name="T24" fmla="*/ 135 w 279"/>
                  <a:gd name="T25" fmla="*/ 13 h 274"/>
                  <a:gd name="T26" fmla="*/ 154 w 279"/>
                  <a:gd name="T27" fmla="*/ 5 h 274"/>
                  <a:gd name="T28" fmla="*/ 63 w 279"/>
                  <a:gd name="T29" fmla="*/ 41 h 274"/>
                  <a:gd name="T30" fmla="*/ 58 w 279"/>
                  <a:gd name="T31" fmla="*/ 44 h 274"/>
                  <a:gd name="T32" fmla="*/ 60 w 279"/>
                  <a:gd name="T33" fmla="*/ 44 h 274"/>
                  <a:gd name="T34" fmla="*/ 49 w 279"/>
                  <a:gd name="T35" fmla="*/ 62 h 274"/>
                  <a:gd name="T36" fmla="*/ 41 w 279"/>
                  <a:gd name="T37" fmla="*/ 182 h 274"/>
                  <a:gd name="T38" fmla="*/ 0 w 279"/>
                  <a:gd name="T39" fmla="*/ 237 h 2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279" h="274">
                    <a:moveTo>
                      <a:pt x="0" y="237"/>
                    </a:moveTo>
                    <a:cubicBezTo>
                      <a:pt x="0" y="237"/>
                      <a:pt x="8" y="274"/>
                      <a:pt x="52" y="255"/>
                    </a:cubicBezTo>
                    <a:cubicBezTo>
                      <a:pt x="74" y="246"/>
                      <a:pt x="80" y="244"/>
                      <a:pt x="80" y="244"/>
                    </a:cubicBezTo>
                    <a:cubicBezTo>
                      <a:pt x="80" y="244"/>
                      <a:pt x="72" y="211"/>
                      <a:pt x="70" y="170"/>
                    </a:cubicBezTo>
                    <a:cubicBezTo>
                      <a:pt x="82" y="215"/>
                      <a:pt x="105" y="252"/>
                      <a:pt x="136" y="253"/>
                    </a:cubicBezTo>
                    <a:cubicBezTo>
                      <a:pt x="172" y="255"/>
                      <a:pt x="197" y="213"/>
                      <a:pt x="204" y="160"/>
                    </a:cubicBezTo>
                    <a:cubicBezTo>
                      <a:pt x="207" y="206"/>
                      <a:pt x="198" y="244"/>
                      <a:pt x="198" y="244"/>
                    </a:cubicBezTo>
                    <a:cubicBezTo>
                      <a:pt x="198" y="244"/>
                      <a:pt x="204" y="246"/>
                      <a:pt x="226" y="255"/>
                    </a:cubicBezTo>
                    <a:cubicBezTo>
                      <a:pt x="270" y="274"/>
                      <a:pt x="279" y="237"/>
                      <a:pt x="279" y="237"/>
                    </a:cubicBezTo>
                    <a:cubicBezTo>
                      <a:pt x="279" y="237"/>
                      <a:pt x="233" y="247"/>
                      <a:pt x="246" y="178"/>
                    </a:cubicBezTo>
                    <a:cubicBezTo>
                      <a:pt x="251" y="146"/>
                      <a:pt x="252" y="114"/>
                      <a:pt x="229" y="62"/>
                    </a:cubicBezTo>
                    <a:cubicBezTo>
                      <a:pt x="208" y="16"/>
                      <a:pt x="164" y="11"/>
                      <a:pt x="137" y="13"/>
                    </a:cubicBezTo>
                    <a:cubicBezTo>
                      <a:pt x="137" y="13"/>
                      <a:pt x="136" y="13"/>
                      <a:pt x="135" y="13"/>
                    </a:cubicBezTo>
                    <a:cubicBezTo>
                      <a:pt x="141" y="10"/>
                      <a:pt x="147" y="7"/>
                      <a:pt x="154" y="5"/>
                    </a:cubicBezTo>
                    <a:cubicBezTo>
                      <a:pt x="154" y="5"/>
                      <a:pt x="97" y="0"/>
                      <a:pt x="63" y="41"/>
                    </a:cubicBezTo>
                    <a:cubicBezTo>
                      <a:pt x="61" y="42"/>
                      <a:pt x="59" y="43"/>
                      <a:pt x="58" y="44"/>
                    </a:cubicBezTo>
                    <a:cubicBezTo>
                      <a:pt x="58" y="44"/>
                      <a:pt x="59" y="44"/>
                      <a:pt x="60" y="44"/>
                    </a:cubicBezTo>
                    <a:cubicBezTo>
                      <a:pt x="56" y="49"/>
                      <a:pt x="52" y="55"/>
                      <a:pt x="49" y="62"/>
                    </a:cubicBezTo>
                    <a:cubicBezTo>
                      <a:pt x="25" y="114"/>
                      <a:pt x="35" y="149"/>
                      <a:pt x="41" y="182"/>
                    </a:cubicBezTo>
                    <a:cubicBezTo>
                      <a:pt x="53" y="251"/>
                      <a:pt x="0" y="237"/>
                      <a:pt x="0" y="23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87A4239B-C28A-8F9D-999D-FB50D653DA10}"/>
                </a:ext>
              </a:extLst>
            </p:cNvPr>
            <p:cNvGrpSpPr/>
            <p:nvPr/>
          </p:nvGrpSpPr>
          <p:grpSpPr>
            <a:xfrm>
              <a:off x="7281510" y="2644246"/>
              <a:ext cx="855663" cy="1008062"/>
              <a:chOff x="4297363" y="4305300"/>
              <a:chExt cx="855663" cy="1008062"/>
            </a:xfrm>
            <a:solidFill>
              <a:schemeClr val="accent3">
                <a:lumMod val="50000"/>
              </a:schemeClr>
            </a:solidFill>
          </p:grpSpPr>
          <p:sp>
            <p:nvSpPr>
              <p:cNvPr id="9" name="Freeform 38">
                <a:extLst>
                  <a:ext uri="{FF2B5EF4-FFF2-40B4-BE49-F238E27FC236}">
                    <a16:creationId xmlns:a16="http://schemas.microsoft.com/office/drawing/2014/main" id="{7915DBBB-DA09-29B8-895F-21EF043DE03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876801" y="4605337"/>
                <a:ext cx="276225" cy="530225"/>
              </a:xfrm>
              <a:custGeom>
                <a:avLst/>
                <a:gdLst>
                  <a:gd name="T0" fmla="*/ 71 w 159"/>
                  <a:gd name="T1" fmla="*/ 304 h 304"/>
                  <a:gd name="T2" fmla="*/ 75 w 159"/>
                  <a:gd name="T3" fmla="*/ 303 h 304"/>
                  <a:gd name="T4" fmla="*/ 98 w 159"/>
                  <a:gd name="T5" fmla="*/ 303 h 304"/>
                  <a:gd name="T6" fmla="*/ 98 w 159"/>
                  <a:gd name="T7" fmla="*/ 304 h 304"/>
                  <a:gd name="T8" fmla="*/ 107 w 159"/>
                  <a:gd name="T9" fmla="*/ 189 h 304"/>
                  <a:gd name="T10" fmla="*/ 108 w 159"/>
                  <a:gd name="T11" fmla="*/ 188 h 304"/>
                  <a:gd name="T12" fmla="*/ 114 w 159"/>
                  <a:gd name="T13" fmla="*/ 169 h 304"/>
                  <a:gd name="T14" fmla="*/ 117 w 159"/>
                  <a:gd name="T15" fmla="*/ 136 h 304"/>
                  <a:gd name="T16" fmla="*/ 122 w 159"/>
                  <a:gd name="T17" fmla="*/ 62 h 304"/>
                  <a:gd name="T18" fmla="*/ 123 w 159"/>
                  <a:gd name="T19" fmla="*/ 61 h 304"/>
                  <a:gd name="T20" fmla="*/ 126 w 159"/>
                  <a:gd name="T21" fmla="*/ 57 h 304"/>
                  <a:gd name="T22" fmla="*/ 126 w 159"/>
                  <a:gd name="T23" fmla="*/ 163 h 304"/>
                  <a:gd name="T24" fmla="*/ 143 w 159"/>
                  <a:gd name="T25" fmla="*/ 160 h 304"/>
                  <a:gd name="T26" fmla="*/ 145 w 159"/>
                  <a:gd name="T27" fmla="*/ 160 h 304"/>
                  <a:gd name="T28" fmla="*/ 147 w 159"/>
                  <a:gd name="T29" fmla="*/ 160 h 304"/>
                  <a:gd name="T30" fmla="*/ 158 w 159"/>
                  <a:gd name="T31" fmla="*/ 32 h 304"/>
                  <a:gd name="T32" fmla="*/ 92 w 159"/>
                  <a:gd name="T33" fmla="*/ 3 h 304"/>
                  <a:gd name="T34" fmla="*/ 86 w 159"/>
                  <a:gd name="T35" fmla="*/ 9 h 304"/>
                  <a:gd name="T36" fmla="*/ 72 w 159"/>
                  <a:gd name="T37" fmla="*/ 71 h 304"/>
                  <a:gd name="T38" fmla="*/ 66 w 159"/>
                  <a:gd name="T39" fmla="*/ 23 h 304"/>
                  <a:gd name="T40" fmla="*/ 68 w 159"/>
                  <a:gd name="T41" fmla="*/ 18 h 304"/>
                  <a:gd name="T42" fmla="*/ 60 w 159"/>
                  <a:gd name="T43" fmla="*/ 19 h 304"/>
                  <a:gd name="T44" fmla="*/ 53 w 159"/>
                  <a:gd name="T45" fmla="*/ 18 h 304"/>
                  <a:gd name="T46" fmla="*/ 55 w 159"/>
                  <a:gd name="T47" fmla="*/ 22 h 304"/>
                  <a:gd name="T48" fmla="*/ 51 w 159"/>
                  <a:gd name="T49" fmla="*/ 46 h 304"/>
                  <a:gd name="T50" fmla="*/ 51 w 159"/>
                  <a:gd name="T51" fmla="*/ 50 h 304"/>
                  <a:gd name="T52" fmla="*/ 49 w 159"/>
                  <a:gd name="T53" fmla="*/ 68 h 304"/>
                  <a:gd name="T54" fmla="*/ 48 w 159"/>
                  <a:gd name="T55" fmla="*/ 71 h 304"/>
                  <a:gd name="T56" fmla="*/ 47 w 159"/>
                  <a:gd name="T57" fmla="*/ 67 h 304"/>
                  <a:gd name="T58" fmla="*/ 26 w 159"/>
                  <a:gd name="T59" fmla="*/ 130 h 304"/>
                  <a:gd name="T60" fmla="*/ 20 w 159"/>
                  <a:gd name="T61" fmla="*/ 148 h 304"/>
                  <a:gd name="T62" fmla="*/ 6 w 159"/>
                  <a:gd name="T63" fmla="*/ 158 h 304"/>
                  <a:gd name="T64" fmla="*/ 3 w 159"/>
                  <a:gd name="T65" fmla="*/ 158 h 304"/>
                  <a:gd name="T66" fmla="*/ 0 w 159"/>
                  <a:gd name="T67" fmla="*/ 157 h 304"/>
                  <a:gd name="T68" fmla="*/ 0 w 159"/>
                  <a:gd name="T69" fmla="*/ 163 h 304"/>
                  <a:gd name="T70" fmla="*/ 0 w 159"/>
                  <a:gd name="T71" fmla="*/ 168 h 304"/>
                  <a:gd name="T72" fmla="*/ 9 w 159"/>
                  <a:gd name="T73" fmla="*/ 190 h 304"/>
                  <a:gd name="T74" fmla="*/ 8 w 159"/>
                  <a:gd name="T75" fmla="*/ 198 h 304"/>
                  <a:gd name="T76" fmla="*/ 16 w 159"/>
                  <a:gd name="T77" fmla="*/ 304 h 304"/>
                  <a:gd name="T78" fmla="*/ 17 w 159"/>
                  <a:gd name="T79" fmla="*/ 303 h 304"/>
                  <a:gd name="T80" fmla="*/ 40 w 159"/>
                  <a:gd name="T81" fmla="*/ 303 h 304"/>
                  <a:gd name="T82" fmla="*/ 44 w 159"/>
                  <a:gd name="T83" fmla="*/ 304 h 304"/>
                  <a:gd name="T84" fmla="*/ 55 w 159"/>
                  <a:gd name="T85" fmla="*/ 215 h 304"/>
                  <a:gd name="T86" fmla="*/ 57 w 159"/>
                  <a:gd name="T87" fmla="*/ 215 h 304"/>
                  <a:gd name="T88" fmla="*/ 60 w 159"/>
                  <a:gd name="T89" fmla="*/ 215 h 304"/>
                  <a:gd name="T90" fmla="*/ 71 w 159"/>
                  <a:gd name="T91" fmla="*/ 304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</a:cxnLst>
                <a:rect l="0" t="0" r="r" b="b"/>
                <a:pathLst>
                  <a:path w="159" h="304">
                    <a:moveTo>
                      <a:pt x="71" y="304"/>
                    </a:moveTo>
                    <a:cubicBezTo>
                      <a:pt x="72" y="304"/>
                      <a:pt x="74" y="303"/>
                      <a:pt x="75" y="303"/>
                    </a:cubicBezTo>
                    <a:cubicBezTo>
                      <a:pt x="98" y="303"/>
                      <a:pt x="98" y="303"/>
                      <a:pt x="98" y="303"/>
                    </a:cubicBezTo>
                    <a:cubicBezTo>
                      <a:pt x="98" y="303"/>
                      <a:pt x="98" y="304"/>
                      <a:pt x="98" y="304"/>
                    </a:cubicBezTo>
                    <a:cubicBezTo>
                      <a:pt x="107" y="189"/>
                      <a:pt x="107" y="189"/>
                      <a:pt x="107" y="189"/>
                    </a:cubicBezTo>
                    <a:cubicBezTo>
                      <a:pt x="107" y="189"/>
                      <a:pt x="108" y="188"/>
                      <a:pt x="108" y="188"/>
                    </a:cubicBezTo>
                    <a:cubicBezTo>
                      <a:pt x="109" y="182"/>
                      <a:pt x="110" y="174"/>
                      <a:pt x="114" y="169"/>
                    </a:cubicBezTo>
                    <a:cubicBezTo>
                      <a:pt x="115" y="163"/>
                      <a:pt x="116" y="151"/>
                      <a:pt x="117" y="136"/>
                    </a:cubicBezTo>
                    <a:cubicBezTo>
                      <a:pt x="122" y="62"/>
                      <a:pt x="122" y="62"/>
                      <a:pt x="122" y="62"/>
                    </a:cubicBezTo>
                    <a:cubicBezTo>
                      <a:pt x="122" y="61"/>
                      <a:pt x="123" y="61"/>
                      <a:pt x="123" y="61"/>
                    </a:cubicBezTo>
                    <a:cubicBezTo>
                      <a:pt x="124" y="60"/>
                      <a:pt x="125" y="58"/>
                      <a:pt x="126" y="57"/>
                    </a:cubicBezTo>
                    <a:cubicBezTo>
                      <a:pt x="129" y="53"/>
                      <a:pt x="127" y="135"/>
                      <a:pt x="126" y="163"/>
                    </a:cubicBezTo>
                    <a:cubicBezTo>
                      <a:pt x="143" y="160"/>
                      <a:pt x="143" y="160"/>
                      <a:pt x="143" y="160"/>
                    </a:cubicBezTo>
                    <a:cubicBezTo>
                      <a:pt x="144" y="160"/>
                      <a:pt x="144" y="160"/>
                      <a:pt x="145" y="160"/>
                    </a:cubicBezTo>
                    <a:cubicBezTo>
                      <a:pt x="146" y="160"/>
                      <a:pt x="146" y="160"/>
                      <a:pt x="147" y="160"/>
                    </a:cubicBezTo>
                    <a:cubicBezTo>
                      <a:pt x="152" y="128"/>
                      <a:pt x="159" y="40"/>
                      <a:pt x="158" y="32"/>
                    </a:cubicBezTo>
                    <a:cubicBezTo>
                      <a:pt x="156" y="26"/>
                      <a:pt x="121" y="0"/>
                      <a:pt x="92" y="3"/>
                    </a:cubicBezTo>
                    <a:cubicBezTo>
                      <a:pt x="90" y="5"/>
                      <a:pt x="88" y="7"/>
                      <a:pt x="86" y="9"/>
                    </a:cubicBezTo>
                    <a:cubicBezTo>
                      <a:pt x="72" y="71"/>
                      <a:pt x="72" y="71"/>
                      <a:pt x="72" y="71"/>
                    </a:cubicBezTo>
                    <a:cubicBezTo>
                      <a:pt x="66" y="23"/>
                      <a:pt x="66" y="23"/>
                      <a:pt x="66" y="23"/>
                    </a:cubicBezTo>
                    <a:cubicBezTo>
                      <a:pt x="68" y="18"/>
                      <a:pt x="68" y="18"/>
                      <a:pt x="68" y="18"/>
                    </a:cubicBezTo>
                    <a:cubicBezTo>
                      <a:pt x="65" y="18"/>
                      <a:pt x="62" y="19"/>
                      <a:pt x="60" y="19"/>
                    </a:cubicBezTo>
                    <a:cubicBezTo>
                      <a:pt x="58" y="19"/>
                      <a:pt x="56" y="18"/>
                      <a:pt x="53" y="18"/>
                    </a:cubicBezTo>
                    <a:cubicBezTo>
                      <a:pt x="55" y="22"/>
                      <a:pt x="55" y="22"/>
                      <a:pt x="55" y="22"/>
                    </a:cubicBezTo>
                    <a:cubicBezTo>
                      <a:pt x="51" y="46"/>
                      <a:pt x="51" y="46"/>
                      <a:pt x="51" y="46"/>
                    </a:cubicBezTo>
                    <a:cubicBezTo>
                      <a:pt x="51" y="47"/>
                      <a:pt x="51" y="48"/>
                      <a:pt x="51" y="50"/>
                    </a:cubicBezTo>
                    <a:cubicBezTo>
                      <a:pt x="49" y="68"/>
                      <a:pt x="49" y="68"/>
                      <a:pt x="49" y="68"/>
                    </a:cubicBezTo>
                    <a:cubicBezTo>
                      <a:pt x="48" y="71"/>
                      <a:pt x="48" y="71"/>
                      <a:pt x="48" y="71"/>
                    </a:cubicBezTo>
                    <a:cubicBezTo>
                      <a:pt x="47" y="67"/>
                      <a:pt x="47" y="67"/>
                      <a:pt x="47" y="67"/>
                    </a:cubicBezTo>
                    <a:cubicBezTo>
                      <a:pt x="42" y="87"/>
                      <a:pt x="34" y="108"/>
                      <a:pt x="26" y="130"/>
                    </a:cubicBezTo>
                    <a:cubicBezTo>
                      <a:pt x="20" y="148"/>
                      <a:pt x="20" y="148"/>
                      <a:pt x="20" y="148"/>
                    </a:cubicBezTo>
                    <a:cubicBezTo>
                      <a:pt x="18" y="154"/>
                      <a:pt x="13" y="158"/>
                      <a:pt x="6" y="158"/>
                    </a:cubicBezTo>
                    <a:cubicBezTo>
                      <a:pt x="5" y="158"/>
                      <a:pt x="4" y="158"/>
                      <a:pt x="3" y="158"/>
                    </a:cubicBezTo>
                    <a:cubicBezTo>
                      <a:pt x="0" y="157"/>
                      <a:pt x="0" y="157"/>
                      <a:pt x="0" y="157"/>
                    </a:cubicBezTo>
                    <a:cubicBezTo>
                      <a:pt x="0" y="159"/>
                      <a:pt x="0" y="161"/>
                      <a:pt x="0" y="163"/>
                    </a:cubicBezTo>
                    <a:cubicBezTo>
                      <a:pt x="0" y="165"/>
                      <a:pt x="0" y="166"/>
                      <a:pt x="0" y="168"/>
                    </a:cubicBezTo>
                    <a:cubicBezTo>
                      <a:pt x="7" y="174"/>
                      <a:pt x="8" y="184"/>
                      <a:pt x="9" y="190"/>
                    </a:cubicBezTo>
                    <a:cubicBezTo>
                      <a:pt x="9" y="193"/>
                      <a:pt x="9" y="196"/>
                      <a:pt x="8" y="198"/>
                    </a:cubicBezTo>
                    <a:cubicBezTo>
                      <a:pt x="16" y="304"/>
                      <a:pt x="16" y="304"/>
                      <a:pt x="16" y="304"/>
                    </a:cubicBezTo>
                    <a:cubicBezTo>
                      <a:pt x="17" y="304"/>
                      <a:pt x="17" y="303"/>
                      <a:pt x="17" y="303"/>
                    </a:cubicBezTo>
                    <a:cubicBezTo>
                      <a:pt x="40" y="303"/>
                      <a:pt x="40" y="303"/>
                      <a:pt x="40" y="303"/>
                    </a:cubicBezTo>
                    <a:cubicBezTo>
                      <a:pt x="41" y="303"/>
                      <a:pt x="43" y="304"/>
                      <a:pt x="44" y="304"/>
                    </a:cubicBezTo>
                    <a:cubicBezTo>
                      <a:pt x="55" y="215"/>
                      <a:pt x="55" y="215"/>
                      <a:pt x="55" y="215"/>
                    </a:cubicBezTo>
                    <a:cubicBezTo>
                      <a:pt x="55" y="215"/>
                      <a:pt x="56" y="215"/>
                      <a:pt x="57" y="215"/>
                    </a:cubicBezTo>
                    <a:cubicBezTo>
                      <a:pt x="58" y="215"/>
                      <a:pt x="59" y="215"/>
                      <a:pt x="60" y="215"/>
                    </a:cubicBezTo>
                    <a:lnTo>
                      <a:pt x="71" y="304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Freeform 39">
                <a:extLst>
                  <a:ext uri="{FF2B5EF4-FFF2-40B4-BE49-F238E27FC236}">
                    <a16:creationId xmlns:a16="http://schemas.microsoft.com/office/drawing/2014/main" id="{4775BDBC-EE60-FA62-2EA9-4AD5C0D476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87938" y="4908550"/>
                <a:ext cx="41275" cy="39688"/>
              </a:xfrm>
              <a:custGeom>
                <a:avLst/>
                <a:gdLst>
                  <a:gd name="T0" fmla="*/ 1 w 24"/>
                  <a:gd name="T1" fmla="*/ 18 h 23"/>
                  <a:gd name="T2" fmla="*/ 6 w 24"/>
                  <a:gd name="T3" fmla="*/ 13 h 23"/>
                  <a:gd name="T4" fmla="*/ 8 w 24"/>
                  <a:gd name="T5" fmla="*/ 14 h 23"/>
                  <a:gd name="T6" fmla="*/ 15 w 24"/>
                  <a:gd name="T7" fmla="*/ 20 h 23"/>
                  <a:gd name="T8" fmla="*/ 24 w 24"/>
                  <a:gd name="T9" fmla="*/ 0 h 23"/>
                  <a:gd name="T10" fmla="*/ 6 w 24"/>
                  <a:gd name="T11" fmla="*/ 3 h 23"/>
                  <a:gd name="T12" fmla="*/ 1 w 24"/>
                  <a:gd name="T13" fmla="*/ 18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4" h="23">
                    <a:moveTo>
                      <a:pt x="1" y="18"/>
                    </a:moveTo>
                    <a:cubicBezTo>
                      <a:pt x="0" y="23"/>
                      <a:pt x="6" y="16"/>
                      <a:pt x="6" y="13"/>
                    </a:cubicBezTo>
                    <a:cubicBezTo>
                      <a:pt x="6" y="11"/>
                      <a:pt x="8" y="10"/>
                      <a:pt x="8" y="14"/>
                    </a:cubicBezTo>
                    <a:cubicBezTo>
                      <a:pt x="8" y="18"/>
                      <a:pt x="10" y="21"/>
                      <a:pt x="15" y="20"/>
                    </a:cubicBezTo>
                    <a:cubicBezTo>
                      <a:pt x="23" y="20"/>
                      <a:pt x="24" y="0"/>
                      <a:pt x="24" y="0"/>
                    </a:cubicBezTo>
                    <a:cubicBezTo>
                      <a:pt x="6" y="3"/>
                      <a:pt x="6" y="3"/>
                      <a:pt x="6" y="3"/>
                    </a:cubicBezTo>
                    <a:cubicBezTo>
                      <a:pt x="2" y="4"/>
                      <a:pt x="2" y="12"/>
                      <a:pt x="1" y="18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Freeform 40">
                <a:extLst>
                  <a:ext uri="{FF2B5EF4-FFF2-40B4-BE49-F238E27FC236}">
                    <a16:creationId xmlns:a16="http://schemas.microsoft.com/office/drawing/2014/main" id="{F56C2D77-82E8-3FEB-52F5-FE15A43A6D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02201" y="4392612"/>
                <a:ext cx="153988" cy="219075"/>
              </a:xfrm>
              <a:custGeom>
                <a:avLst/>
                <a:gdLst>
                  <a:gd name="T0" fmla="*/ 45 w 88"/>
                  <a:gd name="T1" fmla="*/ 126 h 126"/>
                  <a:gd name="T2" fmla="*/ 82 w 88"/>
                  <a:gd name="T3" fmla="*/ 83 h 126"/>
                  <a:gd name="T4" fmla="*/ 85 w 88"/>
                  <a:gd name="T5" fmla="*/ 87 h 126"/>
                  <a:gd name="T6" fmla="*/ 88 w 88"/>
                  <a:gd name="T7" fmla="*/ 73 h 126"/>
                  <a:gd name="T8" fmla="*/ 85 w 88"/>
                  <a:gd name="T9" fmla="*/ 59 h 126"/>
                  <a:gd name="T10" fmla="*/ 84 w 88"/>
                  <a:gd name="T11" fmla="*/ 59 h 126"/>
                  <a:gd name="T12" fmla="*/ 84 w 88"/>
                  <a:gd name="T13" fmla="*/ 47 h 126"/>
                  <a:gd name="T14" fmla="*/ 51 w 88"/>
                  <a:gd name="T15" fmla="*/ 39 h 126"/>
                  <a:gd name="T16" fmla="*/ 56 w 88"/>
                  <a:gd name="T17" fmla="*/ 41 h 126"/>
                  <a:gd name="T18" fmla="*/ 87 w 88"/>
                  <a:gd name="T19" fmla="*/ 30 h 126"/>
                  <a:gd name="T20" fmla="*/ 16 w 88"/>
                  <a:gd name="T21" fmla="*/ 23 h 126"/>
                  <a:gd name="T22" fmla="*/ 2 w 88"/>
                  <a:gd name="T23" fmla="*/ 32 h 126"/>
                  <a:gd name="T24" fmla="*/ 11 w 88"/>
                  <a:gd name="T25" fmla="*/ 32 h 126"/>
                  <a:gd name="T26" fmla="*/ 5 w 88"/>
                  <a:gd name="T27" fmla="*/ 52 h 126"/>
                  <a:gd name="T28" fmla="*/ 4 w 88"/>
                  <a:gd name="T29" fmla="*/ 59 h 126"/>
                  <a:gd name="T30" fmla="*/ 4 w 88"/>
                  <a:gd name="T31" fmla="*/ 59 h 126"/>
                  <a:gd name="T32" fmla="*/ 0 w 88"/>
                  <a:gd name="T33" fmla="*/ 74 h 126"/>
                  <a:gd name="T34" fmla="*/ 4 w 88"/>
                  <a:gd name="T35" fmla="*/ 88 h 126"/>
                  <a:gd name="T36" fmla="*/ 6 w 88"/>
                  <a:gd name="T37" fmla="*/ 84 h 126"/>
                  <a:gd name="T38" fmla="*/ 45 w 88"/>
                  <a:gd name="T39" fmla="*/ 126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88" h="126">
                    <a:moveTo>
                      <a:pt x="45" y="126"/>
                    </a:moveTo>
                    <a:cubicBezTo>
                      <a:pt x="59" y="126"/>
                      <a:pt x="79" y="110"/>
                      <a:pt x="82" y="83"/>
                    </a:cubicBezTo>
                    <a:cubicBezTo>
                      <a:pt x="83" y="85"/>
                      <a:pt x="84" y="87"/>
                      <a:pt x="85" y="87"/>
                    </a:cubicBezTo>
                    <a:cubicBezTo>
                      <a:pt x="87" y="87"/>
                      <a:pt x="88" y="81"/>
                      <a:pt x="88" y="73"/>
                    </a:cubicBezTo>
                    <a:cubicBezTo>
                      <a:pt x="88" y="65"/>
                      <a:pt x="87" y="59"/>
                      <a:pt x="85" y="59"/>
                    </a:cubicBezTo>
                    <a:cubicBezTo>
                      <a:pt x="85" y="59"/>
                      <a:pt x="84" y="59"/>
                      <a:pt x="84" y="59"/>
                    </a:cubicBezTo>
                    <a:cubicBezTo>
                      <a:pt x="84" y="56"/>
                      <a:pt x="84" y="52"/>
                      <a:pt x="84" y="47"/>
                    </a:cubicBezTo>
                    <a:cubicBezTo>
                      <a:pt x="77" y="52"/>
                      <a:pt x="65" y="45"/>
                      <a:pt x="51" y="39"/>
                    </a:cubicBezTo>
                    <a:cubicBezTo>
                      <a:pt x="53" y="40"/>
                      <a:pt x="54" y="40"/>
                      <a:pt x="56" y="41"/>
                    </a:cubicBezTo>
                    <a:cubicBezTo>
                      <a:pt x="78" y="53"/>
                      <a:pt x="87" y="30"/>
                      <a:pt x="87" y="30"/>
                    </a:cubicBezTo>
                    <a:cubicBezTo>
                      <a:pt x="87" y="30"/>
                      <a:pt x="60" y="0"/>
                      <a:pt x="16" y="23"/>
                    </a:cubicBezTo>
                    <a:cubicBezTo>
                      <a:pt x="12" y="25"/>
                      <a:pt x="6" y="30"/>
                      <a:pt x="2" y="32"/>
                    </a:cubicBezTo>
                    <a:cubicBezTo>
                      <a:pt x="2" y="32"/>
                      <a:pt x="5" y="32"/>
                      <a:pt x="11" y="32"/>
                    </a:cubicBezTo>
                    <a:cubicBezTo>
                      <a:pt x="6" y="35"/>
                      <a:pt x="4" y="41"/>
                      <a:pt x="5" y="52"/>
                    </a:cubicBezTo>
                    <a:cubicBezTo>
                      <a:pt x="4" y="54"/>
                      <a:pt x="4" y="57"/>
                      <a:pt x="4" y="59"/>
                    </a:cubicBezTo>
                    <a:cubicBezTo>
                      <a:pt x="4" y="59"/>
                      <a:pt x="4" y="59"/>
                      <a:pt x="4" y="59"/>
                    </a:cubicBezTo>
                    <a:cubicBezTo>
                      <a:pt x="2" y="59"/>
                      <a:pt x="0" y="66"/>
                      <a:pt x="0" y="74"/>
                    </a:cubicBezTo>
                    <a:cubicBezTo>
                      <a:pt x="0" y="81"/>
                      <a:pt x="2" y="88"/>
                      <a:pt x="4" y="88"/>
                    </a:cubicBezTo>
                    <a:cubicBezTo>
                      <a:pt x="5" y="88"/>
                      <a:pt x="5" y="86"/>
                      <a:pt x="6" y="84"/>
                    </a:cubicBezTo>
                    <a:cubicBezTo>
                      <a:pt x="12" y="108"/>
                      <a:pt x="33" y="126"/>
                      <a:pt x="45" y="126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Freeform 41">
                <a:extLst>
                  <a:ext uri="{FF2B5EF4-FFF2-40B4-BE49-F238E27FC236}">
                    <a16:creationId xmlns:a16="http://schemas.microsoft.com/office/drawing/2014/main" id="{F1CE2D91-4935-3995-FB96-6EEE2914C13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864101" y="5159375"/>
                <a:ext cx="84138" cy="30163"/>
              </a:xfrm>
              <a:custGeom>
                <a:avLst/>
                <a:gdLst>
                  <a:gd name="T0" fmla="*/ 24 w 48"/>
                  <a:gd name="T1" fmla="*/ 0 h 17"/>
                  <a:gd name="T2" fmla="*/ 16 w 48"/>
                  <a:gd name="T3" fmla="*/ 16 h 17"/>
                  <a:gd name="T4" fmla="*/ 38 w 48"/>
                  <a:gd name="T5" fmla="*/ 9 h 17"/>
                  <a:gd name="T6" fmla="*/ 41 w 48"/>
                  <a:gd name="T7" fmla="*/ 9 h 17"/>
                  <a:gd name="T8" fmla="*/ 46 w 48"/>
                  <a:gd name="T9" fmla="*/ 9 h 17"/>
                  <a:gd name="T10" fmla="*/ 47 w 48"/>
                  <a:gd name="T11" fmla="*/ 1 h 17"/>
                  <a:gd name="T12" fmla="*/ 47 w 48"/>
                  <a:gd name="T13" fmla="*/ 0 h 17"/>
                  <a:gd name="T14" fmla="*/ 24 w 48"/>
                  <a:gd name="T15" fmla="*/ 0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8" h="17">
                    <a:moveTo>
                      <a:pt x="24" y="0"/>
                    </a:moveTo>
                    <a:cubicBezTo>
                      <a:pt x="24" y="0"/>
                      <a:pt x="0" y="15"/>
                      <a:pt x="16" y="16"/>
                    </a:cubicBezTo>
                    <a:cubicBezTo>
                      <a:pt x="26" y="17"/>
                      <a:pt x="32" y="13"/>
                      <a:pt x="38" y="9"/>
                    </a:cubicBezTo>
                    <a:cubicBezTo>
                      <a:pt x="41" y="7"/>
                      <a:pt x="40" y="9"/>
                      <a:pt x="41" y="9"/>
                    </a:cubicBezTo>
                    <a:cubicBezTo>
                      <a:pt x="42" y="9"/>
                      <a:pt x="45" y="9"/>
                      <a:pt x="46" y="9"/>
                    </a:cubicBezTo>
                    <a:cubicBezTo>
                      <a:pt x="48" y="2"/>
                      <a:pt x="47" y="1"/>
                      <a:pt x="47" y="1"/>
                    </a:cubicBezTo>
                    <a:cubicBezTo>
                      <a:pt x="47" y="0"/>
                      <a:pt x="47" y="0"/>
                      <a:pt x="47" y="0"/>
                    </a:cubicBezTo>
                    <a:lnTo>
                      <a:pt x="24" y="0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Freeform 42">
                <a:extLst>
                  <a:ext uri="{FF2B5EF4-FFF2-40B4-BE49-F238E27FC236}">
                    <a16:creationId xmlns:a16="http://schemas.microsoft.com/office/drawing/2014/main" id="{E1B5E005-A3FA-7341-8492-0BF0AEE7F4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05388" y="5159375"/>
                <a:ext cx="84138" cy="30163"/>
              </a:xfrm>
              <a:custGeom>
                <a:avLst/>
                <a:gdLst>
                  <a:gd name="T0" fmla="*/ 2 w 48"/>
                  <a:gd name="T1" fmla="*/ 9 h 17"/>
                  <a:gd name="T2" fmla="*/ 7 w 48"/>
                  <a:gd name="T3" fmla="*/ 9 h 17"/>
                  <a:gd name="T4" fmla="*/ 10 w 48"/>
                  <a:gd name="T5" fmla="*/ 9 h 17"/>
                  <a:gd name="T6" fmla="*/ 32 w 48"/>
                  <a:gd name="T7" fmla="*/ 16 h 17"/>
                  <a:gd name="T8" fmla="*/ 24 w 48"/>
                  <a:gd name="T9" fmla="*/ 0 h 17"/>
                  <a:gd name="T10" fmla="*/ 1 w 48"/>
                  <a:gd name="T11" fmla="*/ 0 h 17"/>
                  <a:gd name="T12" fmla="*/ 1 w 48"/>
                  <a:gd name="T13" fmla="*/ 1 h 17"/>
                  <a:gd name="T14" fmla="*/ 2 w 48"/>
                  <a:gd name="T15" fmla="*/ 9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8" h="17">
                    <a:moveTo>
                      <a:pt x="2" y="9"/>
                    </a:moveTo>
                    <a:cubicBezTo>
                      <a:pt x="3" y="9"/>
                      <a:pt x="6" y="9"/>
                      <a:pt x="7" y="9"/>
                    </a:cubicBezTo>
                    <a:cubicBezTo>
                      <a:pt x="8" y="9"/>
                      <a:pt x="7" y="7"/>
                      <a:pt x="10" y="9"/>
                    </a:cubicBezTo>
                    <a:cubicBezTo>
                      <a:pt x="16" y="13"/>
                      <a:pt x="22" y="17"/>
                      <a:pt x="32" y="16"/>
                    </a:cubicBezTo>
                    <a:cubicBezTo>
                      <a:pt x="48" y="15"/>
                      <a:pt x="24" y="0"/>
                      <a:pt x="24" y="0"/>
                    </a:cubicBezTo>
                    <a:cubicBezTo>
                      <a:pt x="1" y="0"/>
                      <a:pt x="1" y="0"/>
                      <a:pt x="1" y="0"/>
                    </a:cubicBezTo>
                    <a:cubicBezTo>
                      <a:pt x="1" y="1"/>
                      <a:pt x="1" y="1"/>
                      <a:pt x="1" y="1"/>
                    </a:cubicBezTo>
                    <a:cubicBezTo>
                      <a:pt x="1" y="1"/>
                      <a:pt x="0" y="2"/>
                      <a:pt x="2" y="9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Freeform 43">
                <a:extLst>
                  <a:ext uri="{FF2B5EF4-FFF2-40B4-BE49-F238E27FC236}">
                    <a16:creationId xmlns:a16="http://schemas.microsoft.com/office/drawing/2014/main" id="{75406513-8C4F-9BDF-57CA-96613DCC8BD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97363" y="4610100"/>
                <a:ext cx="268288" cy="525463"/>
              </a:xfrm>
              <a:custGeom>
                <a:avLst/>
                <a:gdLst>
                  <a:gd name="T0" fmla="*/ 30 w 154"/>
                  <a:gd name="T1" fmla="*/ 54 h 301"/>
                  <a:gd name="T2" fmla="*/ 34 w 154"/>
                  <a:gd name="T3" fmla="*/ 57 h 301"/>
                  <a:gd name="T4" fmla="*/ 34 w 154"/>
                  <a:gd name="T5" fmla="*/ 57 h 301"/>
                  <a:gd name="T6" fmla="*/ 37 w 154"/>
                  <a:gd name="T7" fmla="*/ 113 h 301"/>
                  <a:gd name="T8" fmla="*/ 42 w 154"/>
                  <a:gd name="T9" fmla="*/ 165 h 301"/>
                  <a:gd name="T10" fmla="*/ 50 w 154"/>
                  <a:gd name="T11" fmla="*/ 187 h 301"/>
                  <a:gd name="T12" fmla="*/ 50 w 154"/>
                  <a:gd name="T13" fmla="*/ 195 h 301"/>
                  <a:gd name="T14" fmla="*/ 58 w 154"/>
                  <a:gd name="T15" fmla="*/ 301 h 301"/>
                  <a:gd name="T16" fmla="*/ 59 w 154"/>
                  <a:gd name="T17" fmla="*/ 300 h 301"/>
                  <a:gd name="T18" fmla="*/ 82 w 154"/>
                  <a:gd name="T19" fmla="*/ 300 h 301"/>
                  <a:gd name="T20" fmla="*/ 85 w 154"/>
                  <a:gd name="T21" fmla="*/ 301 h 301"/>
                  <a:gd name="T22" fmla="*/ 96 w 154"/>
                  <a:gd name="T23" fmla="*/ 212 h 301"/>
                  <a:gd name="T24" fmla="*/ 98 w 154"/>
                  <a:gd name="T25" fmla="*/ 212 h 301"/>
                  <a:gd name="T26" fmla="*/ 101 w 154"/>
                  <a:gd name="T27" fmla="*/ 212 h 301"/>
                  <a:gd name="T28" fmla="*/ 113 w 154"/>
                  <a:gd name="T29" fmla="*/ 301 h 301"/>
                  <a:gd name="T30" fmla="*/ 116 w 154"/>
                  <a:gd name="T31" fmla="*/ 300 h 301"/>
                  <a:gd name="T32" fmla="*/ 139 w 154"/>
                  <a:gd name="T33" fmla="*/ 300 h 301"/>
                  <a:gd name="T34" fmla="*/ 140 w 154"/>
                  <a:gd name="T35" fmla="*/ 301 h 301"/>
                  <a:gd name="T36" fmla="*/ 148 w 154"/>
                  <a:gd name="T37" fmla="*/ 186 h 301"/>
                  <a:gd name="T38" fmla="*/ 149 w 154"/>
                  <a:gd name="T39" fmla="*/ 185 h 301"/>
                  <a:gd name="T40" fmla="*/ 154 w 154"/>
                  <a:gd name="T41" fmla="*/ 169 h 301"/>
                  <a:gd name="T42" fmla="*/ 153 w 154"/>
                  <a:gd name="T43" fmla="*/ 156 h 301"/>
                  <a:gd name="T44" fmla="*/ 145 w 154"/>
                  <a:gd name="T45" fmla="*/ 157 h 301"/>
                  <a:gd name="T46" fmla="*/ 128 w 154"/>
                  <a:gd name="T47" fmla="*/ 153 h 301"/>
                  <a:gd name="T48" fmla="*/ 121 w 154"/>
                  <a:gd name="T49" fmla="*/ 144 h 301"/>
                  <a:gd name="T50" fmla="*/ 106 w 154"/>
                  <a:gd name="T51" fmla="*/ 26 h 301"/>
                  <a:gd name="T52" fmla="*/ 108 w 154"/>
                  <a:gd name="T53" fmla="*/ 15 h 301"/>
                  <a:gd name="T54" fmla="*/ 101 w 154"/>
                  <a:gd name="T55" fmla="*/ 16 h 301"/>
                  <a:gd name="T56" fmla="*/ 95 w 154"/>
                  <a:gd name="T57" fmla="*/ 15 h 301"/>
                  <a:gd name="T58" fmla="*/ 96 w 154"/>
                  <a:gd name="T59" fmla="*/ 19 h 301"/>
                  <a:gd name="T60" fmla="*/ 90 w 154"/>
                  <a:gd name="T61" fmla="*/ 65 h 301"/>
                  <a:gd name="T62" fmla="*/ 90 w 154"/>
                  <a:gd name="T63" fmla="*/ 68 h 301"/>
                  <a:gd name="T64" fmla="*/ 72 w 154"/>
                  <a:gd name="T65" fmla="*/ 1 h 301"/>
                  <a:gd name="T66" fmla="*/ 71 w 154"/>
                  <a:gd name="T67" fmla="*/ 0 h 301"/>
                  <a:gd name="T68" fmla="*/ 69 w 154"/>
                  <a:gd name="T69" fmla="*/ 0 h 301"/>
                  <a:gd name="T70" fmla="*/ 2 w 154"/>
                  <a:gd name="T71" fmla="*/ 35 h 301"/>
                  <a:gd name="T72" fmla="*/ 10 w 154"/>
                  <a:gd name="T73" fmla="*/ 157 h 301"/>
                  <a:gd name="T74" fmla="*/ 12 w 154"/>
                  <a:gd name="T75" fmla="*/ 157 h 301"/>
                  <a:gd name="T76" fmla="*/ 15 w 154"/>
                  <a:gd name="T77" fmla="*/ 157 h 301"/>
                  <a:gd name="T78" fmla="*/ 33 w 154"/>
                  <a:gd name="T79" fmla="*/ 161 h 301"/>
                  <a:gd name="T80" fmla="*/ 34 w 154"/>
                  <a:gd name="T81" fmla="*/ 161 h 301"/>
                  <a:gd name="T82" fmla="*/ 30 w 154"/>
                  <a:gd name="T83" fmla="*/ 54 h 3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</a:cxnLst>
                <a:rect l="0" t="0" r="r" b="b"/>
                <a:pathLst>
                  <a:path w="154" h="301">
                    <a:moveTo>
                      <a:pt x="30" y="54"/>
                    </a:moveTo>
                    <a:cubicBezTo>
                      <a:pt x="32" y="55"/>
                      <a:pt x="33" y="56"/>
                      <a:pt x="34" y="57"/>
                    </a:cubicBezTo>
                    <a:cubicBezTo>
                      <a:pt x="34" y="57"/>
                      <a:pt x="34" y="57"/>
                      <a:pt x="34" y="57"/>
                    </a:cubicBezTo>
                    <a:cubicBezTo>
                      <a:pt x="37" y="113"/>
                      <a:pt x="37" y="113"/>
                      <a:pt x="37" y="113"/>
                    </a:cubicBezTo>
                    <a:cubicBezTo>
                      <a:pt x="39" y="136"/>
                      <a:pt x="41" y="155"/>
                      <a:pt x="42" y="165"/>
                    </a:cubicBezTo>
                    <a:cubicBezTo>
                      <a:pt x="48" y="171"/>
                      <a:pt x="49" y="181"/>
                      <a:pt x="50" y="187"/>
                    </a:cubicBezTo>
                    <a:cubicBezTo>
                      <a:pt x="50" y="190"/>
                      <a:pt x="50" y="193"/>
                      <a:pt x="50" y="195"/>
                    </a:cubicBezTo>
                    <a:cubicBezTo>
                      <a:pt x="58" y="301"/>
                      <a:pt x="58" y="301"/>
                      <a:pt x="58" y="301"/>
                    </a:cubicBezTo>
                    <a:cubicBezTo>
                      <a:pt x="58" y="301"/>
                      <a:pt x="58" y="300"/>
                      <a:pt x="59" y="300"/>
                    </a:cubicBezTo>
                    <a:cubicBezTo>
                      <a:pt x="82" y="300"/>
                      <a:pt x="82" y="300"/>
                      <a:pt x="82" y="300"/>
                    </a:cubicBezTo>
                    <a:cubicBezTo>
                      <a:pt x="83" y="300"/>
                      <a:pt x="84" y="301"/>
                      <a:pt x="85" y="301"/>
                    </a:cubicBezTo>
                    <a:cubicBezTo>
                      <a:pt x="96" y="212"/>
                      <a:pt x="96" y="212"/>
                      <a:pt x="96" y="212"/>
                    </a:cubicBezTo>
                    <a:cubicBezTo>
                      <a:pt x="97" y="212"/>
                      <a:pt x="98" y="212"/>
                      <a:pt x="98" y="212"/>
                    </a:cubicBezTo>
                    <a:cubicBezTo>
                      <a:pt x="99" y="212"/>
                      <a:pt x="100" y="212"/>
                      <a:pt x="101" y="212"/>
                    </a:cubicBezTo>
                    <a:cubicBezTo>
                      <a:pt x="113" y="301"/>
                      <a:pt x="113" y="301"/>
                      <a:pt x="113" y="301"/>
                    </a:cubicBezTo>
                    <a:cubicBezTo>
                      <a:pt x="114" y="301"/>
                      <a:pt x="115" y="300"/>
                      <a:pt x="116" y="300"/>
                    </a:cubicBezTo>
                    <a:cubicBezTo>
                      <a:pt x="139" y="300"/>
                      <a:pt x="139" y="300"/>
                      <a:pt x="139" y="300"/>
                    </a:cubicBezTo>
                    <a:cubicBezTo>
                      <a:pt x="139" y="300"/>
                      <a:pt x="140" y="301"/>
                      <a:pt x="140" y="301"/>
                    </a:cubicBezTo>
                    <a:cubicBezTo>
                      <a:pt x="148" y="186"/>
                      <a:pt x="148" y="186"/>
                      <a:pt x="148" y="186"/>
                    </a:cubicBezTo>
                    <a:cubicBezTo>
                      <a:pt x="149" y="186"/>
                      <a:pt x="149" y="185"/>
                      <a:pt x="149" y="185"/>
                    </a:cubicBezTo>
                    <a:cubicBezTo>
                      <a:pt x="150" y="180"/>
                      <a:pt x="151" y="174"/>
                      <a:pt x="154" y="169"/>
                    </a:cubicBezTo>
                    <a:cubicBezTo>
                      <a:pt x="154" y="165"/>
                      <a:pt x="153" y="161"/>
                      <a:pt x="153" y="156"/>
                    </a:cubicBezTo>
                    <a:cubicBezTo>
                      <a:pt x="150" y="157"/>
                      <a:pt x="147" y="157"/>
                      <a:pt x="145" y="157"/>
                    </a:cubicBezTo>
                    <a:cubicBezTo>
                      <a:pt x="138" y="157"/>
                      <a:pt x="133" y="156"/>
                      <a:pt x="128" y="153"/>
                    </a:cubicBezTo>
                    <a:cubicBezTo>
                      <a:pt x="125" y="151"/>
                      <a:pt x="122" y="147"/>
                      <a:pt x="121" y="144"/>
                    </a:cubicBezTo>
                    <a:cubicBezTo>
                      <a:pt x="121" y="143"/>
                      <a:pt x="103" y="47"/>
                      <a:pt x="106" y="26"/>
                    </a:cubicBezTo>
                    <a:cubicBezTo>
                      <a:pt x="106" y="22"/>
                      <a:pt x="107" y="18"/>
                      <a:pt x="108" y="15"/>
                    </a:cubicBezTo>
                    <a:cubicBezTo>
                      <a:pt x="106" y="15"/>
                      <a:pt x="104" y="16"/>
                      <a:pt x="101" y="16"/>
                    </a:cubicBezTo>
                    <a:cubicBezTo>
                      <a:pt x="99" y="16"/>
                      <a:pt x="97" y="15"/>
                      <a:pt x="95" y="15"/>
                    </a:cubicBezTo>
                    <a:cubicBezTo>
                      <a:pt x="96" y="19"/>
                      <a:pt x="96" y="19"/>
                      <a:pt x="96" y="19"/>
                    </a:cubicBezTo>
                    <a:cubicBezTo>
                      <a:pt x="90" y="65"/>
                      <a:pt x="90" y="65"/>
                      <a:pt x="90" y="65"/>
                    </a:cubicBezTo>
                    <a:cubicBezTo>
                      <a:pt x="90" y="68"/>
                      <a:pt x="90" y="68"/>
                      <a:pt x="90" y="68"/>
                    </a:cubicBezTo>
                    <a:cubicBezTo>
                      <a:pt x="72" y="1"/>
                      <a:pt x="72" y="1"/>
                      <a:pt x="72" y="1"/>
                    </a:cubicBezTo>
                    <a:cubicBezTo>
                      <a:pt x="71" y="1"/>
                      <a:pt x="71" y="1"/>
                      <a:pt x="71" y="0"/>
                    </a:cubicBezTo>
                    <a:cubicBezTo>
                      <a:pt x="70" y="0"/>
                      <a:pt x="70" y="0"/>
                      <a:pt x="69" y="0"/>
                    </a:cubicBezTo>
                    <a:cubicBezTo>
                      <a:pt x="39" y="4"/>
                      <a:pt x="3" y="15"/>
                      <a:pt x="2" y="35"/>
                    </a:cubicBezTo>
                    <a:cubicBezTo>
                      <a:pt x="0" y="44"/>
                      <a:pt x="5" y="127"/>
                      <a:pt x="10" y="157"/>
                    </a:cubicBezTo>
                    <a:cubicBezTo>
                      <a:pt x="10" y="157"/>
                      <a:pt x="11" y="157"/>
                      <a:pt x="12" y="157"/>
                    </a:cubicBezTo>
                    <a:cubicBezTo>
                      <a:pt x="13" y="157"/>
                      <a:pt x="14" y="157"/>
                      <a:pt x="15" y="157"/>
                    </a:cubicBezTo>
                    <a:cubicBezTo>
                      <a:pt x="33" y="161"/>
                      <a:pt x="33" y="161"/>
                      <a:pt x="33" y="161"/>
                    </a:cubicBezTo>
                    <a:cubicBezTo>
                      <a:pt x="33" y="161"/>
                      <a:pt x="34" y="161"/>
                      <a:pt x="34" y="161"/>
                    </a:cubicBezTo>
                    <a:cubicBezTo>
                      <a:pt x="32" y="133"/>
                      <a:pt x="28" y="52"/>
                      <a:pt x="30" y="5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Freeform 44">
                <a:extLst>
                  <a:ext uri="{FF2B5EF4-FFF2-40B4-BE49-F238E27FC236}">
                    <a16:creationId xmlns:a16="http://schemas.microsoft.com/office/drawing/2014/main" id="{0AA6C3F4-5871-D3EF-AE53-54008D7B5D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18001" y="4908550"/>
                <a:ext cx="42863" cy="41275"/>
              </a:xfrm>
              <a:custGeom>
                <a:avLst/>
                <a:gdLst>
                  <a:gd name="T0" fmla="*/ 19 w 24"/>
                  <a:gd name="T1" fmla="*/ 4 h 24"/>
                  <a:gd name="T2" fmla="*/ 0 w 24"/>
                  <a:gd name="T3" fmla="*/ 0 h 24"/>
                  <a:gd name="T4" fmla="*/ 10 w 24"/>
                  <a:gd name="T5" fmla="*/ 21 h 24"/>
                  <a:gd name="T6" fmla="*/ 17 w 24"/>
                  <a:gd name="T7" fmla="*/ 15 h 24"/>
                  <a:gd name="T8" fmla="*/ 19 w 24"/>
                  <a:gd name="T9" fmla="*/ 14 h 24"/>
                  <a:gd name="T10" fmla="*/ 24 w 24"/>
                  <a:gd name="T11" fmla="*/ 18 h 24"/>
                  <a:gd name="T12" fmla="*/ 19 w 24"/>
                  <a:gd name="T13" fmla="*/ 4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4" h="24">
                    <a:moveTo>
                      <a:pt x="19" y="4"/>
                    </a:moveTo>
                    <a:cubicBezTo>
                      <a:pt x="0" y="0"/>
                      <a:pt x="0" y="0"/>
                      <a:pt x="0" y="0"/>
                    </a:cubicBezTo>
                    <a:cubicBezTo>
                      <a:pt x="0" y="0"/>
                      <a:pt x="2" y="20"/>
                      <a:pt x="10" y="21"/>
                    </a:cubicBezTo>
                    <a:cubicBezTo>
                      <a:pt x="15" y="21"/>
                      <a:pt x="17" y="19"/>
                      <a:pt x="17" y="15"/>
                    </a:cubicBezTo>
                    <a:cubicBezTo>
                      <a:pt x="17" y="11"/>
                      <a:pt x="19" y="11"/>
                      <a:pt x="19" y="14"/>
                    </a:cubicBezTo>
                    <a:cubicBezTo>
                      <a:pt x="19" y="16"/>
                      <a:pt x="24" y="24"/>
                      <a:pt x="24" y="18"/>
                    </a:cubicBezTo>
                    <a:cubicBezTo>
                      <a:pt x="23" y="12"/>
                      <a:pt x="22" y="4"/>
                      <a:pt x="19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Freeform 45">
                <a:extLst>
                  <a:ext uri="{FF2B5EF4-FFF2-40B4-BE49-F238E27FC236}">
                    <a16:creationId xmlns:a16="http://schemas.microsoft.com/office/drawing/2014/main" id="{4FD866E5-FF73-E0E6-0B9C-387CC3DC2AA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97376" y="4392612"/>
                <a:ext cx="152400" cy="219075"/>
              </a:xfrm>
              <a:custGeom>
                <a:avLst/>
                <a:gdLst>
                  <a:gd name="T0" fmla="*/ 3 w 88"/>
                  <a:gd name="T1" fmla="*/ 59 h 126"/>
                  <a:gd name="T2" fmla="*/ 0 w 88"/>
                  <a:gd name="T3" fmla="*/ 74 h 126"/>
                  <a:gd name="T4" fmla="*/ 3 w 88"/>
                  <a:gd name="T5" fmla="*/ 88 h 126"/>
                  <a:gd name="T6" fmla="*/ 6 w 88"/>
                  <a:gd name="T7" fmla="*/ 84 h 126"/>
                  <a:gd name="T8" fmla="*/ 44 w 88"/>
                  <a:gd name="T9" fmla="*/ 126 h 126"/>
                  <a:gd name="T10" fmla="*/ 82 w 88"/>
                  <a:gd name="T11" fmla="*/ 83 h 126"/>
                  <a:gd name="T12" fmla="*/ 84 w 88"/>
                  <a:gd name="T13" fmla="*/ 87 h 126"/>
                  <a:gd name="T14" fmla="*/ 88 w 88"/>
                  <a:gd name="T15" fmla="*/ 73 h 126"/>
                  <a:gd name="T16" fmla="*/ 84 w 88"/>
                  <a:gd name="T17" fmla="*/ 59 h 126"/>
                  <a:gd name="T18" fmla="*/ 83 w 88"/>
                  <a:gd name="T19" fmla="*/ 59 h 126"/>
                  <a:gd name="T20" fmla="*/ 83 w 88"/>
                  <a:gd name="T21" fmla="*/ 47 h 126"/>
                  <a:gd name="T22" fmla="*/ 51 w 88"/>
                  <a:gd name="T23" fmla="*/ 39 h 126"/>
                  <a:gd name="T24" fmla="*/ 55 w 88"/>
                  <a:gd name="T25" fmla="*/ 41 h 126"/>
                  <a:gd name="T26" fmla="*/ 87 w 88"/>
                  <a:gd name="T27" fmla="*/ 30 h 126"/>
                  <a:gd name="T28" fmla="*/ 15 w 88"/>
                  <a:gd name="T29" fmla="*/ 23 h 126"/>
                  <a:gd name="T30" fmla="*/ 1 w 88"/>
                  <a:gd name="T31" fmla="*/ 32 h 126"/>
                  <a:gd name="T32" fmla="*/ 11 w 88"/>
                  <a:gd name="T33" fmla="*/ 32 h 126"/>
                  <a:gd name="T34" fmla="*/ 4 w 88"/>
                  <a:gd name="T35" fmla="*/ 52 h 126"/>
                  <a:gd name="T36" fmla="*/ 4 w 88"/>
                  <a:gd name="T37" fmla="*/ 59 h 126"/>
                  <a:gd name="T38" fmla="*/ 3 w 88"/>
                  <a:gd name="T39" fmla="*/ 59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88" h="126">
                    <a:moveTo>
                      <a:pt x="3" y="59"/>
                    </a:moveTo>
                    <a:cubicBezTo>
                      <a:pt x="1" y="59"/>
                      <a:pt x="0" y="66"/>
                      <a:pt x="0" y="74"/>
                    </a:cubicBezTo>
                    <a:cubicBezTo>
                      <a:pt x="0" y="81"/>
                      <a:pt x="1" y="88"/>
                      <a:pt x="3" y="88"/>
                    </a:cubicBezTo>
                    <a:cubicBezTo>
                      <a:pt x="4" y="88"/>
                      <a:pt x="5" y="86"/>
                      <a:pt x="6" y="84"/>
                    </a:cubicBezTo>
                    <a:cubicBezTo>
                      <a:pt x="12" y="108"/>
                      <a:pt x="33" y="126"/>
                      <a:pt x="44" y="126"/>
                    </a:cubicBezTo>
                    <a:cubicBezTo>
                      <a:pt x="59" y="126"/>
                      <a:pt x="79" y="110"/>
                      <a:pt x="82" y="83"/>
                    </a:cubicBezTo>
                    <a:cubicBezTo>
                      <a:pt x="83" y="85"/>
                      <a:pt x="83" y="87"/>
                      <a:pt x="84" y="87"/>
                    </a:cubicBezTo>
                    <a:cubicBezTo>
                      <a:pt x="86" y="87"/>
                      <a:pt x="88" y="81"/>
                      <a:pt x="88" y="73"/>
                    </a:cubicBezTo>
                    <a:cubicBezTo>
                      <a:pt x="88" y="65"/>
                      <a:pt x="86" y="59"/>
                      <a:pt x="84" y="59"/>
                    </a:cubicBezTo>
                    <a:cubicBezTo>
                      <a:pt x="84" y="59"/>
                      <a:pt x="84" y="59"/>
                      <a:pt x="83" y="59"/>
                    </a:cubicBezTo>
                    <a:cubicBezTo>
                      <a:pt x="84" y="56"/>
                      <a:pt x="84" y="52"/>
                      <a:pt x="83" y="47"/>
                    </a:cubicBezTo>
                    <a:cubicBezTo>
                      <a:pt x="77" y="52"/>
                      <a:pt x="64" y="45"/>
                      <a:pt x="51" y="39"/>
                    </a:cubicBezTo>
                    <a:cubicBezTo>
                      <a:pt x="52" y="40"/>
                      <a:pt x="54" y="40"/>
                      <a:pt x="55" y="41"/>
                    </a:cubicBezTo>
                    <a:cubicBezTo>
                      <a:pt x="78" y="53"/>
                      <a:pt x="87" y="30"/>
                      <a:pt x="87" y="30"/>
                    </a:cubicBezTo>
                    <a:cubicBezTo>
                      <a:pt x="87" y="30"/>
                      <a:pt x="59" y="0"/>
                      <a:pt x="15" y="23"/>
                    </a:cubicBezTo>
                    <a:cubicBezTo>
                      <a:pt x="11" y="25"/>
                      <a:pt x="6" y="30"/>
                      <a:pt x="1" y="32"/>
                    </a:cubicBezTo>
                    <a:cubicBezTo>
                      <a:pt x="1" y="32"/>
                      <a:pt x="5" y="32"/>
                      <a:pt x="11" y="32"/>
                    </a:cubicBezTo>
                    <a:cubicBezTo>
                      <a:pt x="6" y="35"/>
                      <a:pt x="3" y="41"/>
                      <a:pt x="4" y="52"/>
                    </a:cubicBezTo>
                    <a:cubicBezTo>
                      <a:pt x="4" y="54"/>
                      <a:pt x="4" y="57"/>
                      <a:pt x="4" y="59"/>
                    </a:cubicBezTo>
                    <a:cubicBezTo>
                      <a:pt x="4" y="59"/>
                      <a:pt x="3" y="59"/>
                      <a:pt x="3" y="59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Freeform 46">
                <a:extLst>
                  <a:ext uri="{FF2B5EF4-FFF2-40B4-BE49-F238E27FC236}">
                    <a16:creationId xmlns:a16="http://schemas.microsoft.com/office/drawing/2014/main" id="{AC8A1C22-2E0F-0388-511C-DE346E2EB3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56101" y="5159375"/>
                <a:ext cx="84138" cy="30163"/>
              </a:xfrm>
              <a:custGeom>
                <a:avLst/>
                <a:gdLst>
                  <a:gd name="T0" fmla="*/ 17 w 48"/>
                  <a:gd name="T1" fmla="*/ 16 h 17"/>
                  <a:gd name="T2" fmla="*/ 39 w 48"/>
                  <a:gd name="T3" fmla="*/ 9 h 17"/>
                  <a:gd name="T4" fmla="*/ 42 w 48"/>
                  <a:gd name="T5" fmla="*/ 9 h 17"/>
                  <a:gd name="T6" fmla="*/ 47 w 48"/>
                  <a:gd name="T7" fmla="*/ 9 h 17"/>
                  <a:gd name="T8" fmla="*/ 47 w 48"/>
                  <a:gd name="T9" fmla="*/ 1 h 17"/>
                  <a:gd name="T10" fmla="*/ 48 w 48"/>
                  <a:gd name="T11" fmla="*/ 0 h 17"/>
                  <a:gd name="T12" fmla="*/ 25 w 48"/>
                  <a:gd name="T13" fmla="*/ 0 h 17"/>
                  <a:gd name="T14" fmla="*/ 17 w 48"/>
                  <a:gd name="T15" fmla="*/ 16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8" h="17">
                    <a:moveTo>
                      <a:pt x="17" y="16"/>
                    </a:moveTo>
                    <a:cubicBezTo>
                      <a:pt x="27" y="17"/>
                      <a:pt x="33" y="13"/>
                      <a:pt x="39" y="9"/>
                    </a:cubicBezTo>
                    <a:cubicBezTo>
                      <a:pt x="42" y="7"/>
                      <a:pt x="41" y="9"/>
                      <a:pt x="42" y="9"/>
                    </a:cubicBezTo>
                    <a:cubicBezTo>
                      <a:pt x="43" y="9"/>
                      <a:pt x="46" y="9"/>
                      <a:pt x="47" y="9"/>
                    </a:cubicBezTo>
                    <a:cubicBezTo>
                      <a:pt x="48" y="2"/>
                      <a:pt x="47" y="1"/>
                      <a:pt x="47" y="1"/>
                    </a:cubicBezTo>
                    <a:cubicBezTo>
                      <a:pt x="48" y="0"/>
                      <a:pt x="48" y="0"/>
                      <a:pt x="48" y="0"/>
                    </a:cubicBezTo>
                    <a:cubicBezTo>
                      <a:pt x="25" y="0"/>
                      <a:pt x="25" y="0"/>
                      <a:pt x="25" y="0"/>
                    </a:cubicBezTo>
                    <a:cubicBezTo>
                      <a:pt x="25" y="0"/>
                      <a:pt x="0" y="15"/>
                      <a:pt x="17" y="16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Freeform 47">
                <a:extLst>
                  <a:ext uri="{FF2B5EF4-FFF2-40B4-BE49-F238E27FC236}">
                    <a16:creationId xmlns:a16="http://schemas.microsoft.com/office/drawing/2014/main" id="{33A2F4C1-C7F7-2954-2E3E-1A5DFBB0ED7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98976" y="5159375"/>
                <a:ext cx="84138" cy="30163"/>
              </a:xfrm>
              <a:custGeom>
                <a:avLst/>
                <a:gdLst>
                  <a:gd name="T0" fmla="*/ 1 w 48"/>
                  <a:gd name="T1" fmla="*/ 9 h 17"/>
                  <a:gd name="T2" fmla="*/ 6 w 48"/>
                  <a:gd name="T3" fmla="*/ 9 h 17"/>
                  <a:gd name="T4" fmla="*/ 9 w 48"/>
                  <a:gd name="T5" fmla="*/ 9 h 17"/>
                  <a:gd name="T6" fmla="*/ 31 w 48"/>
                  <a:gd name="T7" fmla="*/ 16 h 17"/>
                  <a:gd name="T8" fmla="*/ 23 w 48"/>
                  <a:gd name="T9" fmla="*/ 0 h 17"/>
                  <a:gd name="T10" fmla="*/ 0 w 48"/>
                  <a:gd name="T11" fmla="*/ 0 h 17"/>
                  <a:gd name="T12" fmla="*/ 1 w 48"/>
                  <a:gd name="T13" fmla="*/ 1 h 17"/>
                  <a:gd name="T14" fmla="*/ 1 w 48"/>
                  <a:gd name="T15" fmla="*/ 9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8" h="17">
                    <a:moveTo>
                      <a:pt x="1" y="9"/>
                    </a:moveTo>
                    <a:cubicBezTo>
                      <a:pt x="2" y="9"/>
                      <a:pt x="5" y="9"/>
                      <a:pt x="6" y="9"/>
                    </a:cubicBezTo>
                    <a:cubicBezTo>
                      <a:pt x="7" y="9"/>
                      <a:pt x="6" y="7"/>
                      <a:pt x="9" y="9"/>
                    </a:cubicBezTo>
                    <a:cubicBezTo>
                      <a:pt x="15" y="13"/>
                      <a:pt x="21" y="17"/>
                      <a:pt x="31" y="16"/>
                    </a:cubicBezTo>
                    <a:cubicBezTo>
                      <a:pt x="48" y="15"/>
                      <a:pt x="23" y="0"/>
                      <a:pt x="23" y="0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1" y="1"/>
                      <a:pt x="1" y="1"/>
                      <a:pt x="1" y="1"/>
                    </a:cubicBezTo>
                    <a:cubicBezTo>
                      <a:pt x="1" y="1"/>
                      <a:pt x="0" y="2"/>
                      <a:pt x="1" y="9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Freeform 48">
                <a:extLst>
                  <a:ext uri="{FF2B5EF4-FFF2-40B4-BE49-F238E27FC236}">
                    <a16:creationId xmlns:a16="http://schemas.microsoft.com/office/drawing/2014/main" id="{2C1EA550-7C94-83A2-0F7A-F6ED6E09A4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27563" y="4305300"/>
                <a:ext cx="195263" cy="279400"/>
              </a:xfrm>
              <a:custGeom>
                <a:avLst/>
                <a:gdLst>
                  <a:gd name="T0" fmla="*/ 5 w 112"/>
                  <a:gd name="T1" fmla="*/ 75 h 160"/>
                  <a:gd name="T2" fmla="*/ 0 w 112"/>
                  <a:gd name="T3" fmla="*/ 93 h 160"/>
                  <a:gd name="T4" fmla="*/ 5 w 112"/>
                  <a:gd name="T5" fmla="*/ 111 h 160"/>
                  <a:gd name="T6" fmla="*/ 8 w 112"/>
                  <a:gd name="T7" fmla="*/ 106 h 160"/>
                  <a:gd name="T8" fmla="*/ 57 w 112"/>
                  <a:gd name="T9" fmla="*/ 160 h 160"/>
                  <a:gd name="T10" fmla="*/ 104 w 112"/>
                  <a:gd name="T11" fmla="*/ 104 h 160"/>
                  <a:gd name="T12" fmla="*/ 107 w 112"/>
                  <a:gd name="T13" fmla="*/ 110 h 160"/>
                  <a:gd name="T14" fmla="*/ 112 w 112"/>
                  <a:gd name="T15" fmla="*/ 92 h 160"/>
                  <a:gd name="T16" fmla="*/ 107 w 112"/>
                  <a:gd name="T17" fmla="*/ 74 h 160"/>
                  <a:gd name="T18" fmla="*/ 106 w 112"/>
                  <a:gd name="T19" fmla="*/ 75 h 160"/>
                  <a:gd name="T20" fmla="*/ 106 w 112"/>
                  <a:gd name="T21" fmla="*/ 60 h 160"/>
                  <a:gd name="T22" fmla="*/ 65 w 112"/>
                  <a:gd name="T23" fmla="*/ 49 h 160"/>
                  <a:gd name="T24" fmla="*/ 71 w 112"/>
                  <a:gd name="T25" fmla="*/ 52 h 160"/>
                  <a:gd name="T26" fmla="*/ 110 w 112"/>
                  <a:gd name="T27" fmla="*/ 38 h 160"/>
                  <a:gd name="T28" fmla="*/ 20 w 112"/>
                  <a:gd name="T29" fmla="*/ 29 h 160"/>
                  <a:gd name="T30" fmla="*/ 2 w 112"/>
                  <a:gd name="T31" fmla="*/ 41 h 160"/>
                  <a:gd name="T32" fmla="*/ 14 w 112"/>
                  <a:gd name="T33" fmla="*/ 41 h 160"/>
                  <a:gd name="T34" fmla="*/ 6 w 112"/>
                  <a:gd name="T35" fmla="*/ 66 h 160"/>
                  <a:gd name="T36" fmla="*/ 5 w 112"/>
                  <a:gd name="T37" fmla="*/ 75 h 160"/>
                  <a:gd name="T38" fmla="*/ 5 w 112"/>
                  <a:gd name="T39" fmla="*/ 75 h 1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112" h="160">
                    <a:moveTo>
                      <a:pt x="5" y="75"/>
                    </a:moveTo>
                    <a:cubicBezTo>
                      <a:pt x="2" y="75"/>
                      <a:pt x="0" y="83"/>
                      <a:pt x="0" y="93"/>
                    </a:cubicBezTo>
                    <a:cubicBezTo>
                      <a:pt x="0" y="103"/>
                      <a:pt x="2" y="111"/>
                      <a:pt x="5" y="111"/>
                    </a:cubicBezTo>
                    <a:cubicBezTo>
                      <a:pt x="6" y="111"/>
                      <a:pt x="7" y="109"/>
                      <a:pt x="8" y="106"/>
                    </a:cubicBezTo>
                    <a:cubicBezTo>
                      <a:pt x="15" y="137"/>
                      <a:pt x="42" y="160"/>
                      <a:pt x="57" y="160"/>
                    </a:cubicBezTo>
                    <a:cubicBezTo>
                      <a:pt x="75" y="160"/>
                      <a:pt x="100" y="138"/>
                      <a:pt x="104" y="104"/>
                    </a:cubicBezTo>
                    <a:cubicBezTo>
                      <a:pt x="105" y="108"/>
                      <a:pt x="106" y="110"/>
                      <a:pt x="107" y="110"/>
                    </a:cubicBezTo>
                    <a:cubicBezTo>
                      <a:pt x="110" y="110"/>
                      <a:pt x="112" y="102"/>
                      <a:pt x="112" y="92"/>
                    </a:cubicBezTo>
                    <a:cubicBezTo>
                      <a:pt x="112" y="82"/>
                      <a:pt x="110" y="74"/>
                      <a:pt x="107" y="74"/>
                    </a:cubicBezTo>
                    <a:cubicBezTo>
                      <a:pt x="107" y="74"/>
                      <a:pt x="106" y="74"/>
                      <a:pt x="106" y="75"/>
                    </a:cubicBezTo>
                    <a:cubicBezTo>
                      <a:pt x="106" y="70"/>
                      <a:pt x="106" y="65"/>
                      <a:pt x="106" y="60"/>
                    </a:cubicBezTo>
                    <a:cubicBezTo>
                      <a:pt x="97" y="66"/>
                      <a:pt x="82" y="57"/>
                      <a:pt x="65" y="49"/>
                    </a:cubicBezTo>
                    <a:cubicBezTo>
                      <a:pt x="67" y="50"/>
                      <a:pt x="69" y="51"/>
                      <a:pt x="71" y="52"/>
                    </a:cubicBezTo>
                    <a:cubicBezTo>
                      <a:pt x="99" y="66"/>
                      <a:pt x="110" y="38"/>
                      <a:pt x="110" y="38"/>
                    </a:cubicBezTo>
                    <a:cubicBezTo>
                      <a:pt x="110" y="38"/>
                      <a:pt x="75" y="0"/>
                      <a:pt x="20" y="29"/>
                    </a:cubicBezTo>
                    <a:cubicBezTo>
                      <a:pt x="15" y="31"/>
                      <a:pt x="8" y="38"/>
                      <a:pt x="2" y="41"/>
                    </a:cubicBezTo>
                    <a:cubicBezTo>
                      <a:pt x="2" y="41"/>
                      <a:pt x="7" y="41"/>
                      <a:pt x="14" y="41"/>
                    </a:cubicBezTo>
                    <a:cubicBezTo>
                      <a:pt x="8" y="44"/>
                      <a:pt x="5" y="52"/>
                      <a:pt x="6" y="66"/>
                    </a:cubicBezTo>
                    <a:cubicBezTo>
                      <a:pt x="6" y="69"/>
                      <a:pt x="5" y="72"/>
                      <a:pt x="5" y="75"/>
                    </a:cubicBezTo>
                    <a:cubicBezTo>
                      <a:pt x="5" y="75"/>
                      <a:pt x="5" y="75"/>
                      <a:pt x="5" y="75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Freeform 49">
                <a:extLst>
                  <a:ext uri="{FF2B5EF4-FFF2-40B4-BE49-F238E27FC236}">
                    <a16:creationId xmlns:a16="http://schemas.microsoft.com/office/drawing/2014/main" id="{8DBE6C72-B24B-CECC-7C9D-E2A94C6028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78351" y="5275262"/>
                <a:ext cx="104775" cy="38100"/>
              </a:xfrm>
              <a:custGeom>
                <a:avLst/>
                <a:gdLst>
                  <a:gd name="T0" fmla="*/ 31 w 60"/>
                  <a:gd name="T1" fmla="*/ 0 h 22"/>
                  <a:gd name="T2" fmla="*/ 21 w 60"/>
                  <a:gd name="T3" fmla="*/ 21 h 22"/>
                  <a:gd name="T4" fmla="*/ 48 w 60"/>
                  <a:gd name="T5" fmla="*/ 12 h 22"/>
                  <a:gd name="T6" fmla="*/ 52 w 60"/>
                  <a:gd name="T7" fmla="*/ 12 h 22"/>
                  <a:gd name="T8" fmla="*/ 58 w 60"/>
                  <a:gd name="T9" fmla="*/ 11 h 22"/>
                  <a:gd name="T10" fmla="*/ 59 w 60"/>
                  <a:gd name="T11" fmla="*/ 1 h 22"/>
                  <a:gd name="T12" fmla="*/ 60 w 60"/>
                  <a:gd name="T13" fmla="*/ 0 h 22"/>
                  <a:gd name="T14" fmla="*/ 31 w 60"/>
                  <a:gd name="T15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60" h="22">
                    <a:moveTo>
                      <a:pt x="31" y="0"/>
                    </a:moveTo>
                    <a:cubicBezTo>
                      <a:pt x="31" y="0"/>
                      <a:pt x="0" y="19"/>
                      <a:pt x="21" y="21"/>
                    </a:cubicBezTo>
                    <a:cubicBezTo>
                      <a:pt x="33" y="22"/>
                      <a:pt x="41" y="17"/>
                      <a:pt x="48" y="12"/>
                    </a:cubicBezTo>
                    <a:cubicBezTo>
                      <a:pt x="52" y="9"/>
                      <a:pt x="51" y="12"/>
                      <a:pt x="52" y="12"/>
                    </a:cubicBezTo>
                    <a:cubicBezTo>
                      <a:pt x="54" y="12"/>
                      <a:pt x="58" y="12"/>
                      <a:pt x="58" y="11"/>
                    </a:cubicBezTo>
                    <a:cubicBezTo>
                      <a:pt x="60" y="3"/>
                      <a:pt x="59" y="1"/>
                      <a:pt x="59" y="1"/>
                    </a:cubicBezTo>
                    <a:cubicBezTo>
                      <a:pt x="60" y="0"/>
                      <a:pt x="60" y="0"/>
                      <a:pt x="60" y="0"/>
                    </a:cubicBezTo>
                    <a:lnTo>
                      <a:pt x="31" y="0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Freeform 50">
                <a:extLst>
                  <a:ext uri="{FF2B5EF4-FFF2-40B4-BE49-F238E27FC236}">
                    <a16:creationId xmlns:a16="http://schemas.microsoft.com/office/drawing/2014/main" id="{AE3B4F25-A45E-FF8B-61C8-49F3C33F17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57738" y="5275262"/>
                <a:ext cx="106363" cy="38100"/>
              </a:xfrm>
              <a:custGeom>
                <a:avLst/>
                <a:gdLst>
                  <a:gd name="T0" fmla="*/ 2 w 61"/>
                  <a:gd name="T1" fmla="*/ 11 h 22"/>
                  <a:gd name="T2" fmla="*/ 8 w 61"/>
                  <a:gd name="T3" fmla="*/ 12 h 22"/>
                  <a:gd name="T4" fmla="*/ 12 w 61"/>
                  <a:gd name="T5" fmla="*/ 12 h 22"/>
                  <a:gd name="T6" fmla="*/ 40 w 61"/>
                  <a:gd name="T7" fmla="*/ 21 h 22"/>
                  <a:gd name="T8" fmla="*/ 29 w 61"/>
                  <a:gd name="T9" fmla="*/ 0 h 22"/>
                  <a:gd name="T10" fmla="*/ 1 w 61"/>
                  <a:gd name="T11" fmla="*/ 0 h 22"/>
                  <a:gd name="T12" fmla="*/ 1 w 61"/>
                  <a:gd name="T13" fmla="*/ 1 h 22"/>
                  <a:gd name="T14" fmla="*/ 2 w 61"/>
                  <a:gd name="T15" fmla="*/ 11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61" h="22">
                    <a:moveTo>
                      <a:pt x="2" y="11"/>
                    </a:moveTo>
                    <a:cubicBezTo>
                      <a:pt x="3" y="12"/>
                      <a:pt x="7" y="12"/>
                      <a:pt x="8" y="12"/>
                    </a:cubicBezTo>
                    <a:cubicBezTo>
                      <a:pt x="9" y="12"/>
                      <a:pt x="8" y="9"/>
                      <a:pt x="12" y="12"/>
                    </a:cubicBezTo>
                    <a:cubicBezTo>
                      <a:pt x="19" y="17"/>
                      <a:pt x="27" y="22"/>
                      <a:pt x="40" y="21"/>
                    </a:cubicBezTo>
                    <a:cubicBezTo>
                      <a:pt x="61" y="19"/>
                      <a:pt x="29" y="0"/>
                      <a:pt x="29" y="0"/>
                    </a:cubicBezTo>
                    <a:cubicBezTo>
                      <a:pt x="1" y="0"/>
                      <a:pt x="1" y="0"/>
                      <a:pt x="1" y="0"/>
                    </a:cubicBezTo>
                    <a:cubicBezTo>
                      <a:pt x="1" y="1"/>
                      <a:pt x="1" y="1"/>
                      <a:pt x="1" y="1"/>
                    </a:cubicBezTo>
                    <a:cubicBezTo>
                      <a:pt x="1" y="1"/>
                      <a:pt x="0" y="3"/>
                      <a:pt x="2" y="11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Freeform 51">
                <a:extLst>
                  <a:ext uri="{FF2B5EF4-FFF2-40B4-BE49-F238E27FC236}">
                    <a16:creationId xmlns:a16="http://schemas.microsoft.com/office/drawing/2014/main" id="{0837272F-C8C4-3161-9F90-E8AABD78EEF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503738" y="4572000"/>
                <a:ext cx="444500" cy="692150"/>
              </a:xfrm>
              <a:custGeom>
                <a:avLst/>
                <a:gdLst>
                  <a:gd name="T0" fmla="*/ 251 w 255"/>
                  <a:gd name="T1" fmla="*/ 47 h 397"/>
                  <a:gd name="T2" fmla="*/ 162 w 255"/>
                  <a:gd name="T3" fmla="*/ 8 h 397"/>
                  <a:gd name="T4" fmla="*/ 136 w 255"/>
                  <a:gd name="T5" fmla="*/ 30 h 397"/>
                  <a:gd name="T6" fmla="*/ 134 w 255"/>
                  <a:gd name="T7" fmla="*/ 15 h 397"/>
                  <a:gd name="T8" fmla="*/ 119 w 255"/>
                  <a:gd name="T9" fmla="*/ 23 h 397"/>
                  <a:gd name="T10" fmla="*/ 113 w 255"/>
                  <a:gd name="T11" fmla="*/ 87 h 397"/>
                  <a:gd name="T12" fmla="*/ 90 w 255"/>
                  <a:gd name="T13" fmla="*/ 5 h 397"/>
                  <a:gd name="T14" fmla="*/ 2 w 255"/>
                  <a:gd name="T15" fmla="*/ 49 h 397"/>
                  <a:gd name="T16" fmla="*/ 48 w 255"/>
                  <a:gd name="T17" fmla="*/ 161 h 397"/>
                  <a:gd name="T18" fmla="*/ 54 w 255"/>
                  <a:gd name="T19" fmla="*/ 224 h 397"/>
                  <a:gd name="T20" fmla="*/ 73 w 255"/>
                  <a:gd name="T21" fmla="*/ 397 h 397"/>
                  <a:gd name="T22" fmla="*/ 121 w 255"/>
                  <a:gd name="T23" fmla="*/ 273 h 397"/>
                  <a:gd name="T24" fmla="*/ 128 w 255"/>
                  <a:gd name="T25" fmla="*/ 273 h 397"/>
                  <a:gd name="T26" fmla="*/ 175 w 255"/>
                  <a:gd name="T27" fmla="*/ 397 h 397"/>
                  <a:gd name="T28" fmla="*/ 196 w 255"/>
                  <a:gd name="T29" fmla="*/ 224 h 397"/>
                  <a:gd name="T30" fmla="*/ 200 w 255"/>
                  <a:gd name="T31" fmla="*/ 173 h 397"/>
                  <a:gd name="T32" fmla="*/ 220 w 255"/>
                  <a:gd name="T33" fmla="*/ 163 h 397"/>
                  <a:gd name="T34" fmla="*/ 207 w 255"/>
                  <a:gd name="T35" fmla="*/ 79 h 397"/>
                  <a:gd name="T36" fmla="*/ 211 w 255"/>
                  <a:gd name="T37" fmla="*/ 73 h 397"/>
                  <a:gd name="T38" fmla="*/ 207 w 255"/>
                  <a:gd name="T39" fmla="*/ 79 h 397"/>
                  <a:gd name="T40" fmla="*/ 112 w 255"/>
                  <a:gd name="T41" fmla="*/ 110 h 397"/>
                  <a:gd name="T42" fmla="*/ 127 w 255"/>
                  <a:gd name="T43" fmla="*/ 109 h 397"/>
                  <a:gd name="T44" fmla="*/ 139 w 255"/>
                  <a:gd name="T45" fmla="*/ 111 h 397"/>
                  <a:gd name="T46" fmla="*/ 126 w 255"/>
                  <a:gd name="T47" fmla="*/ 113 h 397"/>
                  <a:gd name="T48" fmla="*/ 48 w 255"/>
                  <a:gd name="T49" fmla="*/ 118 h 397"/>
                  <a:gd name="T50" fmla="*/ 42 w 255"/>
                  <a:gd name="T51" fmla="*/ 77 h 397"/>
                  <a:gd name="T52" fmla="*/ 42 w 255"/>
                  <a:gd name="T53" fmla="*/ 83 h 397"/>
                  <a:gd name="T54" fmla="*/ 42 w 255"/>
                  <a:gd name="T55" fmla="*/ 77 h 397"/>
                  <a:gd name="T56" fmla="*/ 120 w 255"/>
                  <a:gd name="T57" fmla="*/ 139 h 397"/>
                  <a:gd name="T58" fmla="*/ 121 w 255"/>
                  <a:gd name="T59" fmla="*/ 135 h 397"/>
                  <a:gd name="T60" fmla="*/ 132 w 255"/>
                  <a:gd name="T61" fmla="*/ 131 h 397"/>
                  <a:gd name="T62" fmla="*/ 215 w 255"/>
                  <a:gd name="T63" fmla="*/ 120 h 397"/>
                  <a:gd name="T64" fmla="*/ 220 w 255"/>
                  <a:gd name="T65" fmla="*/ 126 h 3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255" h="397">
                    <a:moveTo>
                      <a:pt x="227" y="144"/>
                    </a:moveTo>
                    <a:cubicBezTo>
                      <a:pt x="240" y="109"/>
                      <a:pt x="255" y="69"/>
                      <a:pt x="251" y="47"/>
                    </a:cubicBezTo>
                    <a:cubicBezTo>
                      <a:pt x="250" y="32"/>
                      <a:pt x="203" y="0"/>
                      <a:pt x="167" y="5"/>
                    </a:cubicBezTo>
                    <a:cubicBezTo>
                      <a:pt x="167" y="6"/>
                      <a:pt x="165" y="7"/>
                      <a:pt x="162" y="8"/>
                    </a:cubicBezTo>
                    <a:cubicBezTo>
                      <a:pt x="143" y="91"/>
                      <a:pt x="143" y="91"/>
                      <a:pt x="143" y="91"/>
                    </a:cubicBezTo>
                    <a:cubicBezTo>
                      <a:pt x="136" y="30"/>
                      <a:pt x="136" y="30"/>
                      <a:pt x="136" y="30"/>
                    </a:cubicBezTo>
                    <a:cubicBezTo>
                      <a:pt x="138" y="23"/>
                      <a:pt x="138" y="23"/>
                      <a:pt x="138" y="23"/>
                    </a:cubicBezTo>
                    <a:cubicBezTo>
                      <a:pt x="134" y="15"/>
                      <a:pt x="134" y="15"/>
                      <a:pt x="134" y="15"/>
                    </a:cubicBezTo>
                    <a:cubicBezTo>
                      <a:pt x="123" y="15"/>
                      <a:pt x="123" y="15"/>
                      <a:pt x="123" y="15"/>
                    </a:cubicBezTo>
                    <a:cubicBezTo>
                      <a:pt x="119" y="23"/>
                      <a:pt x="119" y="23"/>
                      <a:pt x="119" y="23"/>
                    </a:cubicBezTo>
                    <a:cubicBezTo>
                      <a:pt x="121" y="29"/>
                      <a:pt x="121" y="29"/>
                      <a:pt x="121" y="29"/>
                    </a:cubicBezTo>
                    <a:cubicBezTo>
                      <a:pt x="113" y="87"/>
                      <a:pt x="113" y="87"/>
                      <a:pt x="113" y="87"/>
                    </a:cubicBezTo>
                    <a:cubicBezTo>
                      <a:pt x="113" y="90"/>
                      <a:pt x="113" y="90"/>
                      <a:pt x="113" y="90"/>
                    </a:cubicBezTo>
                    <a:cubicBezTo>
                      <a:pt x="90" y="5"/>
                      <a:pt x="90" y="5"/>
                      <a:pt x="90" y="5"/>
                    </a:cubicBezTo>
                    <a:cubicBezTo>
                      <a:pt x="89" y="5"/>
                      <a:pt x="88" y="5"/>
                      <a:pt x="87" y="5"/>
                    </a:cubicBezTo>
                    <a:cubicBezTo>
                      <a:pt x="49" y="11"/>
                      <a:pt x="3" y="24"/>
                      <a:pt x="2" y="49"/>
                    </a:cubicBezTo>
                    <a:cubicBezTo>
                      <a:pt x="0" y="61"/>
                      <a:pt x="12" y="135"/>
                      <a:pt x="18" y="163"/>
                    </a:cubicBezTo>
                    <a:cubicBezTo>
                      <a:pt x="24" y="167"/>
                      <a:pt x="37" y="164"/>
                      <a:pt x="48" y="161"/>
                    </a:cubicBezTo>
                    <a:cubicBezTo>
                      <a:pt x="51" y="196"/>
                      <a:pt x="53" y="222"/>
                      <a:pt x="53" y="222"/>
                    </a:cubicBezTo>
                    <a:cubicBezTo>
                      <a:pt x="54" y="224"/>
                      <a:pt x="54" y="224"/>
                      <a:pt x="54" y="224"/>
                    </a:cubicBezTo>
                    <a:cubicBezTo>
                      <a:pt x="55" y="229"/>
                      <a:pt x="58" y="234"/>
                      <a:pt x="61" y="238"/>
                    </a:cubicBezTo>
                    <a:cubicBezTo>
                      <a:pt x="73" y="397"/>
                      <a:pt x="73" y="397"/>
                      <a:pt x="73" y="397"/>
                    </a:cubicBezTo>
                    <a:cubicBezTo>
                      <a:pt x="106" y="397"/>
                      <a:pt x="106" y="397"/>
                      <a:pt x="106" y="397"/>
                    </a:cubicBezTo>
                    <a:cubicBezTo>
                      <a:pt x="121" y="273"/>
                      <a:pt x="121" y="273"/>
                      <a:pt x="121" y="273"/>
                    </a:cubicBezTo>
                    <a:cubicBezTo>
                      <a:pt x="122" y="273"/>
                      <a:pt x="123" y="273"/>
                      <a:pt x="124" y="273"/>
                    </a:cubicBezTo>
                    <a:cubicBezTo>
                      <a:pt x="125" y="273"/>
                      <a:pt x="126" y="273"/>
                      <a:pt x="128" y="273"/>
                    </a:cubicBezTo>
                    <a:cubicBezTo>
                      <a:pt x="144" y="397"/>
                      <a:pt x="144" y="397"/>
                      <a:pt x="144" y="397"/>
                    </a:cubicBezTo>
                    <a:cubicBezTo>
                      <a:pt x="175" y="397"/>
                      <a:pt x="175" y="397"/>
                      <a:pt x="175" y="397"/>
                    </a:cubicBezTo>
                    <a:cubicBezTo>
                      <a:pt x="187" y="240"/>
                      <a:pt x="187" y="240"/>
                      <a:pt x="187" y="240"/>
                    </a:cubicBezTo>
                    <a:cubicBezTo>
                      <a:pt x="191" y="235"/>
                      <a:pt x="194" y="229"/>
                      <a:pt x="196" y="224"/>
                    </a:cubicBezTo>
                    <a:cubicBezTo>
                      <a:pt x="196" y="222"/>
                      <a:pt x="196" y="222"/>
                      <a:pt x="196" y="222"/>
                    </a:cubicBezTo>
                    <a:cubicBezTo>
                      <a:pt x="196" y="222"/>
                      <a:pt x="198" y="202"/>
                      <a:pt x="200" y="173"/>
                    </a:cubicBezTo>
                    <a:cubicBezTo>
                      <a:pt x="201" y="158"/>
                      <a:pt x="201" y="158"/>
                      <a:pt x="201" y="158"/>
                    </a:cubicBezTo>
                    <a:cubicBezTo>
                      <a:pt x="220" y="163"/>
                      <a:pt x="220" y="163"/>
                      <a:pt x="220" y="163"/>
                    </a:cubicBezTo>
                    <a:lnTo>
                      <a:pt x="227" y="144"/>
                    </a:lnTo>
                    <a:close/>
                    <a:moveTo>
                      <a:pt x="207" y="79"/>
                    </a:moveTo>
                    <a:cubicBezTo>
                      <a:pt x="207" y="79"/>
                      <a:pt x="207" y="79"/>
                      <a:pt x="207" y="78"/>
                    </a:cubicBezTo>
                    <a:cubicBezTo>
                      <a:pt x="208" y="76"/>
                      <a:pt x="210" y="75"/>
                      <a:pt x="211" y="73"/>
                    </a:cubicBezTo>
                    <a:cubicBezTo>
                      <a:pt x="214" y="70"/>
                      <a:pt x="209" y="89"/>
                      <a:pt x="205" y="108"/>
                    </a:cubicBezTo>
                    <a:lnTo>
                      <a:pt x="207" y="79"/>
                    </a:lnTo>
                    <a:close/>
                    <a:moveTo>
                      <a:pt x="51" y="116"/>
                    </a:moveTo>
                    <a:cubicBezTo>
                      <a:pt x="112" y="110"/>
                      <a:pt x="112" y="110"/>
                      <a:pt x="112" y="110"/>
                    </a:cubicBezTo>
                    <a:cubicBezTo>
                      <a:pt x="117" y="110"/>
                      <a:pt x="117" y="110"/>
                      <a:pt x="117" y="110"/>
                    </a:cubicBezTo>
                    <a:cubicBezTo>
                      <a:pt x="127" y="109"/>
                      <a:pt x="127" y="109"/>
                      <a:pt x="127" y="109"/>
                    </a:cubicBezTo>
                    <a:cubicBezTo>
                      <a:pt x="161" y="108"/>
                      <a:pt x="161" y="108"/>
                      <a:pt x="161" y="108"/>
                    </a:cubicBezTo>
                    <a:cubicBezTo>
                      <a:pt x="139" y="111"/>
                      <a:pt x="139" y="111"/>
                      <a:pt x="139" y="111"/>
                    </a:cubicBezTo>
                    <a:cubicBezTo>
                      <a:pt x="137" y="111"/>
                      <a:pt x="137" y="111"/>
                      <a:pt x="137" y="111"/>
                    </a:cubicBezTo>
                    <a:cubicBezTo>
                      <a:pt x="126" y="113"/>
                      <a:pt x="126" y="113"/>
                      <a:pt x="126" y="113"/>
                    </a:cubicBezTo>
                    <a:cubicBezTo>
                      <a:pt x="29" y="128"/>
                      <a:pt x="29" y="128"/>
                      <a:pt x="29" y="128"/>
                    </a:cubicBezTo>
                    <a:cubicBezTo>
                      <a:pt x="48" y="118"/>
                      <a:pt x="48" y="118"/>
                      <a:pt x="48" y="118"/>
                    </a:cubicBezTo>
                    <a:lnTo>
                      <a:pt x="51" y="116"/>
                    </a:lnTo>
                    <a:close/>
                    <a:moveTo>
                      <a:pt x="42" y="77"/>
                    </a:moveTo>
                    <a:cubicBezTo>
                      <a:pt x="42" y="77"/>
                      <a:pt x="42" y="77"/>
                      <a:pt x="42" y="77"/>
                    </a:cubicBezTo>
                    <a:cubicBezTo>
                      <a:pt x="42" y="83"/>
                      <a:pt x="42" y="83"/>
                      <a:pt x="42" y="83"/>
                    </a:cubicBezTo>
                    <a:cubicBezTo>
                      <a:pt x="41" y="79"/>
                      <a:pt x="40" y="75"/>
                      <a:pt x="39" y="74"/>
                    </a:cubicBezTo>
                    <a:cubicBezTo>
                      <a:pt x="40" y="75"/>
                      <a:pt x="41" y="76"/>
                      <a:pt x="42" y="77"/>
                    </a:cubicBezTo>
                    <a:close/>
                    <a:moveTo>
                      <a:pt x="126" y="138"/>
                    </a:moveTo>
                    <a:cubicBezTo>
                      <a:pt x="120" y="139"/>
                      <a:pt x="120" y="139"/>
                      <a:pt x="120" y="139"/>
                    </a:cubicBezTo>
                    <a:cubicBezTo>
                      <a:pt x="108" y="140"/>
                      <a:pt x="108" y="140"/>
                      <a:pt x="108" y="140"/>
                    </a:cubicBezTo>
                    <a:cubicBezTo>
                      <a:pt x="121" y="135"/>
                      <a:pt x="121" y="135"/>
                      <a:pt x="121" y="135"/>
                    </a:cubicBezTo>
                    <a:cubicBezTo>
                      <a:pt x="128" y="132"/>
                      <a:pt x="128" y="132"/>
                      <a:pt x="128" y="132"/>
                    </a:cubicBezTo>
                    <a:cubicBezTo>
                      <a:pt x="132" y="131"/>
                      <a:pt x="132" y="131"/>
                      <a:pt x="132" y="131"/>
                    </a:cubicBezTo>
                    <a:cubicBezTo>
                      <a:pt x="202" y="122"/>
                      <a:pt x="202" y="122"/>
                      <a:pt x="202" y="122"/>
                    </a:cubicBezTo>
                    <a:cubicBezTo>
                      <a:pt x="215" y="120"/>
                      <a:pt x="215" y="120"/>
                      <a:pt x="215" y="120"/>
                    </a:cubicBezTo>
                    <a:cubicBezTo>
                      <a:pt x="219" y="125"/>
                      <a:pt x="219" y="125"/>
                      <a:pt x="219" y="125"/>
                    </a:cubicBezTo>
                    <a:cubicBezTo>
                      <a:pt x="220" y="126"/>
                      <a:pt x="220" y="126"/>
                      <a:pt x="220" y="126"/>
                    </a:cubicBezTo>
                    <a:lnTo>
                      <a:pt x="126" y="138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FABB94D3-4F73-F0D7-A7AA-CB136C43C6E1}"/>
                </a:ext>
              </a:extLst>
            </p:cNvPr>
            <p:cNvGrpSpPr/>
            <p:nvPr/>
          </p:nvGrpSpPr>
          <p:grpSpPr>
            <a:xfrm>
              <a:off x="7425179" y="4672208"/>
              <a:ext cx="606425" cy="841375"/>
              <a:chOff x="4403726" y="1663700"/>
              <a:chExt cx="606425" cy="841375"/>
            </a:xfrm>
            <a:solidFill>
              <a:schemeClr val="accent5"/>
            </a:solidFill>
          </p:grpSpPr>
          <p:sp>
            <p:nvSpPr>
              <p:cNvPr id="24" name="Freeform 15">
                <a:extLst>
                  <a:ext uri="{FF2B5EF4-FFF2-40B4-BE49-F238E27FC236}">
                    <a16:creationId xmlns:a16="http://schemas.microsoft.com/office/drawing/2014/main" id="{E17485D4-8ADA-7727-353D-C44D2CC1A3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03726" y="2098675"/>
                <a:ext cx="606425" cy="406400"/>
              </a:xfrm>
              <a:custGeom>
                <a:avLst/>
                <a:gdLst>
                  <a:gd name="T0" fmla="*/ 1 w 348"/>
                  <a:gd name="T1" fmla="*/ 119 h 233"/>
                  <a:gd name="T2" fmla="*/ 1 w 348"/>
                  <a:gd name="T3" fmla="*/ 233 h 233"/>
                  <a:gd name="T4" fmla="*/ 47 w 348"/>
                  <a:gd name="T5" fmla="*/ 233 h 233"/>
                  <a:gd name="T6" fmla="*/ 47 w 348"/>
                  <a:gd name="T7" fmla="*/ 141 h 233"/>
                  <a:gd name="T8" fmla="*/ 52 w 348"/>
                  <a:gd name="T9" fmla="*/ 148 h 233"/>
                  <a:gd name="T10" fmla="*/ 52 w 348"/>
                  <a:gd name="T11" fmla="*/ 148 h 233"/>
                  <a:gd name="T12" fmla="*/ 70 w 348"/>
                  <a:gd name="T13" fmla="*/ 233 h 233"/>
                  <a:gd name="T14" fmla="*/ 279 w 348"/>
                  <a:gd name="T15" fmla="*/ 233 h 233"/>
                  <a:gd name="T16" fmla="*/ 290 w 348"/>
                  <a:gd name="T17" fmla="*/ 153 h 233"/>
                  <a:gd name="T18" fmla="*/ 291 w 348"/>
                  <a:gd name="T19" fmla="*/ 152 h 233"/>
                  <a:gd name="T20" fmla="*/ 297 w 348"/>
                  <a:gd name="T21" fmla="*/ 141 h 233"/>
                  <a:gd name="T22" fmla="*/ 300 w 348"/>
                  <a:gd name="T23" fmla="*/ 233 h 233"/>
                  <a:gd name="T24" fmla="*/ 345 w 348"/>
                  <a:gd name="T25" fmla="*/ 233 h 233"/>
                  <a:gd name="T26" fmla="*/ 340 w 348"/>
                  <a:gd name="T27" fmla="*/ 82 h 233"/>
                  <a:gd name="T28" fmla="*/ 233 w 348"/>
                  <a:gd name="T29" fmla="*/ 10 h 233"/>
                  <a:gd name="T30" fmla="*/ 225 w 348"/>
                  <a:gd name="T31" fmla="*/ 15 h 233"/>
                  <a:gd name="T32" fmla="*/ 198 w 348"/>
                  <a:gd name="T33" fmla="*/ 177 h 233"/>
                  <a:gd name="T34" fmla="*/ 188 w 348"/>
                  <a:gd name="T35" fmla="*/ 57 h 233"/>
                  <a:gd name="T36" fmla="*/ 191 w 348"/>
                  <a:gd name="T37" fmla="*/ 44 h 233"/>
                  <a:gd name="T38" fmla="*/ 185 w 348"/>
                  <a:gd name="T39" fmla="*/ 29 h 233"/>
                  <a:gd name="T40" fmla="*/ 170 w 348"/>
                  <a:gd name="T41" fmla="*/ 29 h 233"/>
                  <a:gd name="T42" fmla="*/ 164 w 348"/>
                  <a:gd name="T43" fmla="*/ 44 h 233"/>
                  <a:gd name="T44" fmla="*/ 167 w 348"/>
                  <a:gd name="T45" fmla="*/ 55 h 233"/>
                  <a:gd name="T46" fmla="*/ 156 w 348"/>
                  <a:gd name="T47" fmla="*/ 168 h 233"/>
                  <a:gd name="T48" fmla="*/ 155 w 348"/>
                  <a:gd name="T49" fmla="*/ 175 h 233"/>
                  <a:gd name="T50" fmla="*/ 122 w 348"/>
                  <a:gd name="T51" fmla="*/ 10 h 233"/>
                  <a:gd name="T52" fmla="*/ 117 w 348"/>
                  <a:gd name="T53" fmla="*/ 10 h 233"/>
                  <a:gd name="T54" fmla="*/ 1 w 348"/>
                  <a:gd name="T55" fmla="*/ 119 h 2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348" h="233">
                    <a:moveTo>
                      <a:pt x="1" y="119"/>
                    </a:moveTo>
                    <a:cubicBezTo>
                      <a:pt x="0" y="129"/>
                      <a:pt x="0" y="178"/>
                      <a:pt x="1" y="233"/>
                    </a:cubicBezTo>
                    <a:cubicBezTo>
                      <a:pt x="47" y="233"/>
                      <a:pt x="47" y="233"/>
                      <a:pt x="47" y="233"/>
                    </a:cubicBezTo>
                    <a:cubicBezTo>
                      <a:pt x="46" y="181"/>
                      <a:pt x="45" y="139"/>
                      <a:pt x="47" y="141"/>
                    </a:cubicBezTo>
                    <a:cubicBezTo>
                      <a:pt x="49" y="144"/>
                      <a:pt x="51" y="146"/>
                      <a:pt x="52" y="148"/>
                    </a:cubicBezTo>
                    <a:cubicBezTo>
                      <a:pt x="52" y="148"/>
                      <a:pt x="52" y="148"/>
                      <a:pt x="52" y="148"/>
                    </a:cubicBezTo>
                    <a:cubicBezTo>
                      <a:pt x="70" y="233"/>
                      <a:pt x="70" y="233"/>
                      <a:pt x="70" y="233"/>
                    </a:cubicBezTo>
                    <a:cubicBezTo>
                      <a:pt x="279" y="233"/>
                      <a:pt x="279" y="233"/>
                      <a:pt x="279" y="233"/>
                    </a:cubicBezTo>
                    <a:cubicBezTo>
                      <a:pt x="290" y="153"/>
                      <a:pt x="290" y="153"/>
                      <a:pt x="290" y="153"/>
                    </a:cubicBezTo>
                    <a:cubicBezTo>
                      <a:pt x="290" y="153"/>
                      <a:pt x="291" y="152"/>
                      <a:pt x="291" y="152"/>
                    </a:cubicBezTo>
                    <a:cubicBezTo>
                      <a:pt x="293" y="148"/>
                      <a:pt x="295" y="144"/>
                      <a:pt x="297" y="141"/>
                    </a:cubicBezTo>
                    <a:cubicBezTo>
                      <a:pt x="299" y="137"/>
                      <a:pt x="300" y="181"/>
                      <a:pt x="300" y="233"/>
                    </a:cubicBezTo>
                    <a:cubicBezTo>
                      <a:pt x="345" y="233"/>
                      <a:pt x="345" y="233"/>
                      <a:pt x="345" y="233"/>
                    </a:cubicBezTo>
                    <a:cubicBezTo>
                      <a:pt x="348" y="167"/>
                      <a:pt x="347" y="102"/>
                      <a:pt x="340" y="82"/>
                    </a:cubicBezTo>
                    <a:cubicBezTo>
                      <a:pt x="336" y="68"/>
                      <a:pt x="286" y="0"/>
                      <a:pt x="233" y="10"/>
                    </a:cubicBezTo>
                    <a:cubicBezTo>
                      <a:pt x="233" y="10"/>
                      <a:pt x="230" y="12"/>
                      <a:pt x="225" y="15"/>
                    </a:cubicBezTo>
                    <a:cubicBezTo>
                      <a:pt x="198" y="177"/>
                      <a:pt x="198" y="177"/>
                      <a:pt x="198" y="177"/>
                    </a:cubicBezTo>
                    <a:cubicBezTo>
                      <a:pt x="188" y="57"/>
                      <a:pt x="188" y="57"/>
                      <a:pt x="188" y="57"/>
                    </a:cubicBezTo>
                    <a:cubicBezTo>
                      <a:pt x="191" y="44"/>
                      <a:pt x="191" y="44"/>
                      <a:pt x="191" y="44"/>
                    </a:cubicBezTo>
                    <a:cubicBezTo>
                      <a:pt x="185" y="29"/>
                      <a:pt x="185" y="29"/>
                      <a:pt x="185" y="29"/>
                    </a:cubicBezTo>
                    <a:cubicBezTo>
                      <a:pt x="170" y="29"/>
                      <a:pt x="170" y="29"/>
                      <a:pt x="170" y="29"/>
                    </a:cubicBezTo>
                    <a:cubicBezTo>
                      <a:pt x="164" y="44"/>
                      <a:pt x="164" y="44"/>
                      <a:pt x="164" y="44"/>
                    </a:cubicBezTo>
                    <a:cubicBezTo>
                      <a:pt x="167" y="55"/>
                      <a:pt x="167" y="55"/>
                      <a:pt x="167" y="55"/>
                    </a:cubicBezTo>
                    <a:cubicBezTo>
                      <a:pt x="156" y="168"/>
                      <a:pt x="156" y="168"/>
                      <a:pt x="156" y="168"/>
                    </a:cubicBezTo>
                    <a:cubicBezTo>
                      <a:pt x="155" y="175"/>
                      <a:pt x="155" y="175"/>
                      <a:pt x="155" y="175"/>
                    </a:cubicBezTo>
                    <a:cubicBezTo>
                      <a:pt x="122" y="10"/>
                      <a:pt x="122" y="10"/>
                      <a:pt x="122" y="10"/>
                    </a:cubicBezTo>
                    <a:cubicBezTo>
                      <a:pt x="120" y="10"/>
                      <a:pt x="119" y="10"/>
                      <a:pt x="117" y="10"/>
                    </a:cubicBezTo>
                    <a:cubicBezTo>
                      <a:pt x="63" y="20"/>
                      <a:pt x="4" y="54"/>
                      <a:pt x="1" y="119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Freeform 16">
                <a:extLst>
                  <a:ext uri="{FF2B5EF4-FFF2-40B4-BE49-F238E27FC236}">
                    <a16:creationId xmlns:a16="http://schemas.microsoft.com/office/drawing/2014/main" id="{6A502210-6755-3451-B40D-477B81BA7F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73576" y="1663700"/>
                <a:ext cx="485775" cy="477838"/>
              </a:xfrm>
              <a:custGeom>
                <a:avLst/>
                <a:gdLst>
                  <a:gd name="T0" fmla="*/ 0 w 279"/>
                  <a:gd name="T1" fmla="*/ 237 h 274"/>
                  <a:gd name="T2" fmla="*/ 52 w 279"/>
                  <a:gd name="T3" fmla="*/ 255 h 274"/>
                  <a:gd name="T4" fmla="*/ 80 w 279"/>
                  <a:gd name="T5" fmla="*/ 244 h 274"/>
                  <a:gd name="T6" fmla="*/ 70 w 279"/>
                  <a:gd name="T7" fmla="*/ 170 h 274"/>
                  <a:gd name="T8" fmla="*/ 136 w 279"/>
                  <a:gd name="T9" fmla="*/ 253 h 274"/>
                  <a:gd name="T10" fmla="*/ 204 w 279"/>
                  <a:gd name="T11" fmla="*/ 160 h 274"/>
                  <a:gd name="T12" fmla="*/ 198 w 279"/>
                  <a:gd name="T13" fmla="*/ 244 h 274"/>
                  <a:gd name="T14" fmla="*/ 226 w 279"/>
                  <a:gd name="T15" fmla="*/ 255 h 274"/>
                  <a:gd name="T16" fmla="*/ 279 w 279"/>
                  <a:gd name="T17" fmla="*/ 237 h 274"/>
                  <a:gd name="T18" fmla="*/ 246 w 279"/>
                  <a:gd name="T19" fmla="*/ 178 h 274"/>
                  <a:gd name="T20" fmla="*/ 229 w 279"/>
                  <a:gd name="T21" fmla="*/ 62 h 274"/>
                  <a:gd name="T22" fmla="*/ 137 w 279"/>
                  <a:gd name="T23" fmla="*/ 13 h 274"/>
                  <a:gd name="T24" fmla="*/ 135 w 279"/>
                  <a:gd name="T25" fmla="*/ 13 h 274"/>
                  <a:gd name="T26" fmla="*/ 154 w 279"/>
                  <a:gd name="T27" fmla="*/ 5 h 274"/>
                  <a:gd name="T28" fmla="*/ 63 w 279"/>
                  <a:gd name="T29" fmla="*/ 41 h 274"/>
                  <a:gd name="T30" fmla="*/ 58 w 279"/>
                  <a:gd name="T31" fmla="*/ 44 h 274"/>
                  <a:gd name="T32" fmla="*/ 60 w 279"/>
                  <a:gd name="T33" fmla="*/ 44 h 274"/>
                  <a:gd name="T34" fmla="*/ 49 w 279"/>
                  <a:gd name="T35" fmla="*/ 62 h 274"/>
                  <a:gd name="T36" fmla="*/ 41 w 279"/>
                  <a:gd name="T37" fmla="*/ 182 h 274"/>
                  <a:gd name="T38" fmla="*/ 0 w 279"/>
                  <a:gd name="T39" fmla="*/ 237 h 2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279" h="274">
                    <a:moveTo>
                      <a:pt x="0" y="237"/>
                    </a:moveTo>
                    <a:cubicBezTo>
                      <a:pt x="0" y="237"/>
                      <a:pt x="8" y="274"/>
                      <a:pt x="52" y="255"/>
                    </a:cubicBezTo>
                    <a:cubicBezTo>
                      <a:pt x="74" y="246"/>
                      <a:pt x="80" y="244"/>
                      <a:pt x="80" y="244"/>
                    </a:cubicBezTo>
                    <a:cubicBezTo>
                      <a:pt x="80" y="244"/>
                      <a:pt x="72" y="211"/>
                      <a:pt x="70" y="170"/>
                    </a:cubicBezTo>
                    <a:cubicBezTo>
                      <a:pt x="82" y="215"/>
                      <a:pt x="105" y="252"/>
                      <a:pt x="136" y="253"/>
                    </a:cubicBezTo>
                    <a:cubicBezTo>
                      <a:pt x="172" y="255"/>
                      <a:pt x="197" y="213"/>
                      <a:pt x="204" y="160"/>
                    </a:cubicBezTo>
                    <a:cubicBezTo>
                      <a:pt x="207" y="206"/>
                      <a:pt x="198" y="244"/>
                      <a:pt x="198" y="244"/>
                    </a:cubicBezTo>
                    <a:cubicBezTo>
                      <a:pt x="198" y="244"/>
                      <a:pt x="204" y="246"/>
                      <a:pt x="226" y="255"/>
                    </a:cubicBezTo>
                    <a:cubicBezTo>
                      <a:pt x="270" y="274"/>
                      <a:pt x="279" y="237"/>
                      <a:pt x="279" y="237"/>
                    </a:cubicBezTo>
                    <a:cubicBezTo>
                      <a:pt x="279" y="237"/>
                      <a:pt x="233" y="247"/>
                      <a:pt x="246" y="178"/>
                    </a:cubicBezTo>
                    <a:cubicBezTo>
                      <a:pt x="251" y="146"/>
                      <a:pt x="252" y="114"/>
                      <a:pt x="229" y="62"/>
                    </a:cubicBezTo>
                    <a:cubicBezTo>
                      <a:pt x="208" y="16"/>
                      <a:pt x="164" y="11"/>
                      <a:pt x="137" y="13"/>
                    </a:cubicBezTo>
                    <a:cubicBezTo>
                      <a:pt x="137" y="13"/>
                      <a:pt x="136" y="13"/>
                      <a:pt x="135" y="13"/>
                    </a:cubicBezTo>
                    <a:cubicBezTo>
                      <a:pt x="141" y="10"/>
                      <a:pt x="147" y="7"/>
                      <a:pt x="154" y="5"/>
                    </a:cubicBezTo>
                    <a:cubicBezTo>
                      <a:pt x="154" y="5"/>
                      <a:pt x="97" y="0"/>
                      <a:pt x="63" y="41"/>
                    </a:cubicBezTo>
                    <a:cubicBezTo>
                      <a:pt x="61" y="42"/>
                      <a:pt x="59" y="43"/>
                      <a:pt x="58" y="44"/>
                    </a:cubicBezTo>
                    <a:cubicBezTo>
                      <a:pt x="58" y="44"/>
                      <a:pt x="59" y="44"/>
                      <a:pt x="60" y="44"/>
                    </a:cubicBezTo>
                    <a:cubicBezTo>
                      <a:pt x="56" y="49"/>
                      <a:pt x="52" y="55"/>
                      <a:pt x="49" y="62"/>
                    </a:cubicBezTo>
                    <a:cubicBezTo>
                      <a:pt x="25" y="114"/>
                      <a:pt x="35" y="149"/>
                      <a:pt x="41" y="182"/>
                    </a:cubicBezTo>
                    <a:cubicBezTo>
                      <a:pt x="53" y="251"/>
                      <a:pt x="0" y="237"/>
                      <a:pt x="0" y="23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6" name="箭头: 左右 25">
              <a:extLst>
                <a:ext uri="{FF2B5EF4-FFF2-40B4-BE49-F238E27FC236}">
                  <a16:creationId xmlns:a16="http://schemas.microsoft.com/office/drawing/2014/main" id="{B318DE96-7653-8441-60D4-AC4D7FBF38DF}"/>
                </a:ext>
              </a:extLst>
            </p:cNvPr>
            <p:cNvSpPr/>
            <p:nvPr/>
          </p:nvSpPr>
          <p:spPr>
            <a:xfrm rot="16200000">
              <a:off x="7375794" y="2000471"/>
              <a:ext cx="571755" cy="223746"/>
            </a:xfrm>
            <a:prstGeom prst="leftRightArrow">
              <a:avLst/>
            </a:prstGeom>
            <a:solidFill>
              <a:schemeClr val="tx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箭头: 左右 26">
              <a:extLst>
                <a:ext uri="{FF2B5EF4-FFF2-40B4-BE49-F238E27FC236}">
                  <a16:creationId xmlns:a16="http://schemas.microsoft.com/office/drawing/2014/main" id="{E68DB33B-E711-6B69-7635-30D7B95D0472}"/>
                </a:ext>
              </a:extLst>
            </p:cNvPr>
            <p:cNvSpPr/>
            <p:nvPr/>
          </p:nvSpPr>
          <p:spPr>
            <a:xfrm rot="16200000">
              <a:off x="7437706" y="4050385"/>
              <a:ext cx="571755" cy="223746"/>
            </a:xfrm>
            <a:prstGeom prst="leftRightArrow">
              <a:avLst/>
            </a:prstGeom>
            <a:solidFill>
              <a:schemeClr val="tx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6FFBF523-00D6-2456-3CEF-6197CC93C6AD}"/>
                </a:ext>
              </a:extLst>
            </p:cNvPr>
            <p:cNvGrpSpPr/>
            <p:nvPr/>
          </p:nvGrpSpPr>
          <p:grpSpPr>
            <a:xfrm>
              <a:off x="5119210" y="2603125"/>
              <a:ext cx="1249363" cy="1174750"/>
              <a:chOff x="4189413" y="2940050"/>
              <a:chExt cx="1249363" cy="1174750"/>
            </a:xfrm>
            <a:solidFill>
              <a:schemeClr val="accent2">
                <a:lumMod val="75000"/>
              </a:schemeClr>
            </a:solidFill>
          </p:grpSpPr>
          <p:sp>
            <p:nvSpPr>
              <p:cNvPr id="29" name="Freeform 7">
                <a:extLst>
                  <a:ext uri="{FF2B5EF4-FFF2-40B4-BE49-F238E27FC236}">
                    <a16:creationId xmlns:a16="http://schemas.microsoft.com/office/drawing/2014/main" id="{68151177-7287-67F2-56D8-538598A3546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89413" y="4114800"/>
                <a:ext cx="38100" cy="0"/>
              </a:xfrm>
              <a:custGeom>
                <a:avLst/>
                <a:gdLst>
                  <a:gd name="T0" fmla="*/ 24 w 24"/>
                  <a:gd name="T1" fmla="*/ 0 w 24"/>
                  <a:gd name="T2" fmla="*/ 24 w 24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24">
                    <a:moveTo>
                      <a:pt x="24" y="0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grpFill/>
              <a:ln w="6350" cap="flat">
                <a:solidFill>
                  <a:srgbClr val="D9D9D9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Freeform 136">
                <a:extLst>
                  <a:ext uri="{FF2B5EF4-FFF2-40B4-BE49-F238E27FC236}">
                    <a16:creationId xmlns:a16="http://schemas.microsoft.com/office/drawing/2014/main" id="{C9115075-277A-39F5-17AB-740BBB858B7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816476" y="2940050"/>
                <a:ext cx="174625" cy="238125"/>
              </a:xfrm>
              <a:custGeom>
                <a:avLst/>
                <a:gdLst>
                  <a:gd name="T0" fmla="*/ 4 w 100"/>
                  <a:gd name="T1" fmla="*/ 64 h 137"/>
                  <a:gd name="T2" fmla="*/ 0 w 100"/>
                  <a:gd name="T3" fmla="*/ 80 h 137"/>
                  <a:gd name="T4" fmla="*/ 4 w 100"/>
                  <a:gd name="T5" fmla="*/ 95 h 137"/>
                  <a:gd name="T6" fmla="*/ 7 w 100"/>
                  <a:gd name="T7" fmla="*/ 92 h 137"/>
                  <a:gd name="T8" fmla="*/ 51 w 100"/>
                  <a:gd name="T9" fmla="*/ 137 h 137"/>
                  <a:gd name="T10" fmla="*/ 93 w 100"/>
                  <a:gd name="T11" fmla="*/ 90 h 137"/>
                  <a:gd name="T12" fmla="*/ 96 w 100"/>
                  <a:gd name="T13" fmla="*/ 95 h 137"/>
                  <a:gd name="T14" fmla="*/ 100 w 100"/>
                  <a:gd name="T15" fmla="*/ 79 h 137"/>
                  <a:gd name="T16" fmla="*/ 96 w 100"/>
                  <a:gd name="T17" fmla="*/ 64 h 137"/>
                  <a:gd name="T18" fmla="*/ 95 w 100"/>
                  <a:gd name="T19" fmla="*/ 64 h 137"/>
                  <a:gd name="T20" fmla="*/ 95 w 100"/>
                  <a:gd name="T21" fmla="*/ 51 h 137"/>
                  <a:gd name="T22" fmla="*/ 58 w 100"/>
                  <a:gd name="T23" fmla="*/ 42 h 137"/>
                  <a:gd name="T24" fmla="*/ 63 w 100"/>
                  <a:gd name="T25" fmla="*/ 45 h 137"/>
                  <a:gd name="T26" fmla="*/ 99 w 100"/>
                  <a:gd name="T27" fmla="*/ 33 h 137"/>
                  <a:gd name="T28" fmla="*/ 18 w 100"/>
                  <a:gd name="T29" fmla="*/ 25 h 137"/>
                  <a:gd name="T30" fmla="*/ 2 w 100"/>
                  <a:gd name="T31" fmla="*/ 35 h 137"/>
                  <a:gd name="T32" fmla="*/ 13 w 100"/>
                  <a:gd name="T33" fmla="*/ 35 h 137"/>
                  <a:gd name="T34" fmla="*/ 6 w 100"/>
                  <a:gd name="T35" fmla="*/ 57 h 137"/>
                  <a:gd name="T36" fmla="*/ 5 w 100"/>
                  <a:gd name="T37" fmla="*/ 65 h 137"/>
                  <a:gd name="T38" fmla="*/ 4 w 100"/>
                  <a:gd name="T39" fmla="*/ 64 h 1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100" h="137">
                    <a:moveTo>
                      <a:pt x="4" y="64"/>
                    </a:moveTo>
                    <a:cubicBezTo>
                      <a:pt x="2" y="64"/>
                      <a:pt x="0" y="71"/>
                      <a:pt x="0" y="80"/>
                    </a:cubicBezTo>
                    <a:cubicBezTo>
                      <a:pt x="0" y="88"/>
                      <a:pt x="2" y="95"/>
                      <a:pt x="4" y="95"/>
                    </a:cubicBezTo>
                    <a:cubicBezTo>
                      <a:pt x="5" y="95"/>
                      <a:pt x="6" y="94"/>
                      <a:pt x="7" y="92"/>
                    </a:cubicBezTo>
                    <a:cubicBezTo>
                      <a:pt x="14" y="118"/>
                      <a:pt x="38" y="137"/>
                      <a:pt x="51" y="137"/>
                    </a:cubicBezTo>
                    <a:cubicBezTo>
                      <a:pt x="67" y="137"/>
                      <a:pt x="90" y="119"/>
                      <a:pt x="93" y="90"/>
                    </a:cubicBezTo>
                    <a:cubicBezTo>
                      <a:pt x="94" y="93"/>
                      <a:pt x="95" y="95"/>
                      <a:pt x="96" y="95"/>
                    </a:cubicBezTo>
                    <a:cubicBezTo>
                      <a:pt x="98" y="95"/>
                      <a:pt x="100" y="88"/>
                      <a:pt x="100" y="79"/>
                    </a:cubicBezTo>
                    <a:cubicBezTo>
                      <a:pt x="100" y="71"/>
                      <a:pt x="98" y="64"/>
                      <a:pt x="96" y="64"/>
                    </a:cubicBezTo>
                    <a:cubicBezTo>
                      <a:pt x="96" y="64"/>
                      <a:pt x="95" y="64"/>
                      <a:pt x="95" y="64"/>
                    </a:cubicBezTo>
                    <a:cubicBezTo>
                      <a:pt x="95" y="60"/>
                      <a:pt x="95" y="56"/>
                      <a:pt x="95" y="51"/>
                    </a:cubicBezTo>
                    <a:cubicBezTo>
                      <a:pt x="87" y="57"/>
                      <a:pt x="73" y="49"/>
                      <a:pt x="58" y="42"/>
                    </a:cubicBezTo>
                    <a:cubicBezTo>
                      <a:pt x="60" y="43"/>
                      <a:pt x="62" y="44"/>
                      <a:pt x="63" y="45"/>
                    </a:cubicBezTo>
                    <a:cubicBezTo>
                      <a:pt x="89" y="57"/>
                      <a:pt x="99" y="33"/>
                      <a:pt x="99" y="33"/>
                    </a:cubicBezTo>
                    <a:cubicBezTo>
                      <a:pt x="99" y="33"/>
                      <a:pt x="68" y="0"/>
                      <a:pt x="18" y="25"/>
                    </a:cubicBezTo>
                    <a:cubicBezTo>
                      <a:pt x="13" y="27"/>
                      <a:pt x="7" y="33"/>
                      <a:pt x="2" y="35"/>
                    </a:cubicBezTo>
                    <a:cubicBezTo>
                      <a:pt x="2" y="35"/>
                      <a:pt x="6" y="35"/>
                      <a:pt x="13" y="35"/>
                    </a:cubicBezTo>
                    <a:cubicBezTo>
                      <a:pt x="7" y="38"/>
                      <a:pt x="4" y="45"/>
                      <a:pt x="6" y="57"/>
                    </a:cubicBezTo>
                    <a:cubicBezTo>
                      <a:pt x="5" y="59"/>
                      <a:pt x="5" y="62"/>
                      <a:pt x="5" y="65"/>
                    </a:cubicBezTo>
                    <a:cubicBezTo>
                      <a:pt x="5" y="65"/>
                      <a:pt x="5" y="64"/>
                      <a:pt x="4" y="6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Freeform 137">
                <a:extLst>
                  <a:ext uri="{FF2B5EF4-FFF2-40B4-BE49-F238E27FC236}">
                    <a16:creationId xmlns:a16="http://schemas.microsoft.com/office/drawing/2014/main" id="{ECC5E3CB-C494-F384-9DC0-BFB2016815F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705351" y="3170238"/>
                <a:ext cx="400050" cy="328613"/>
              </a:xfrm>
              <a:custGeom>
                <a:avLst/>
                <a:gdLst>
                  <a:gd name="T0" fmla="*/ 203 w 229"/>
                  <a:gd name="T1" fmla="*/ 123 h 188"/>
                  <a:gd name="T2" fmla="*/ 225 w 229"/>
                  <a:gd name="T3" fmla="*/ 39 h 188"/>
                  <a:gd name="T4" fmla="*/ 150 w 229"/>
                  <a:gd name="T5" fmla="*/ 4 h 188"/>
                  <a:gd name="T6" fmla="*/ 145 w 229"/>
                  <a:gd name="T7" fmla="*/ 6 h 188"/>
                  <a:gd name="T8" fmla="*/ 128 w 229"/>
                  <a:gd name="T9" fmla="*/ 78 h 188"/>
                  <a:gd name="T10" fmla="*/ 122 w 229"/>
                  <a:gd name="T11" fmla="*/ 25 h 188"/>
                  <a:gd name="T12" fmla="*/ 124 w 229"/>
                  <a:gd name="T13" fmla="*/ 19 h 188"/>
                  <a:gd name="T14" fmla="*/ 120 w 229"/>
                  <a:gd name="T15" fmla="*/ 12 h 188"/>
                  <a:gd name="T16" fmla="*/ 111 w 229"/>
                  <a:gd name="T17" fmla="*/ 12 h 188"/>
                  <a:gd name="T18" fmla="*/ 107 w 229"/>
                  <a:gd name="T19" fmla="*/ 19 h 188"/>
                  <a:gd name="T20" fmla="*/ 109 w 229"/>
                  <a:gd name="T21" fmla="*/ 24 h 188"/>
                  <a:gd name="T22" fmla="*/ 102 w 229"/>
                  <a:gd name="T23" fmla="*/ 74 h 188"/>
                  <a:gd name="T24" fmla="*/ 102 w 229"/>
                  <a:gd name="T25" fmla="*/ 77 h 188"/>
                  <a:gd name="T26" fmla="*/ 81 w 229"/>
                  <a:gd name="T27" fmla="*/ 4 h 188"/>
                  <a:gd name="T28" fmla="*/ 78 w 229"/>
                  <a:gd name="T29" fmla="*/ 4 h 188"/>
                  <a:gd name="T30" fmla="*/ 2 w 229"/>
                  <a:gd name="T31" fmla="*/ 42 h 188"/>
                  <a:gd name="T32" fmla="*/ 16 w 229"/>
                  <a:gd name="T33" fmla="*/ 139 h 188"/>
                  <a:gd name="T34" fmla="*/ 43 w 229"/>
                  <a:gd name="T35" fmla="*/ 137 h 188"/>
                  <a:gd name="T36" fmla="*/ 48 w 229"/>
                  <a:gd name="T37" fmla="*/ 188 h 188"/>
                  <a:gd name="T38" fmla="*/ 176 w 229"/>
                  <a:gd name="T39" fmla="*/ 188 h 188"/>
                  <a:gd name="T40" fmla="*/ 180 w 229"/>
                  <a:gd name="T41" fmla="*/ 148 h 188"/>
                  <a:gd name="T42" fmla="*/ 181 w 229"/>
                  <a:gd name="T43" fmla="*/ 135 h 188"/>
                  <a:gd name="T44" fmla="*/ 198 w 229"/>
                  <a:gd name="T45" fmla="*/ 139 h 188"/>
                  <a:gd name="T46" fmla="*/ 203 w 229"/>
                  <a:gd name="T47" fmla="*/ 123 h 188"/>
                  <a:gd name="T48" fmla="*/ 182 w 229"/>
                  <a:gd name="T49" fmla="*/ 61 h 188"/>
                  <a:gd name="T50" fmla="*/ 184 w 229"/>
                  <a:gd name="T51" fmla="*/ 63 h 188"/>
                  <a:gd name="T52" fmla="*/ 182 w 229"/>
                  <a:gd name="T53" fmla="*/ 61 h 188"/>
                  <a:gd name="T54" fmla="*/ 46 w 229"/>
                  <a:gd name="T55" fmla="*/ 98 h 188"/>
                  <a:gd name="T56" fmla="*/ 100 w 229"/>
                  <a:gd name="T57" fmla="*/ 94 h 188"/>
                  <a:gd name="T58" fmla="*/ 105 w 229"/>
                  <a:gd name="T59" fmla="*/ 93 h 188"/>
                  <a:gd name="T60" fmla="*/ 114 w 229"/>
                  <a:gd name="T61" fmla="*/ 93 h 188"/>
                  <a:gd name="T62" fmla="*/ 145 w 229"/>
                  <a:gd name="T63" fmla="*/ 92 h 188"/>
                  <a:gd name="T64" fmla="*/ 125 w 229"/>
                  <a:gd name="T65" fmla="*/ 94 h 188"/>
                  <a:gd name="T66" fmla="*/ 123 w 229"/>
                  <a:gd name="T67" fmla="*/ 95 h 188"/>
                  <a:gd name="T68" fmla="*/ 113 w 229"/>
                  <a:gd name="T69" fmla="*/ 96 h 188"/>
                  <a:gd name="T70" fmla="*/ 27 w 229"/>
                  <a:gd name="T71" fmla="*/ 109 h 188"/>
                  <a:gd name="T72" fmla="*/ 43 w 229"/>
                  <a:gd name="T73" fmla="*/ 100 h 188"/>
                  <a:gd name="T74" fmla="*/ 46 w 229"/>
                  <a:gd name="T75" fmla="*/ 98 h 188"/>
                  <a:gd name="T76" fmla="*/ 113 w 229"/>
                  <a:gd name="T77" fmla="*/ 118 h 188"/>
                  <a:gd name="T78" fmla="*/ 108 w 229"/>
                  <a:gd name="T79" fmla="*/ 118 h 188"/>
                  <a:gd name="T80" fmla="*/ 98 w 229"/>
                  <a:gd name="T81" fmla="*/ 119 h 188"/>
                  <a:gd name="T82" fmla="*/ 109 w 229"/>
                  <a:gd name="T83" fmla="*/ 115 h 188"/>
                  <a:gd name="T84" fmla="*/ 115 w 229"/>
                  <a:gd name="T85" fmla="*/ 113 h 188"/>
                  <a:gd name="T86" fmla="*/ 118 w 229"/>
                  <a:gd name="T87" fmla="*/ 111 h 188"/>
                  <a:gd name="T88" fmla="*/ 182 w 229"/>
                  <a:gd name="T89" fmla="*/ 104 h 188"/>
                  <a:gd name="T90" fmla="*/ 193 w 229"/>
                  <a:gd name="T91" fmla="*/ 102 h 188"/>
                  <a:gd name="T92" fmla="*/ 197 w 229"/>
                  <a:gd name="T93" fmla="*/ 106 h 188"/>
                  <a:gd name="T94" fmla="*/ 198 w 229"/>
                  <a:gd name="T95" fmla="*/ 107 h 188"/>
                  <a:gd name="T96" fmla="*/ 113 w 229"/>
                  <a:gd name="T97" fmla="*/ 118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</a:cxnLst>
                <a:rect l="0" t="0" r="r" b="b"/>
                <a:pathLst>
                  <a:path w="229" h="188">
                    <a:moveTo>
                      <a:pt x="203" y="123"/>
                    </a:moveTo>
                    <a:cubicBezTo>
                      <a:pt x="215" y="92"/>
                      <a:pt x="229" y="58"/>
                      <a:pt x="225" y="39"/>
                    </a:cubicBezTo>
                    <a:cubicBezTo>
                      <a:pt x="225" y="26"/>
                      <a:pt x="183" y="0"/>
                      <a:pt x="150" y="4"/>
                    </a:cubicBezTo>
                    <a:cubicBezTo>
                      <a:pt x="150" y="4"/>
                      <a:pt x="148" y="5"/>
                      <a:pt x="145" y="6"/>
                    </a:cubicBezTo>
                    <a:cubicBezTo>
                      <a:pt x="128" y="78"/>
                      <a:pt x="128" y="78"/>
                      <a:pt x="128" y="78"/>
                    </a:cubicBezTo>
                    <a:cubicBezTo>
                      <a:pt x="122" y="25"/>
                      <a:pt x="122" y="25"/>
                      <a:pt x="122" y="25"/>
                    </a:cubicBezTo>
                    <a:cubicBezTo>
                      <a:pt x="124" y="19"/>
                      <a:pt x="124" y="19"/>
                      <a:pt x="124" y="19"/>
                    </a:cubicBezTo>
                    <a:cubicBezTo>
                      <a:pt x="120" y="12"/>
                      <a:pt x="120" y="12"/>
                      <a:pt x="120" y="12"/>
                    </a:cubicBezTo>
                    <a:cubicBezTo>
                      <a:pt x="111" y="12"/>
                      <a:pt x="111" y="12"/>
                      <a:pt x="111" y="12"/>
                    </a:cubicBezTo>
                    <a:cubicBezTo>
                      <a:pt x="107" y="19"/>
                      <a:pt x="107" y="19"/>
                      <a:pt x="107" y="19"/>
                    </a:cubicBezTo>
                    <a:cubicBezTo>
                      <a:pt x="109" y="24"/>
                      <a:pt x="109" y="24"/>
                      <a:pt x="109" y="24"/>
                    </a:cubicBezTo>
                    <a:cubicBezTo>
                      <a:pt x="102" y="74"/>
                      <a:pt x="102" y="74"/>
                      <a:pt x="102" y="74"/>
                    </a:cubicBezTo>
                    <a:cubicBezTo>
                      <a:pt x="102" y="77"/>
                      <a:pt x="102" y="77"/>
                      <a:pt x="102" y="77"/>
                    </a:cubicBezTo>
                    <a:cubicBezTo>
                      <a:pt x="81" y="4"/>
                      <a:pt x="81" y="4"/>
                      <a:pt x="81" y="4"/>
                    </a:cubicBezTo>
                    <a:cubicBezTo>
                      <a:pt x="80" y="4"/>
                      <a:pt x="79" y="4"/>
                      <a:pt x="78" y="4"/>
                    </a:cubicBezTo>
                    <a:cubicBezTo>
                      <a:pt x="45" y="8"/>
                      <a:pt x="4" y="20"/>
                      <a:pt x="2" y="42"/>
                    </a:cubicBezTo>
                    <a:cubicBezTo>
                      <a:pt x="0" y="52"/>
                      <a:pt x="11" y="115"/>
                      <a:pt x="16" y="139"/>
                    </a:cubicBezTo>
                    <a:cubicBezTo>
                      <a:pt x="22" y="142"/>
                      <a:pt x="34" y="140"/>
                      <a:pt x="43" y="137"/>
                    </a:cubicBezTo>
                    <a:cubicBezTo>
                      <a:pt x="46" y="163"/>
                      <a:pt x="48" y="183"/>
                      <a:pt x="48" y="188"/>
                    </a:cubicBezTo>
                    <a:cubicBezTo>
                      <a:pt x="176" y="188"/>
                      <a:pt x="176" y="188"/>
                      <a:pt x="176" y="188"/>
                    </a:cubicBezTo>
                    <a:cubicBezTo>
                      <a:pt x="176" y="184"/>
                      <a:pt x="178" y="169"/>
                      <a:pt x="180" y="148"/>
                    </a:cubicBezTo>
                    <a:cubicBezTo>
                      <a:pt x="181" y="135"/>
                      <a:pt x="181" y="135"/>
                      <a:pt x="181" y="135"/>
                    </a:cubicBezTo>
                    <a:cubicBezTo>
                      <a:pt x="198" y="139"/>
                      <a:pt x="198" y="139"/>
                      <a:pt x="198" y="139"/>
                    </a:cubicBezTo>
                    <a:lnTo>
                      <a:pt x="203" y="123"/>
                    </a:lnTo>
                    <a:close/>
                    <a:moveTo>
                      <a:pt x="182" y="61"/>
                    </a:moveTo>
                    <a:cubicBezTo>
                      <a:pt x="183" y="60"/>
                      <a:pt x="183" y="61"/>
                      <a:pt x="184" y="63"/>
                    </a:cubicBezTo>
                    <a:cubicBezTo>
                      <a:pt x="183" y="63"/>
                      <a:pt x="182" y="62"/>
                      <a:pt x="182" y="61"/>
                    </a:cubicBezTo>
                    <a:close/>
                    <a:moveTo>
                      <a:pt x="46" y="98"/>
                    </a:moveTo>
                    <a:cubicBezTo>
                      <a:pt x="100" y="94"/>
                      <a:pt x="100" y="94"/>
                      <a:pt x="100" y="94"/>
                    </a:cubicBezTo>
                    <a:cubicBezTo>
                      <a:pt x="105" y="93"/>
                      <a:pt x="105" y="93"/>
                      <a:pt x="105" y="93"/>
                    </a:cubicBezTo>
                    <a:cubicBezTo>
                      <a:pt x="114" y="93"/>
                      <a:pt x="114" y="93"/>
                      <a:pt x="114" y="93"/>
                    </a:cubicBezTo>
                    <a:cubicBezTo>
                      <a:pt x="145" y="92"/>
                      <a:pt x="145" y="92"/>
                      <a:pt x="145" y="92"/>
                    </a:cubicBezTo>
                    <a:cubicBezTo>
                      <a:pt x="125" y="94"/>
                      <a:pt x="125" y="94"/>
                      <a:pt x="125" y="94"/>
                    </a:cubicBezTo>
                    <a:cubicBezTo>
                      <a:pt x="123" y="95"/>
                      <a:pt x="123" y="95"/>
                      <a:pt x="123" y="95"/>
                    </a:cubicBezTo>
                    <a:cubicBezTo>
                      <a:pt x="113" y="96"/>
                      <a:pt x="113" y="96"/>
                      <a:pt x="113" y="96"/>
                    </a:cubicBezTo>
                    <a:cubicBezTo>
                      <a:pt x="27" y="109"/>
                      <a:pt x="27" y="109"/>
                      <a:pt x="27" y="109"/>
                    </a:cubicBezTo>
                    <a:cubicBezTo>
                      <a:pt x="43" y="100"/>
                      <a:pt x="43" y="100"/>
                      <a:pt x="43" y="100"/>
                    </a:cubicBezTo>
                    <a:lnTo>
                      <a:pt x="46" y="98"/>
                    </a:lnTo>
                    <a:close/>
                    <a:moveTo>
                      <a:pt x="113" y="118"/>
                    </a:moveTo>
                    <a:cubicBezTo>
                      <a:pt x="108" y="118"/>
                      <a:pt x="108" y="118"/>
                      <a:pt x="108" y="118"/>
                    </a:cubicBezTo>
                    <a:cubicBezTo>
                      <a:pt x="98" y="119"/>
                      <a:pt x="98" y="119"/>
                      <a:pt x="98" y="119"/>
                    </a:cubicBezTo>
                    <a:cubicBezTo>
                      <a:pt x="109" y="115"/>
                      <a:pt x="109" y="115"/>
                      <a:pt x="109" y="115"/>
                    </a:cubicBezTo>
                    <a:cubicBezTo>
                      <a:pt x="115" y="113"/>
                      <a:pt x="115" y="113"/>
                      <a:pt x="115" y="113"/>
                    </a:cubicBezTo>
                    <a:cubicBezTo>
                      <a:pt x="118" y="111"/>
                      <a:pt x="118" y="111"/>
                      <a:pt x="118" y="111"/>
                    </a:cubicBezTo>
                    <a:cubicBezTo>
                      <a:pt x="182" y="104"/>
                      <a:pt x="182" y="104"/>
                      <a:pt x="182" y="104"/>
                    </a:cubicBezTo>
                    <a:cubicBezTo>
                      <a:pt x="193" y="102"/>
                      <a:pt x="193" y="102"/>
                      <a:pt x="193" y="102"/>
                    </a:cubicBezTo>
                    <a:cubicBezTo>
                      <a:pt x="197" y="106"/>
                      <a:pt x="197" y="106"/>
                      <a:pt x="197" y="106"/>
                    </a:cubicBezTo>
                    <a:cubicBezTo>
                      <a:pt x="198" y="107"/>
                      <a:pt x="198" y="107"/>
                      <a:pt x="198" y="107"/>
                    </a:cubicBezTo>
                    <a:lnTo>
                      <a:pt x="113" y="118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Freeform 138">
                <a:extLst>
                  <a:ext uri="{FF2B5EF4-FFF2-40B4-BE49-F238E27FC236}">
                    <a16:creationId xmlns:a16="http://schemas.microsoft.com/office/drawing/2014/main" id="{A166CBFB-629C-3271-D4A1-E86798A9CD2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343401" y="3576638"/>
                <a:ext cx="396875" cy="327025"/>
              </a:xfrm>
              <a:custGeom>
                <a:avLst/>
                <a:gdLst>
                  <a:gd name="T0" fmla="*/ 175 w 228"/>
                  <a:gd name="T1" fmla="*/ 188 h 188"/>
                  <a:gd name="T2" fmla="*/ 179 w 228"/>
                  <a:gd name="T3" fmla="*/ 148 h 188"/>
                  <a:gd name="T4" fmla="*/ 180 w 228"/>
                  <a:gd name="T5" fmla="*/ 135 h 188"/>
                  <a:gd name="T6" fmla="*/ 197 w 228"/>
                  <a:gd name="T7" fmla="*/ 139 h 188"/>
                  <a:gd name="T8" fmla="*/ 203 w 228"/>
                  <a:gd name="T9" fmla="*/ 123 h 188"/>
                  <a:gd name="T10" fmla="*/ 225 w 228"/>
                  <a:gd name="T11" fmla="*/ 39 h 188"/>
                  <a:gd name="T12" fmla="*/ 149 w 228"/>
                  <a:gd name="T13" fmla="*/ 4 h 188"/>
                  <a:gd name="T14" fmla="*/ 145 w 228"/>
                  <a:gd name="T15" fmla="*/ 6 h 188"/>
                  <a:gd name="T16" fmla="*/ 128 w 228"/>
                  <a:gd name="T17" fmla="*/ 78 h 188"/>
                  <a:gd name="T18" fmla="*/ 121 w 228"/>
                  <a:gd name="T19" fmla="*/ 25 h 188"/>
                  <a:gd name="T20" fmla="*/ 123 w 228"/>
                  <a:gd name="T21" fmla="*/ 19 h 188"/>
                  <a:gd name="T22" fmla="*/ 119 w 228"/>
                  <a:gd name="T23" fmla="*/ 12 h 188"/>
                  <a:gd name="T24" fmla="*/ 110 w 228"/>
                  <a:gd name="T25" fmla="*/ 12 h 188"/>
                  <a:gd name="T26" fmla="*/ 106 w 228"/>
                  <a:gd name="T27" fmla="*/ 19 h 188"/>
                  <a:gd name="T28" fmla="*/ 108 w 228"/>
                  <a:gd name="T29" fmla="*/ 24 h 188"/>
                  <a:gd name="T30" fmla="*/ 101 w 228"/>
                  <a:gd name="T31" fmla="*/ 74 h 188"/>
                  <a:gd name="T32" fmla="*/ 101 w 228"/>
                  <a:gd name="T33" fmla="*/ 77 h 188"/>
                  <a:gd name="T34" fmla="*/ 80 w 228"/>
                  <a:gd name="T35" fmla="*/ 4 h 188"/>
                  <a:gd name="T36" fmla="*/ 77 w 228"/>
                  <a:gd name="T37" fmla="*/ 4 h 188"/>
                  <a:gd name="T38" fmla="*/ 2 w 228"/>
                  <a:gd name="T39" fmla="*/ 41 h 188"/>
                  <a:gd name="T40" fmla="*/ 16 w 228"/>
                  <a:gd name="T41" fmla="*/ 139 h 188"/>
                  <a:gd name="T42" fmla="*/ 43 w 228"/>
                  <a:gd name="T43" fmla="*/ 137 h 188"/>
                  <a:gd name="T44" fmla="*/ 48 w 228"/>
                  <a:gd name="T45" fmla="*/ 188 h 188"/>
                  <a:gd name="T46" fmla="*/ 175 w 228"/>
                  <a:gd name="T47" fmla="*/ 188 h 188"/>
                  <a:gd name="T48" fmla="*/ 181 w 228"/>
                  <a:gd name="T49" fmla="*/ 61 h 188"/>
                  <a:gd name="T50" fmla="*/ 183 w 228"/>
                  <a:gd name="T51" fmla="*/ 63 h 188"/>
                  <a:gd name="T52" fmla="*/ 181 w 228"/>
                  <a:gd name="T53" fmla="*/ 61 h 188"/>
                  <a:gd name="T54" fmla="*/ 193 w 228"/>
                  <a:gd name="T55" fmla="*/ 102 h 188"/>
                  <a:gd name="T56" fmla="*/ 196 w 228"/>
                  <a:gd name="T57" fmla="*/ 106 h 188"/>
                  <a:gd name="T58" fmla="*/ 197 w 228"/>
                  <a:gd name="T59" fmla="*/ 107 h 188"/>
                  <a:gd name="T60" fmla="*/ 112 w 228"/>
                  <a:gd name="T61" fmla="*/ 117 h 188"/>
                  <a:gd name="T62" fmla="*/ 107 w 228"/>
                  <a:gd name="T63" fmla="*/ 118 h 188"/>
                  <a:gd name="T64" fmla="*/ 97 w 228"/>
                  <a:gd name="T65" fmla="*/ 119 h 188"/>
                  <a:gd name="T66" fmla="*/ 108 w 228"/>
                  <a:gd name="T67" fmla="*/ 115 h 188"/>
                  <a:gd name="T68" fmla="*/ 114 w 228"/>
                  <a:gd name="T69" fmla="*/ 113 h 188"/>
                  <a:gd name="T70" fmla="*/ 118 w 228"/>
                  <a:gd name="T71" fmla="*/ 111 h 188"/>
                  <a:gd name="T72" fmla="*/ 181 w 228"/>
                  <a:gd name="T73" fmla="*/ 104 h 188"/>
                  <a:gd name="T74" fmla="*/ 193 w 228"/>
                  <a:gd name="T75" fmla="*/ 102 h 188"/>
                  <a:gd name="T76" fmla="*/ 45 w 228"/>
                  <a:gd name="T77" fmla="*/ 98 h 188"/>
                  <a:gd name="T78" fmla="*/ 100 w 228"/>
                  <a:gd name="T79" fmla="*/ 94 h 188"/>
                  <a:gd name="T80" fmla="*/ 104 w 228"/>
                  <a:gd name="T81" fmla="*/ 93 h 188"/>
                  <a:gd name="T82" fmla="*/ 113 w 228"/>
                  <a:gd name="T83" fmla="*/ 93 h 188"/>
                  <a:gd name="T84" fmla="*/ 144 w 228"/>
                  <a:gd name="T85" fmla="*/ 91 h 188"/>
                  <a:gd name="T86" fmla="*/ 124 w 228"/>
                  <a:gd name="T87" fmla="*/ 94 h 188"/>
                  <a:gd name="T88" fmla="*/ 122 w 228"/>
                  <a:gd name="T89" fmla="*/ 95 h 188"/>
                  <a:gd name="T90" fmla="*/ 112 w 228"/>
                  <a:gd name="T91" fmla="*/ 96 h 188"/>
                  <a:gd name="T92" fmla="*/ 26 w 228"/>
                  <a:gd name="T93" fmla="*/ 109 h 188"/>
                  <a:gd name="T94" fmla="*/ 43 w 228"/>
                  <a:gd name="T95" fmla="*/ 100 h 188"/>
                  <a:gd name="T96" fmla="*/ 45 w 228"/>
                  <a:gd name="T97" fmla="*/ 98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</a:cxnLst>
                <a:rect l="0" t="0" r="r" b="b"/>
                <a:pathLst>
                  <a:path w="228" h="188">
                    <a:moveTo>
                      <a:pt x="175" y="188"/>
                    </a:moveTo>
                    <a:cubicBezTo>
                      <a:pt x="176" y="184"/>
                      <a:pt x="177" y="169"/>
                      <a:pt x="179" y="148"/>
                    </a:cubicBezTo>
                    <a:cubicBezTo>
                      <a:pt x="180" y="135"/>
                      <a:pt x="180" y="135"/>
                      <a:pt x="180" y="135"/>
                    </a:cubicBezTo>
                    <a:cubicBezTo>
                      <a:pt x="197" y="139"/>
                      <a:pt x="197" y="139"/>
                      <a:pt x="197" y="139"/>
                    </a:cubicBezTo>
                    <a:cubicBezTo>
                      <a:pt x="203" y="123"/>
                      <a:pt x="203" y="123"/>
                      <a:pt x="203" y="123"/>
                    </a:cubicBezTo>
                    <a:cubicBezTo>
                      <a:pt x="214" y="92"/>
                      <a:pt x="228" y="58"/>
                      <a:pt x="225" y="39"/>
                    </a:cubicBezTo>
                    <a:cubicBezTo>
                      <a:pt x="224" y="26"/>
                      <a:pt x="182" y="0"/>
                      <a:pt x="149" y="4"/>
                    </a:cubicBezTo>
                    <a:cubicBezTo>
                      <a:pt x="149" y="4"/>
                      <a:pt x="147" y="5"/>
                      <a:pt x="145" y="6"/>
                    </a:cubicBezTo>
                    <a:cubicBezTo>
                      <a:pt x="128" y="78"/>
                      <a:pt x="128" y="78"/>
                      <a:pt x="128" y="78"/>
                    </a:cubicBezTo>
                    <a:cubicBezTo>
                      <a:pt x="121" y="25"/>
                      <a:pt x="121" y="25"/>
                      <a:pt x="121" y="25"/>
                    </a:cubicBezTo>
                    <a:cubicBezTo>
                      <a:pt x="123" y="19"/>
                      <a:pt x="123" y="19"/>
                      <a:pt x="123" y="19"/>
                    </a:cubicBezTo>
                    <a:cubicBezTo>
                      <a:pt x="119" y="12"/>
                      <a:pt x="119" y="12"/>
                      <a:pt x="119" y="12"/>
                    </a:cubicBezTo>
                    <a:cubicBezTo>
                      <a:pt x="110" y="12"/>
                      <a:pt x="110" y="12"/>
                      <a:pt x="110" y="12"/>
                    </a:cubicBezTo>
                    <a:cubicBezTo>
                      <a:pt x="106" y="19"/>
                      <a:pt x="106" y="19"/>
                      <a:pt x="106" y="19"/>
                    </a:cubicBezTo>
                    <a:cubicBezTo>
                      <a:pt x="108" y="24"/>
                      <a:pt x="108" y="24"/>
                      <a:pt x="108" y="24"/>
                    </a:cubicBezTo>
                    <a:cubicBezTo>
                      <a:pt x="101" y="74"/>
                      <a:pt x="101" y="74"/>
                      <a:pt x="101" y="74"/>
                    </a:cubicBezTo>
                    <a:cubicBezTo>
                      <a:pt x="101" y="77"/>
                      <a:pt x="101" y="77"/>
                      <a:pt x="101" y="77"/>
                    </a:cubicBezTo>
                    <a:cubicBezTo>
                      <a:pt x="80" y="4"/>
                      <a:pt x="80" y="4"/>
                      <a:pt x="80" y="4"/>
                    </a:cubicBezTo>
                    <a:cubicBezTo>
                      <a:pt x="79" y="4"/>
                      <a:pt x="78" y="4"/>
                      <a:pt x="77" y="4"/>
                    </a:cubicBezTo>
                    <a:cubicBezTo>
                      <a:pt x="44" y="8"/>
                      <a:pt x="3" y="20"/>
                      <a:pt x="2" y="41"/>
                    </a:cubicBezTo>
                    <a:cubicBezTo>
                      <a:pt x="0" y="52"/>
                      <a:pt x="11" y="115"/>
                      <a:pt x="16" y="139"/>
                    </a:cubicBezTo>
                    <a:cubicBezTo>
                      <a:pt x="22" y="142"/>
                      <a:pt x="33" y="140"/>
                      <a:pt x="43" y="137"/>
                    </a:cubicBezTo>
                    <a:cubicBezTo>
                      <a:pt x="45" y="163"/>
                      <a:pt x="47" y="183"/>
                      <a:pt x="48" y="188"/>
                    </a:cubicBezTo>
                    <a:lnTo>
                      <a:pt x="175" y="188"/>
                    </a:lnTo>
                    <a:close/>
                    <a:moveTo>
                      <a:pt x="181" y="61"/>
                    </a:moveTo>
                    <a:cubicBezTo>
                      <a:pt x="182" y="60"/>
                      <a:pt x="183" y="61"/>
                      <a:pt x="183" y="63"/>
                    </a:cubicBezTo>
                    <a:cubicBezTo>
                      <a:pt x="182" y="63"/>
                      <a:pt x="181" y="62"/>
                      <a:pt x="181" y="61"/>
                    </a:cubicBezTo>
                    <a:close/>
                    <a:moveTo>
                      <a:pt x="193" y="102"/>
                    </a:moveTo>
                    <a:cubicBezTo>
                      <a:pt x="196" y="106"/>
                      <a:pt x="196" y="106"/>
                      <a:pt x="196" y="106"/>
                    </a:cubicBezTo>
                    <a:cubicBezTo>
                      <a:pt x="197" y="107"/>
                      <a:pt x="197" y="107"/>
                      <a:pt x="197" y="107"/>
                    </a:cubicBezTo>
                    <a:cubicBezTo>
                      <a:pt x="112" y="117"/>
                      <a:pt x="112" y="117"/>
                      <a:pt x="112" y="117"/>
                    </a:cubicBezTo>
                    <a:cubicBezTo>
                      <a:pt x="107" y="118"/>
                      <a:pt x="107" y="118"/>
                      <a:pt x="107" y="118"/>
                    </a:cubicBezTo>
                    <a:cubicBezTo>
                      <a:pt x="97" y="119"/>
                      <a:pt x="97" y="119"/>
                      <a:pt x="97" y="119"/>
                    </a:cubicBezTo>
                    <a:cubicBezTo>
                      <a:pt x="108" y="115"/>
                      <a:pt x="108" y="115"/>
                      <a:pt x="108" y="115"/>
                    </a:cubicBezTo>
                    <a:cubicBezTo>
                      <a:pt x="114" y="113"/>
                      <a:pt x="114" y="113"/>
                      <a:pt x="114" y="113"/>
                    </a:cubicBezTo>
                    <a:cubicBezTo>
                      <a:pt x="118" y="111"/>
                      <a:pt x="118" y="111"/>
                      <a:pt x="118" y="111"/>
                    </a:cubicBezTo>
                    <a:cubicBezTo>
                      <a:pt x="181" y="104"/>
                      <a:pt x="181" y="104"/>
                      <a:pt x="181" y="104"/>
                    </a:cubicBezTo>
                    <a:lnTo>
                      <a:pt x="193" y="102"/>
                    </a:lnTo>
                    <a:close/>
                    <a:moveTo>
                      <a:pt x="45" y="98"/>
                    </a:moveTo>
                    <a:cubicBezTo>
                      <a:pt x="100" y="94"/>
                      <a:pt x="100" y="94"/>
                      <a:pt x="100" y="94"/>
                    </a:cubicBezTo>
                    <a:cubicBezTo>
                      <a:pt x="104" y="93"/>
                      <a:pt x="104" y="93"/>
                      <a:pt x="104" y="93"/>
                    </a:cubicBezTo>
                    <a:cubicBezTo>
                      <a:pt x="113" y="93"/>
                      <a:pt x="113" y="93"/>
                      <a:pt x="113" y="93"/>
                    </a:cubicBezTo>
                    <a:cubicBezTo>
                      <a:pt x="144" y="91"/>
                      <a:pt x="144" y="91"/>
                      <a:pt x="144" y="91"/>
                    </a:cubicBezTo>
                    <a:cubicBezTo>
                      <a:pt x="124" y="94"/>
                      <a:pt x="124" y="94"/>
                      <a:pt x="124" y="94"/>
                    </a:cubicBezTo>
                    <a:cubicBezTo>
                      <a:pt x="122" y="95"/>
                      <a:pt x="122" y="95"/>
                      <a:pt x="122" y="95"/>
                    </a:cubicBezTo>
                    <a:cubicBezTo>
                      <a:pt x="112" y="96"/>
                      <a:pt x="112" y="96"/>
                      <a:pt x="112" y="96"/>
                    </a:cubicBezTo>
                    <a:cubicBezTo>
                      <a:pt x="26" y="109"/>
                      <a:pt x="26" y="109"/>
                      <a:pt x="26" y="109"/>
                    </a:cubicBezTo>
                    <a:cubicBezTo>
                      <a:pt x="43" y="100"/>
                      <a:pt x="43" y="100"/>
                      <a:pt x="43" y="100"/>
                    </a:cubicBezTo>
                    <a:lnTo>
                      <a:pt x="45" y="98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Freeform 139">
                <a:extLst>
                  <a:ext uri="{FF2B5EF4-FFF2-40B4-BE49-F238E27FC236}">
                    <a16:creationId xmlns:a16="http://schemas.microsoft.com/office/drawing/2014/main" id="{9AE5D8F7-0916-FE2E-48E5-AD8A337581D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54526" y="3346450"/>
                <a:ext cx="173038" cy="238125"/>
              </a:xfrm>
              <a:custGeom>
                <a:avLst/>
                <a:gdLst>
                  <a:gd name="T0" fmla="*/ 4 w 99"/>
                  <a:gd name="T1" fmla="*/ 64 h 137"/>
                  <a:gd name="T2" fmla="*/ 0 w 99"/>
                  <a:gd name="T3" fmla="*/ 80 h 137"/>
                  <a:gd name="T4" fmla="*/ 4 w 99"/>
                  <a:gd name="T5" fmla="*/ 95 h 137"/>
                  <a:gd name="T6" fmla="*/ 6 w 99"/>
                  <a:gd name="T7" fmla="*/ 91 h 137"/>
                  <a:gd name="T8" fmla="*/ 50 w 99"/>
                  <a:gd name="T9" fmla="*/ 137 h 137"/>
                  <a:gd name="T10" fmla="*/ 93 w 99"/>
                  <a:gd name="T11" fmla="*/ 90 h 137"/>
                  <a:gd name="T12" fmla="*/ 95 w 99"/>
                  <a:gd name="T13" fmla="*/ 95 h 137"/>
                  <a:gd name="T14" fmla="*/ 99 w 99"/>
                  <a:gd name="T15" fmla="*/ 79 h 137"/>
                  <a:gd name="T16" fmla="*/ 95 w 99"/>
                  <a:gd name="T17" fmla="*/ 64 h 137"/>
                  <a:gd name="T18" fmla="*/ 94 w 99"/>
                  <a:gd name="T19" fmla="*/ 64 h 137"/>
                  <a:gd name="T20" fmla="*/ 94 w 99"/>
                  <a:gd name="T21" fmla="*/ 51 h 137"/>
                  <a:gd name="T22" fmla="*/ 57 w 99"/>
                  <a:gd name="T23" fmla="*/ 42 h 137"/>
                  <a:gd name="T24" fmla="*/ 63 w 99"/>
                  <a:gd name="T25" fmla="*/ 45 h 137"/>
                  <a:gd name="T26" fmla="*/ 98 w 99"/>
                  <a:gd name="T27" fmla="*/ 33 h 137"/>
                  <a:gd name="T28" fmla="*/ 17 w 99"/>
                  <a:gd name="T29" fmla="*/ 25 h 137"/>
                  <a:gd name="T30" fmla="*/ 1 w 99"/>
                  <a:gd name="T31" fmla="*/ 35 h 137"/>
                  <a:gd name="T32" fmla="*/ 12 w 99"/>
                  <a:gd name="T33" fmla="*/ 35 h 137"/>
                  <a:gd name="T34" fmla="*/ 5 w 99"/>
                  <a:gd name="T35" fmla="*/ 57 h 137"/>
                  <a:gd name="T36" fmla="*/ 4 w 99"/>
                  <a:gd name="T37" fmla="*/ 65 h 137"/>
                  <a:gd name="T38" fmla="*/ 4 w 99"/>
                  <a:gd name="T39" fmla="*/ 64 h 1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99" h="137">
                    <a:moveTo>
                      <a:pt x="4" y="64"/>
                    </a:moveTo>
                    <a:cubicBezTo>
                      <a:pt x="1" y="64"/>
                      <a:pt x="0" y="71"/>
                      <a:pt x="0" y="80"/>
                    </a:cubicBezTo>
                    <a:cubicBezTo>
                      <a:pt x="0" y="88"/>
                      <a:pt x="1" y="95"/>
                      <a:pt x="4" y="95"/>
                    </a:cubicBezTo>
                    <a:cubicBezTo>
                      <a:pt x="5" y="95"/>
                      <a:pt x="6" y="94"/>
                      <a:pt x="6" y="91"/>
                    </a:cubicBezTo>
                    <a:cubicBezTo>
                      <a:pt x="13" y="118"/>
                      <a:pt x="37" y="137"/>
                      <a:pt x="50" y="137"/>
                    </a:cubicBezTo>
                    <a:cubicBezTo>
                      <a:pt x="67" y="137"/>
                      <a:pt x="89" y="119"/>
                      <a:pt x="93" y="90"/>
                    </a:cubicBezTo>
                    <a:cubicBezTo>
                      <a:pt x="93" y="93"/>
                      <a:pt x="94" y="95"/>
                      <a:pt x="95" y="95"/>
                    </a:cubicBezTo>
                    <a:cubicBezTo>
                      <a:pt x="98" y="95"/>
                      <a:pt x="99" y="88"/>
                      <a:pt x="99" y="79"/>
                    </a:cubicBezTo>
                    <a:cubicBezTo>
                      <a:pt x="99" y="71"/>
                      <a:pt x="98" y="64"/>
                      <a:pt x="95" y="64"/>
                    </a:cubicBezTo>
                    <a:cubicBezTo>
                      <a:pt x="95" y="64"/>
                      <a:pt x="95" y="64"/>
                      <a:pt x="94" y="64"/>
                    </a:cubicBezTo>
                    <a:cubicBezTo>
                      <a:pt x="95" y="60"/>
                      <a:pt x="95" y="56"/>
                      <a:pt x="94" y="51"/>
                    </a:cubicBezTo>
                    <a:cubicBezTo>
                      <a:pt x="86" y="57"/>
                      <a:pt x="72" y="49"/>
                      <a:pt x="57" y="42"/>
                    </a:cubicBezTo>
                    <a:cubicBezTo>
                      <a:pt x="59" y="43"/>
                      <a:pt x="61" y="44"/>
                      <a:pt x="63" y="45"/>
                    </a:cubicBezTo>
                    <a:cubicBezTo>
                      <a:pt x="88" y="57"/>
                      <a:pt x="98" y="33"/>
                      <a:pt x="98" y="33"/>
                    </a:cubicBezTo>
                    <a:cubicBezTo>
                      <a:pt x="98" y="33"/>
                      <a:pt x="67" y="0"/>
                      <a:pt x="17" y="25"/>
                    </a:cubicBezTo>
                    <a:cubicBezTo>
                      <a:pt x="13" y="27"/>
                      <a:pt x="6" y="33"/>
                      <a:pt x="1" y="35"/>
                    </a:cubicBezTo>
                    <a:cubicBezTo>
                      <a:pt x="1" y="35"/>
                      <a:pt x="5" y="35"/>
                      <a:pt x="12" y="35"/>
                    </a:cubicBezTo>
                    <a:cubicBezTo>
                      <a:pt x="6" y="38"/>
                      <a:pt x="4" y="45"/>
                      <a:pt x="5" y="57"/>
                    </a:cubicBezTo>
                    <a:cubicBezTo>
                      <a:pt x="4" y="59"/>
                      <a:pt x="4" y="62"/>
                      <a:pt x="4" y="65"/>
                    </a:cubicBezTo>
                    <a:cubicBezTo>
                      <a:pt x="4" y="65"/>
                      <a:pt x="4" y="64"/>
                      <a:pt x="4" y="6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Freeform 140">
                <a:extLst>
                  <a:ext uri="{FF2B5EF4-FFF2-40B4-BE49-F238E27FC236}">
                    <a16:creationId xmlns:a16="http://schemas.microsoft.com/office/drawing/2014/main" id="{519212C5-A33B-E93D-E72C-309D2A46EA5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041901" y="3571875"/>
                <a:ext cx="396875" cy="327025"/>
              </a:xfrm>
              <a:custGeom>
                <a:avLst/>
                <a:gdLst>
                  <a:gd name="T0" fmla="*/ 149 w 228"/>
                  <a:gd name="T1" fmla="*/ 4 h 188"/>
                  <a:gd name="T2" fmla="*/ 144 w 228"/>
                  <a:gd name="T3" fmla="*/ 6 h 188"/>
                  <a:gd name="T4" fmla="*/ 128 w 228"/>
                  <a:gd name="T5" fmla="*/ 77 h 188"/>
                  <a:gd name="T6" fmla="*/ 121 w 228"/>
                  <a:gd name="T7" fmla="*/ 25 h 188"/>
                  <a:gd name="T8" fmla="*/ 123 w 228"/>
                  <a:gd name="T9" fmla="*/ 19 h 188"/>
                  <a:gd name="T10" fmla="*/ 119 w 228"/>
                  <a:gd name="T11" fmla="*/ 12 h 188"/>
                  <a:gd name="T12" fmla="*/ 110 w 228"/>
                  <a:gd name="T13" fmla="*/ 12 h 188"/>
                  <a:gd name="T14" fmla="*/ 106 w 228"/>
                  <a:gd name="T15" fmla="*/ 19 h 188"/>
                  <a:gd name="T16" fmla="*/ 108 w 228"/>
                  <a:gd name="T17" fmla="*/ 24 h 188"/>
                  <a:gd name="T18" fmla="*/ 101 w 228"/>
                  <a:gd name="T19" fmla="*/ 74 h 188"/>
                  <a:gd name="T20" fmla="*/ 101 w 228"/>
                  <a:gd name="T21" fmla="*/ 77 h 188"/>
                  <a:gd name="T22" fmla="*/ 80 w 228"/>
                  <a:gd name="T23" fmla="*/ 4 h 188"/>
                  <a:gd name="T24" fmla="*/ 77 w 228"/>
                  <a:gd name="T25" fmla="*/ 4 h 188"/>
                  <a:gd name="T26" fmla="*/ 2 w 228"/>
                  <a:gd name="T27" fmla="*/ 41 h 188"/>
                  <a:gd name="T28" fmla="*/ 16 w 228"/>
                  <a:gd name="T29" fmla="*/ 139 h 188"/>
                  <a:gd name="T30" fmla="*/ 43 w 228"/>
                  <a:gd name="T31" fmla="*/ 137 h 188"/>
                  <a:gd name="T32" fmla="*/ 47 w 228"/>
                  <a:gd name="T33" fmla="*/ 188 h 188"/>
                  <a:gd name="T34" fmla="*/ 175 w 228"/>
                  <a:gd name="T35" fmla="*/ 188 h 188"/>
                  <a:gd name="T36" fmla="*/ 179 w 228"/>
                  <a:gd name="T37" fmla="*/ 148 h 188"/>
                  <a:gd name="T38" fmla="*/ 180 w 228"/>
                  <a:gd name="T39" fmla="*/ 135 h 188"/>
                  <a:gd name="T40" fmla="*/ 197 w 228"/>
                  <a:gd name="T41" fmla="*/ 139 h 188"/>
                  <a:gd name="T42" fmla="*/ 202 w 228"/>
                  <a:gd name="T43" fmla="*/ 123 h 188"/>
                  <a:gd name="T44" fmla="*/ 225 w 228"/>
                  <a:gd name="T45" fmla="*/ 39 h 188"/>
                  <a:gd name="T46" fmla="*/ 149 w 228"/>
                  <a:gd name="T47" fmla="*/ 4 h 188"/>
                  <a:gd name="T48" fmla="*/ 181 w 228"/>
                  <a:gd name="T49" fmla="*/ 61 h 188"/>
                  <a:gd name="T50" fmla="*/ 183 w 228"/>
                  <a:gd name="T51" fmla="*/ 63 h 188"/>
                  <a:gd name="T52" fmla="*/ 181 w 228"/>
                  <a:gd name="T53" fmla="*/ 61 h 188"/>
                  <a:gd name="T54" fmla="*/ 45 w 228"/>
                  <a:gd name="T55" fmla="*/ 98 h 188"/>
                  <a:gd name="T56" fmla="*/ 99 w 228"/>
                  <a:gd name="T57" fmla="*/ 94 h 188"/>
                  <a:gd name="T58" fmla="*/ 104 w 228"/>
                  <a:gd name="T59" fmla="*/ 93 h 188"/>
                  <a:gd name="T60" fmla="*/ 113 w 228"/>
                  <a:gd name="T61" fmla="*/ 93 h 188"/>
                  <a:gd name="T62" fmla="*/ 144 w 228"/>
                  <a:gd name="T63" fmla="*/ 91 h 188"/>
                  <a:gd name="T64" fmla="*/ 124 w 228"/>
                  <a:gd name="T65" fmla="*/ 94 h 188"/>
                  <a:gd name="T66" fmla="*/ 122 w 228"/>
                  <a:gd name="T67" fmla="*/ 95 h 188"/>
                  <a:gd name="T68" fmla="*/ 112 w 228"/>
                  <a:gd name="T69" fmla="*/ 96 h 188"/>
                  <a:gd name="T70" fmla="*/ 26 w 228"/>
                  <a:gd name="T71" fmla="*/ 109 h 188"/>
                  <a:gd name="T72" fmla="*/ 42 w 228"/>
                  <a:gd name="T73" fmla="*/ 100 h 188"/>
                  <a:gd name="T74" fmla="*/ 45 w 228"/>
                  <a:gd name="T75" fmla="*/ 98 h 188"/>
                  <a:gd name="T76" fmla="*/ 112 w 228"/>
                  <a:gd name="T77" fmla="*/ 117 h 188"/>
                  <a:gd name="T78" fmla="*/ 107 w 228"/>
                  <a:gd name="T79" fmla="*/ 118 h 188"/>
                  <a:gd name="T80" fmla="*/ 97 w 228"/>
                  <a:gd name="T81" fmla="*/ 119 h 188"/>
                  <a:gd name="T82" fmla="*/ 108 w 228"/>
                  <a:gd name="T83" fmla="*/ 115 h 188"/>
                  <a:gd name="T84" fmla="*/ 114 w 228"/>
                  <a:gd name="T85" fmla="*/ 113 h 188"/>
                  <a:gd name="T86" fmla="*/ 117 w 228"/>
                  <a:gd name="T87" fmla="*/ 111 h 188"/>
                  <a:gd name="T88" fmla="*/ 181 w 228"/>
                  <a:gd name="T89" fmla="*/ 104 h 188"/>
                  <a:gd name="T90" fmla="*/ 192 w 228"/>
                  <a:gd name="T91" fmla="*/ 102 h 188"/>
                  <a:gd name="T92" fmla="*/ 196 w 228"/>
                  <a:gd name="T93" fmla="*/ 106 h 188"/>
                  <a:gd name="T94" fmla="*/ 197 w 228"/>
                  <a:gd name="T95" fmla="*/ 107 h 188"/>
                  <a:gd name="T96" fmla="*/ 112 w 228"/>
                  <a:gd name="T97" fmla="*/ 117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</a:cxnLst>
                <a:rect l="0" t="0" r="r" b="b"/>
                <a:pathLst>
                  <a:path w="228" h="188">
                    <a:moveTo>
                      <a:pt x="149" y="4"/>
                    </a:moveTo>
                    <a:cubicBezTo>
                      <a:pt x="149" y="4"/>
                      <a:pt x="147" y="5"/>
                      <a:pt x="144" y="6"/>
                    </a:cubicBezTo>
                    <a:cubicBezTo>
                      <a:pt x="128" y="77"/>
                      <a:pt x="128" y="77"/>
                      <a:pt x="128" y="77"/>
                    </a:cubicBezTo>
                    <a:cubicBezTo>
                      <a:pt x="121" y="25"/>
                      <a:pt x="121" y="25"/>
                      <a:pt x="121" y="25"/>
                    </a:cubicBezTo>
                    <a:cubicBezTo>
                      <a:pt x="123" y="19"/>
                      <a:pt x="123" y="19"/>
                      <a:pt x="123" y="19"/>
                    </a:cubicBezTo>
                    <a:cubicBezTo>
                      <a:pt x="119" y="12"/>
                      <a:pt x="119" y="12"/>
                      <a:pt x="119" y="12"/>
                    </a:cubicBezTo>
                    <a:cubicBezTo>
                      <a:pt x="110" y="12"/>
                      <a:pt x="110" y="12"/>
                      <a:pt x="110" y="12"/>
                    </a:cubicBezTo>
                    <a:cubicBezTo>
                      <a:pt x="106" y="19"/>
                      <a:pt x="106" y="19"/>
                      <a:pt x="106" y="19"/>
                    </a:cubicBezTo>
                    <a:cubicBezTo>
                      <a:pt x="108" y="24"/>
                      <a:pt x="108" y="24"/>
                      <a:pt x="108" y="24"/>
                    </a:cubicBezTo>
                    <a:cubicBezTo>
                      <a:pt x="101" y="74"/>
                      <a:pt x="101" y="74"/>
                      <a:pt x="101" y="74"/>
                    </a:cubicBezTo>
                    <a:cubicBezTo>
                      <a:pt x="101" y="77"/>
                      <a:pt x="101" y="77"/>
                      <a:pt x="101" y="77"/>
                    </a:cubicBezTo>
                    <a:cubicBezTo>
                      <a:pt x="80" y="4"/>
                      <a:pt x="80" y="4"/>
                      <a:pt x="80" y="4"/>
                    </a:cubicBezTo>
                    <a:cubicBezTo>
                      <a:pt x="79" y="4"/>
                      <a:pt x="78" y="4"/>
                      <a:pt x="77" y="4"/>
                    </a:cubicBezTo>
                    <a:cubicBezTo>
                      <a:pt x="44" y="8"/>
                      <a:pt x="3" y="19"/>
                      <a:pt x="2" y="41"/>
                    </a:cubicBezTo>
                    <a:cubicBezTo>
                      <a:pt x="0" y="52"/>
                      <a:pt x="11" y="114"/>
                      <a:pt x="16" y="139"/>
                    </a:cubicBezTo>
                    <a:cubicBezTo>
                      <a:pt x="22" y="142"/>
                      <a:pt x="33" y="140"/>
                      <a:pt x="43" y="137"/>
                    </a:cubicBezTo>
                    <a:cubicBezTo>
                      <a:pt x="45" y="163"/>
                      <a:pt x="47" y="183"/>
                      <a:pt x="47" y="188"/>
                    </a:cubicBezTo>
                    <a:cubicBezTo>
                      <a:pt x="175" y="188"/>
                      <a:pt x="175" y="188"/>
                      <a:pt x="175" y="188"/>
                    </a:cubicBezTo>
                    <a:cubicBezTo>
                      <a:pt x="175" y="184"/>
                      <a:pt x="177" y="169"/>
                      <a:pt x="179" y="148"/>
                    </a:cubicBezTo>
                    <a:cubicBezTo>
                      <a:pt x="180" y="135"/>
                      <a:pt x="180" y="135"/>
                      <a:pt x="180" y="135"/>
                    </a:cubicBezTo>
                    <a:cubicBezTo>
                      <a:pt x="197" y="139"/>
                      <a:pt x="197" y="139"/>
                      <a:pt x="197" y="139"/>
                    </a:cubicBezTo>
                    <a:cubicBezTo>
                      <a:pt x="202" y="123"/>
                      <a:pt x="202" y="123"/>
                      <a:pt x="202" y="123"/>
                    </a:cubicBezTo>
                    <a:cubicBezTo>
                      <a:pt x="214" y="92"/>
                      <a:pt x="228" y="58"/>
                      <a:pt x="225" y="39"/>
                    </a:cubicBezTo>
                    <a:cubicBezTo>
                      <a:pt x="224" y="26"/>
                      <a:pt x="182" y="0"/>
                      <a:pt x="149" y="4"/>
                    </a:cubicBezTo>
                    <a:close/>
                    <a:moveTo>
                      <a:pt x="181" y="61"/>
                    </a:moveTo>
                    <a:cubicBezTo>
                      <a:pt x="182" y="60"/>
                      <a:pt x="182" y="61"/>
                      <a:pt x="183" y="63"/>
                    </a:cubicBezTo>
                    <a:cubicBezTo>
                      <a:pt x="182" y="63"/>
                      <a:pt x="181" y="62"/>
                      <a:pt x="181" y="61"/>
                    </a:cubicBezTo>
                    <a:close/>
                    <a:moveTo>
                      <a:pt x="45" y="98"/>
                    </a:moveTo>
                    <a:cubicBezTo>
                      <a:pt x="99" y="94"/>
                      <a:pt x="99" y="94"/>
                      <a:pt x="99" y="94"/>
                    </a:cubicBezTo>
                    <a:cubicBezTo>
                      <a:pt x="104" y="93"/>
                      <a:pt x="104" y="93"/>
                      <a:pt x="104" y="93"/>
                    </a:cubicBezTo>
                    <a:cubicBezTo>
                      <a:pt x="113" y="93"/>
                      <a:pt x="113" y="93"/>
                      <a:pt x="113" y="93"/>
                    </a:cubicBezTo>
                    <a:cubicBezTo>
                      <a:pt x="144" y="91"/>
                      <a:pt x="144" y="91"/>
                      <a:pt x="144" y="91"/>
                    </a:cubicBezTo>
                    <a:cubicBezTo>
                      <a:pt x="124" y="94"/>
                      <a:pt x="124" y="94"/>
                      <a:pt x="124" y="94"/>
                    </a:cubicBezTo>
                    <a:cubicBezTo>
                      <a:pt x="122" y="95"/>
                      <a:pt x="122" y="95"/>
                      <a:pt x="122" y="95"/>
                    </a:cubicBezTo>
                    <a:cubicBezTo>
                      <a:pt x="112" y="96"/>
                      <a:pt x="112" y="96"/>
                      <a:pt x="112" y="96"/>
                    </a:cubicBezTo>
                    <a:cubicBezTo>
                      <a:pt x="26" y="109"/>
                      <a:pt x="26" y="109"/>
                      <a:pt x="26" y="109"/>
                    </a:cubicBezTo>
                    <a:cubicBezTo>
                      <a:pt x="42" y="100"/>
                      <a:pt x="42" y="100"/>
                      <a:pt x="42" y="100"/>
                    </a:cubicBezTo>
                    <a:lnTo>
                      <a:pt x="45" y="98"/>
                    </a:lnTo>
                    <a:close/>
                    <a:moveTo>
                      <a:pt x="112" y="117"/>
                    </a:moveTo>
                    <a:cubicBezTo>
                      <a:pt x="107" y="118"/>
                      <a:pt x="107" y="118"/>
                      <a:pt x="107" y="118"/>
                    </a:cubicBezTo>
                    <a:cubicBezTo>
                      <a:pt x="97" y="119"/>
                      <a:pt x="97" y="119"/>
                      <a:pt x="97" y="119"/>
                    </a:cubicBezTo>
                    <a:cubicBezTo>
                      <a:pt x="108" y="115"/>
                      <a:pt x="108" y="115"/>
                      <a:pt x="108" y="115"/>
                    </a:cubicBezTo>
                    <a:cubicBezTo>
                      <a:pt x="114" y="113"/>
                      <a:pt x="114" y="113"/>
                      <a:pt x="114" y="113"/>
                    </a:cubicBezTo>
                    <a:cubicBezTo>
                      <a:pt x="117" y="111"/>
                      <a:pt x="117" y="111"/>
                      <a:pt x="117" y="111"/>
                    </a:cubicBezTo>
                    <a:cubicBezTo>
                      <a:pt x="181" y="104"/>
                      <a:pt x="181" y="104"/>
                      <a:pt x="181" y="104"/>
                    </a:cubicBezTo>
                    <a:cubicBezTo>
                      <a:pt x="192" y="102"/>
                      <a:pt x="192" y="102"/>
                      <a:pt x="192" y="102"/>
                    </a:cubicBezTo>
                    <a:cubicBezTo>
                      <a:pt x="196" y="106"/>
                      <a:pt x="196" y="106"/>
                      <a:pt x="196" y="106"/>
                    </a:cubicBezTo>
                    <a:cubicBezTo>
                      <a:pt x="197" y="107"/>
                      <a:pt x="197" y="107"/>
                      <a:pt x="197" y="107"/>
                    </a:cubicBezTo>
                    <a:lnTo>
                      <a:pt x="112" y="117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Freeform 141">
                <a:extLst>
                  <a:ext uri="{FF2B5EF4-FFF2-40B4-BE49-F238E27FC236}">
                    <a16:creationId xmlns:a16="http://schemas.microsoft.com/office/drawing/2014/main" id="{7FB140EC-1A5D-D808-79D9-751DC689D4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51438" y="3341688"/>
                <a:ext cx="174625" cy="238125"/>
              </a:xfrm>
              <a:custGeom>
                <a:avLst/>
                <a:gdLst>
                  <a:gd name="T0" fmla="*/ 4 w 100"/>
                  <a:gd name="T1" fmla="*/ 64 h 137"/>
                  <a:gd name="T2" fmla="*/ 0 w 100"/>
                  <a:gd name="T3" fmla="*/ 80 h 137"/>
                  <a:gd name="T4" fmla="*/ 4 w 100"/>
                  <a:gd name="T5" fmla="*/ 95 h 137"/>
                  <a:gd name="T6" fmla="*/ 7 w 100"/>
                  <a:gd name="T7" fmla="*/ 91 h 137"/>
                  <a:gd name="T8" fmla="*/ 51 w 100"/>
                  <a:gd name="T9" fmla="*/ 137 h 137"/>
                  <a:gd name="T10" fmla="*/ 93 w 100"/>
                  <a:gd name="T11" fmla="*/ 90 h 137"/>
                  <a:gd name="T12" fmla="*/ 96 w 100"/>
                  <a:gd name="T13" fmla="*/ 95 h 137"/>
                  <a:gd name="T14" fmla="*/ 100 w 100"/>
                  <a:gd name="T15" fmla="*/ 79 h 137"/>
                  <a:gd name="T16" fmla="*/ 96 w 100"/>
                  <a:gd name="T17" fmla="*/ 64 h 137"/>
                  <a:gd name="T18" fmla="*/ 95 w 100"/>
                  <a:gd name="T19" fmla="*/ 64 h 137"/>
                  <a:gd name="T20" fmla="*/ 95 w 100"/>
                  <a:gd name="T21" fmla="*/ 51 h 137"/>
                  <a:gd name="T22" fmla="*/ 58 w 100"/>
                  <a:gd name="T23" fmla="*/ 42 h 137"/>
                  <a:gd name="T24" fmla="*/ 64 w 100"/>
                  <a:gd name="T25" fmla="*/ 45 h 137"/>
                  <a:gd name="T26" fmla="*/ 99 w 100"/>
                  <a:gd name="T27" fmla="*/ 33 h 137"/>
                  <a:gd name="T28" fmla="*/ 18 w 100"/>
                  <a:gd name="T29" fmla="*/ 25 h 137"/>
                  <a:gd name="T30" fmla="*/ 2 w 100"/>
                  <a:gd name="T31" fmla="*/ 35 h 137"/>
                  <a:gd name="T32" fmla="*/ 13 w 100"/>
                  <a:gd name="T33" fmla="*/ 35 h 137"/>
                  <a:gd name="T34" fmla="*/ 6 w 100"/>
                  <a:gd name="T35" fmla="*/ 57 h 137"/>
                  <a:gd name="T36" fmla="*/ 5 w 100"/>
                  <a:gd name="T37" fmla="*/ 65 h 137"/>
                  <a:gd name="T38" fmla="*/ 4 w 100"/>
                  <a:gd name="T39" fmla="*/ 64 h 1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100" h="137">
                    <a:moveTo>
                      <a:pt x="4" y="64"/>
                    </a:moveTo>
                    <a:cubicBezTo>
                      <a:pt x="2" y="64"/>
                      <a:pt x="0" y="71"/>
                      <a:pt x="0" y="80"/>
                    </a:cubicBezTo>
                    <a:cubicBezTo>
                      <a:pt x="0" y="88"/>
                      <a:pt x="2" y="95"/>
                      <a:pt x="4" y="95"/>
                    </a:cubicBezTo>
                    <a:cubicBezTo>
                      <a:pt x="5" y="95"/>
                      <a:pt x="6" y="94"/>
                      <a:pt x="7" y="91"/>
                    </a:cubicBezTo>
                    <a:cubicBezTo>
                      <a:pt x="14" y="118"/>
                      <a:pt x="38" y="137"/>
                      <a:pt x="51" y="137"/>
                    </a:cubicBezTo>
                    <a:cubicBezTo>
                      <a:pt x="67" y="137"/>
                      <a:pt x="90" y="119"/>
                      <a:pt x="93" y="90"/>
                    </a:cubicBezTo>
                    <a:cubicBezTo>
                      <a:pt x="94" y="93"/>
                      <a:pt x="95" y="95"/>
                      <a:pt x="96" y="95"/>
                    </a:cubicBezTo>
                    <a:cubicBezTo>
                      <a:pt x="98" y="95"/>
                      <a:pt x="100" y="88"/>
                      <a:pt x="100" y="79"/>
                    </a:cubicBezTo>
                    <a:cubicBezTo>
                      <a:pt x="100" y="71"/>
                      <a:pt x="98" y="64"/>
                      <a:pt x="96" y="64"/>
                    </a:cubicBezTo>
                    <a:cubicBezTo>
                      <a:pt x="96" y="64"/>
                      <a:pt x="96" y="64"/>
                      <a:pt x="95" y="64"/>
                    </a:cubicBezTo>
                    <a:cubicBezTo>
                      <a:pt x="95" y="60"/>
                      <a:pt x="96" y="56"/>
                      <a:pt x="95" y="51"/>
                    </a:cubicBezTo>
                    <a:cubicBezTo>
                      <a:pt x="87" y="57"/>
                      <a:pt x="73" y="49"/>
                      <a:pt x="58" y="42"/>
                    </a:cubicBezTo>
                    <a:cubicBezTo>
                      <a:pt x="60" y="43"/>
                      <a:pt x="62" y="44"/>
                      <a:pt x="64" y="45"/>
                    </a:cubicBezTo>
                    <a:cubicBezTo>
                      <a:pt x="89" y="57"/>
                      <a:pt x="99" y="33"/>
                      <a:pt x="99" y="33"/>
                    </a:cubicBezTo>
                    <a:cubicBezTo>
                      <a:pt x="99" y="33"/>
                      <a:pt x="68" y="0"/>
                      <a:pt x="18" y="25"/>
                    </a:cubicBezTo>
                    <a:cubicBezTo>
                      <a:pt x="13" y="27"/>
                      <a:pt x="7" y="33"/>
                      <a:pt x="2" y="35"/>
                    </a:cubicBezTo>
                    <a:cubicBezTo>
                      <a:pt x="2" y="35"/>
                      <a:pt x="6" y="35"/>
                      <a:pt x="13" y="35"/>
                    </a:cubicBezTo>
                    <a:cubicBezTo>
                      <a:pt x="7" y="38"/>
                      <a:pt x="4" y="45"/>
                      <a:pt x="6" y="57"/>
                    </a:cubicBezTo>
                    <a:cubicBezTo>
                      <a:pt x="5" y="59"/>
                      <a:pt x="5" y="62"/>
                      <a:pt x="5" y="65"/>
                    </a:cubicBezTo>
                    <a:cubicBezTo>
                      <a:pt x="5" y="64"/>
                      <a:pt x="5" y="64"/>
                      <a:pt x="4" y="6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Freeform 142">
                <a:extLst>
                  <a:ext uri="{FF2B5EF4-FFF2-40B4-BE49-F238E27FC236}">
                    <a16:creationId xmlns:a16="http://schemas.microsoft.com/office/drawing/2014/main" id="{B8DEEE84-5776-0682-D4FF-6267269E72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76788" y="3638550"/>
                <a:ext cx="215900" cy="163513"/>
              </a:xfrm>
              <a:custGeom>
                <a:avLst/>
                <a:gdLst>
                  <a:gd name="T0" fmla="*/ 47 w 136"/>
                  <a:gd name="T1" fmla="*/ 0 h 103"/>
                  <a:gd name="T2" fmla="*/ 47 w 136"/>
                  <a:gd name="T3" fmla="*/ 61 h 103"/>
                  <a:gd name="T4" fmla="*/ 0 w 136"/>
                  <a:gd name="T5" fmla="*/ 61 h 103"/>
                  <a:gd name="T6" fmla="*/ 0 w 136"/>
                  <a:gd name="T7" fmla="*/ 103 h 103"/>
                  <a:gd name="T8" fmla="*/ 136 w 136"/>
                  <a:gd name="T9" fmla="*/ 103 h 103"/>
                  <a:gd name="T10" fmla="*/ 136 w 136"/>
                  <a:gd name="T11" fmla="*/ 61 h 103"/>
                  <a:gd name="T12" fmla="*/ 89 w 136"/>
                  <a:gd name="T13" fmla="*/ 61 h 103"/>
                  <a:gd name="T14" fmla="*/ 89 w 136"/>
                  <a:gd name="T15" fmla="*/ 0 h 103"/>
                  <a:gd name="T16" fmla="*/ 47 w 136"/>
                  <a:gd name="T17" fmla="*/ 0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36" h="103">
                    <a:moveTo>
                      <a:pt x="47" y="0"/>
                    </a:moveTo>
                    <a:lnTo>
                      <a:pt x="47" y="61"/>
                    </a:lnTo>
                    <a:lnTo>
                      <a:pt x="0" y="61"/>
                    </a:lnTo>
                    <a:lnTo>
                      <a:pt x="0" y="103"/>
                    </a:lnTo>
                    <a:lnTo>
                      <a:pt x="136" y="103"/>
                    </a:lnTo>
                    <a:lnTo>
                      <a:pt x="136" y="61"/>
                    </a:lnTo>
                    <a:lnTo>
                      <a:pt x="89" y="61"/>
                    </a:lnTo>
                    <a:lnTo>
                      <a:pt x="89" y="0"/>
                    </a:lnTo>
                    <a:lnTo>
                      <a:pt x="47" y="0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solidFill>
                    <a:srgbClr val="42495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5" name="组合 44">
              <a:extLst>
                <a:ext uri="{FF2B5EF4-FFF2-40B4-BE49-F238E27FC236}">
                  <a16:creationId xmlns:a16="http://schemas.microsoft.com/office/drawing/2014/main" id="{FAF03FFF-9503-4244-5B15-FC3A58AEC7AD}"/>
                </a:ext>
              </a:extLst>
            </p:cNvPr>
            <p:cNvGrpSpPr/>
            <p:nvPr/>
          </p:nvGrpSpPr>
          <p:grpSpPr>
            <a:xfrm>
              <a:off x="9298895" y="2819044"/>
              <a:ext cx="812033" cy="655464"/>
              <a:chOff x="9170656" y="3019949"/>
              <a:chExt cx="519248" cy="436389"/>
            </a:xfrm>
            <a:solidFill>
              <a:schemeClr val="accent1">
                <a:lumMod val="50000"/>
              </a:schemeClr>
            </a:solidFill>
          </p:grpSpPr>
          <p:sp>
            <p:nvSpPr>
              <p:cNvPr id="38" name="Rectangle 76">
                <a:extLst>
                  <a:ext uri="{FF2B5EF4-FFF2-40B4-BE49-F238E27FC236}">
                    <a16:creationId xmlns:a16="http://schemas.microsoft.com/office/drawing/2014/main" id="{DA1F1C94-07D4-626F-E14C-CA85EE2DB1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59850" y="3406623"/>
                <a:ext cx="138098" cy="30382"/>
              </a:xfrm>
              <a:prstGeom prst="rect">
                <a:avLst/>
              </a:prstGeom>
              <a:grpFill/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Freeform 77">
                <a:extLst>
                  <a:ext uri="{FF2B5EF4-FFF2-40B4-BE49-F238E27FC236}">
                    <a16:creationId xmlns:a16="http://schemas.microsoft.com/office/drawing/2014/main" id="{CDEFA3C3-DAD7-C567-238C-F3FBC3C2633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9170656" y="3019949"/>
                <a:ext cx="519248" cy="378388"/>
              </a:xfrm>
              <a:custGeom>
                <a:avLst/>
                <a:gdLst>
                  <a:gd name="T0" fmla="*/ 184 w 189"/>
                  <a:gd name="T1" fmla="*/ 0 h 138"/>
                  <a:gd name="T2" fmla="*/ 5 w 189"/>
                  <a:gd name="T3" fmla="*/ 0 h 138"/>
                  <a:gd name="T4" fmla="*/ 0 w 189"/>
                  <a:gd name="T5" fmla="*/ 5 h 138"/>
                  <a:gd name="T6" fmla="*/ 0 w 189"/>
                  <a:gd name="T7" fmla="*/ 134 h 138"/>
                  <a:gd name="T8" fmla="*/ 5 w 189"/>
                  <a:gd name="T9" fmla="*/ 138 h 138"/>
                  <a:gd name="T10" fmla="*/ 184 w 189"/>
                  <a:gd name="T11" fmla="*/ 138 h 138"/>
                  <a:gd name="T12" fmla="*/ 189 w 189"/>
                  <a:gd name="T13" fmla="*/ 134 h 138"/>
                  <a:gd name="T14" fmla="*/ 189 w 189"/>
                  <a:gd name="T15" fmla="*/ 5 h 138"/>
                  <a:gd name="T16" fmla="*/ 184 w 189"/>
                  <a:gd name="T17" fmla="*/ 0 h 138"/>
                  <a:gd name="T18" fmla="*/ 177 w 189"/>
                  <a:gd name="T19" fmla="*/ 108 h 138"/>
                  <a:gd name="T20" fmla="*/ 12 w 189"/>
                  <a:gd name="T21" fmla="*/ 108 h 138"/>
                  <a:gd name="T22" fmla="*/ 12 w 189"/>
                  <a:gd name="T23" fmla="*/ 11 h 138"/>
                  <a:gd name="T24" fmla="*/ 177 w 189"/>
                  <a:gd name="T25" fmla="*/ 11 h 138"/>
                  <a:gd name="T26" fmla="*/ 177 w 189"/>
                  <a:gd name="T27" fmla="*/ 108 h 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189" h="138">
                    <a:moveTo>
                      <a:pt x="184" y="0"/>
                    </a:moveTo>
                    <a:cubicBezTo>
                      <a:pt x="5" y="0"/>
                      <a:pt x="5" y="0"/>
                      <a:pt x="5" y="0"/>
                    </a:cubicBezTo>
                    <a:cubicBezTo>
                      <a:pt x="2" y="0"/>
                      <a:pt x="0" y="2"/>
                      <a:pt x="0" y="5"/>
                    </a:cubicBezTo>
                    <a:cubicBezTo>
                      <a:pt x="0" y="134"/>
                      <a:pt x="0" y="134"/>
                      <a:pt x="0" y="134"/>
                    </a:cubicBezTo>
                    <a:cubicBezTo>
                      <a:pt x="0" y="136"/>
                      <a:pt x="2" y="138"/>
                      <a:pt x="5" y="138"/>
                    </a:cubicBezTo>
                    <a:cubicBezTo>
                      <a:pt x="184" y="138"/>
                      <a:pt x="184" y="138"/>
                      <a:pt x="184" y="138"/>
                    </a:cubicBezTo>
                    <a:cubicBezTo>
                      <a:pt x="187" y="138"/>
                      <a:pt x="189" y="136"/>
                      <a:pt x="189" y="134"/>
                    </a:cubicBezTo>
                    <a:cubicBezTo>
                      <a:pt x="189" y="5"/>
                      <a:pt x="189" y="5"/>
                      <a:pt x="189" y="5"/>
                    </a:cubicBezTo>
                    <a:cubicBezTo>
                      <a:pt x="189" y="2"/>
                      <a:pt x="187" y="0"/>
                      <a:pt x="184" y="0"/>
                    </a:cubicBezTo>
                    <a:close/>
                    <a:moveTo>
                      <a:pt x="177" y="108"/>
                    </a:moveTo>
                    <a:cubicBezTo>
                      <a:pt x="12" y="108"/>
                      <a:pt x="12" y="108"/>
                      <a:pt x="12" y="108"/>
                    </a:cubicBezTo>
                    <a:cubicBezTo>
                      <a:pt x="12" y="11"/>
                      <a:pt x="12" y="11"/>
                      <a:pt x="12" y="11"/>
                    </a:cubicBezTo>
                    <a:cubicBezTo>
                      <a:pt x="177" y="11"/>
                      <a:pt x="177" y="11"/>
                      <a:pt x="177" y="11"/>
                    </a:cubicBezTo>
                    <a:lnTo>
                      <a:pt x="177" y="108"/>
                    </a:lnTo>
                    <a:close/>
                  </a:path>
                </a:pathLst>
              </a:custGeom>
              <a:grpFill/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Freeform 78">
                <a:extLst>
                  <a:ext uri="{FF2B5EF4-FFF2-40B4-BE49-F238E27FC236}">
                    <a16:creationId xmlns:a16="http://schemas.microsoft.com/office/drawing/2014/main" id="{8F52298C-BB75-B9FC-5C32-8CA2CD11025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319802" y="3442528"/>
                <a:ext cx="220956" cy="13810"/>
              </a:xfrm>
              <a:custGeom>
                <a:avLst/>
                <a:gdLst>
                  <a:gd name="T0" fmla="*/ 77 w 81"/>
                  <a:gd name="T1" fmla="*/ 0 h 5"/>
                  <a:gd name="T2" fmla="*/ 4 w 81"/>
                  <a:gd name="T3" fmla="*/ 0 h 5"/>
                  <a:gd name="T4" fmla="*/ 0 w 81"/>
                  <a:gd name="T5" fmla="*/ 3 h 5"/>
                  <a:gd name="T6" fmla="*/ 0 w 81"/>
                  <a:gd name="T7" fmla="*/ 5 h 5"/>
                  <a:gd name="T8" fmla="*/ 81 w 81"/>
                  <a:gd name="T9" fmla="*/ 5 h 5"/>
                  <a:gd name="T10" fmla="*/ 81 w 81"/>
                  <a:gd name="T11" fmla="*/ 3 h 5"/>
                  <a:gd name="T12" fmla="*/ 77 w 81"/>
                  <a:gd name="T13" fmla="*/ 0 h 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81" h="5">
                    <a:moveTo>
                      <a:pt x="77" y="0"/>
                    </a:moveTo>
                    <a:cubicBezTo>
                      <a:pt x="4" y="0"/>
                      <a:pt x="4" y="0"/>
                      <a:pt x="4" y="0"/>
                    </a:cubicBezTo>
                    <a:cubicBezTo>
                      <a:pt x="2" y="0"/>
                      <a:pt x="0" y="1"/>
                      <a:pt x="0" y="3"/>
                    </a:cubicBezTo>
                    <a:cubicBezTo>
                      <a:pt x="0" y="5"/>
                      <a:pt x="0" y="5"/>
                      <a:pt x="0" y="5"/>
                    </a:cubicBezTo>
                    <a:cubicBezTo>
                      <a:pt x="81" y="5"/>
                      <a:pt x="81" y="5"/>
                      <a:pt x="81" y="5"/>
                    </a:cubicBezTo>
                    <a:cubicBezTo>
                      <a:pt x="81" y="3"/>
                      <a:pt x="81" y="3"/>
                      <a:pt x="81" y="3"/>
                    </a:cubicBezTo>
                    <a:cubicBezTo>
                      <a:pt x="81" y="1"/>
                      <a:pt x="79" y="0"/>
                      <a:pt x="77" y="0"/>
                    </a:cubicBezTo>
                    <a:close/>
                  </a:path>
                </a:pathLst>
              </a:custGeom>
              <a:grpFill/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Freeform 79">
                <a:extLst>
                  <a:ext uri="{FF2B5EF4-FFF2-40B4-BE49-F238E27FC236}">
                    <a16:creationId xmlns:a16="http://schemas.microsoft.com/office/drawing/2014/main" id="{C169CA61-E9FC-09E5-D34B-52C8E671771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261801" y="3198095"/>
                <a:ext cx="49715" cy="46953"/>
              </a:xfrm>
              <a:custGeom>
                <a:avLst/>
                <a:gdLst>
                  <a:gd name="T0" fmla="*/ 17 w 18"/>
                  <a:gd name="T1" fmla="*/ 0 h 17"/>
                  <a:gd name="T2" fmla="*/ 16 w 18"/>
                  <a:gd name="T3" fmla="*/ 0 h 17"/>
                  <a:gd name="T4" fmla="*/ 0 w 18"/>
                  <a:gd name="T5" fmla="*/ 15 h 17"/>
                  <a:gd name="T6" fmla="*/ 0 w 18"/>
                  <a:gd name="T7" fmla="*/ 17 h 17"/>
                  <a:gd name="T8" fmla="*/ 1 w 18"/>
                  <a:gd name="T9" fmla="*/ 17 h 17"/>
                  <a:gd name="T10" fmla="*/ 2 w 18"/>
                  <a:gd name="T11" fmla="*/ 17 h 17"/>
                  <a:gd name="T12" fmla="*/ 18 w 18"/>
                  <a:gd name="T13" fmla="*/ 2 h 17"/>
                  <a:gd name="T14" fmla="*/ 18 w 18"/>
                  <a:gd name="T15" fmla="*/ 0 h 17"/>
                  <a:gd name="T16" fmla="*/ 17 w 18"/>
                  <a:gd name="T17" fmla="*/ 0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8" h="17">
                    <a:moveTo>
                      <a:pt x="17" y="0"/>
                    </a:moveTo>
                    <a:cubicBezTo>
                      <a:pt x="16" y="0"/>
                      <a:pt x="16" y="0"/>
                      <a:pt x="16" y="0"/>
                    </a:cubicBezTo>
                    <a:cubicBezTo>
                      <a:pt x="0" y="15"/>
                      <a:pt x="0" y="15"/>
                      <a:pt x="0" y="15"/>
                    </a:cubicBezTo>
                    <a:cubicBezTo>
                      <a:pt x="0" y="15"/>
                      <a:pt x="0" y="16"/>
                      <a:pt x="0" y="17"/>
                    </a:cubicBezTo>
                    <a:cubicBezTo>
                      <a:pt x="1" y="17"/>
                      <a:pt x="1" y="17"/>
                      <a:pt x="1" y="17"/>
                    </a:cubicBezTo>
                    <a:cubicBezTo>
                      <a:pt x="2" y="17"/>
                      <a:pt x="2" y="17"/>
                      <a:pt x="2" y="17"/>
                    </a:cubicBezTo>
                    <a:cubicBezTo>
                      <a:pt x="18" y="2"/>
                      <a:pt x="18" y="2"/>
                      <a:pt x="18" y="2"/>
                    </a:cubicBezTo>
                    <a:cubicBezTo>
                      <a:pt x="18" y="2"/>
                      <a:pt x="18" y="1"/>
                      <a:pt x="18" y="0"/>
                    </a:cubicBezTo>
                    <a:cubicBezTo>
                      <a:pt x="17" y="0"/>
                      <a:pt x="17" y="0"/>
                      <a:pt x="17" y="0"/>
                    </a:cubicBezTo>
                    <a:close/>
                  </a:path>
                </a:pathLst>
              </a:custGeom>
              <a:grpFill/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Freeform 80">
                <a:extLst>
                  <a:ext uri="{FF2B5EF4-FFF2-40B4-BE49-F238E27FC236}">
                    <a16:creationId xmlns:a16="http://schemas.microsoft.com/office/drawing/2014/main" id="{F8BF852A-94AD-242A-420B-28F43B75D85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9236943" y="3113856"/>
                <a:ext cx="227861" cy="156051"/>
              </a:xfrm>
              <a:custGeom>
                <a:avLst/>
                <a:gdLst>
                  <a:gd name="T0" fmla="*/ 80 w 83"/>
                  <a:gd name="T1" fmla="*/ 3 h 57"/>
                  <a:gd name="T2" fmla="*/ 73 w 83"/>
                  <a:gd name="T3" fmla="*/ 0 h 57"/>
                  <a:gd name="T4" fmla="*/ 10 w 83"/>
                  <a:gd name="T5" fmla="*/ 0 h 57"/>
                  <a:gd name="T6" fmla="*/ 3 w 83"/>
                  <a:gd name="T7" fmla="*/ 3 h 57"/>
                  <a:gd name="T8" fmla="*/ 0 w 83"/>
                  <a:gd name="T9" fmla="*/ 11 h 57"/>
                  <a:gd name="T10" fmla="*/ 0 w 83"/>
                  <a:gd name="T11" fmla="*/ 47 h 57"/>
                  <a:gd name="T12" fmla="*/ 10 w 83"/>
                  <a:gd name="T13" fmla="*/ 57 h 57"/>
                  <a:gd name="T14" fmla="*/ 73 w 83"/>
                  <a:gd name="T15" fmla="*/ 57 h 57"/>
                  <a:gd name="T16" fmla="*/ 83 w 83"/>
                  <a:gd name="T17" fmla="*/ 47 h 57"/>
                  <a:gd name="T18" fmla="*/ 83 w 83"/>
                  <a:gd name="T19" fmla="*/ 11 h 57"/>
                  <a:gd name="T20" fmla="*/ 80 w 83"/>
                  <a:gd name="T21" fmla="*/ 3 h 57"/>
                  <a:gd name="T22" fmla="*/ 41 w 83"/>
                  <a:gd name="T23" fmla="*/ 32 h 57"/>
                  <a:gd name="T24" fmla="*/ 11 w 83"/>
                  <a:gd name="T25" fmla="*/ 7 h 57"/>
                  <a:gd name="T26" fmla="*/ 72 w 83"/>
                  <a:gd name="T27" fmla="*/ 7 h 57"/>
                  <a:gd name="T28" fmla="*/ 41 w 83"/>
                  <a:gd name="T29" fmla="*/ 32 h 57"/>
                  <a:gd name="T30" fmla="*/ 76 w 83"/>
                  <a:gd name="T31" fmla="*/ 47 h 57"/>
                  <a:gd name="T32" fmla="*/ 73 w 83"/>
                  <a:gd name="T33" fmla="*/ 51 h 57"/>
                  <a:gd name="T34" fmla="*/ 10 w 83"/>
                  <a:gd name="T35" fmla="*/ 51 h 57"/>
                  <a:gd name="T36" fmla="*/ 6 w 83"/>
                  <a:gd name="T37" fmla="*/ 47 h 57"/>
                  <a:gd name="T38" fmla="*/ 6 w 83"/>
                  <a:gd name="T39" fmla="*/ 11 h 57"/>
                  <a:gd name="T40" fmla="*/ 39 w 83"/>
                  <a:gd name="T41" fmla="*/ 38 h 57"/>
                  <a:gd name="T42" fmla="*/ 41 w 83"/>
                  <a:gd name="T43" fmla="*/ 39 h 57"/>
                  <a:gd name="T44" fmla="*/ 44 w 83"/>
                  <a:gd name="T45" fmla="*/ 38 h 57"/>
                  <a:gd name="T46" fmla="*/ 76 w 83"/>
                  <a:gd name="T47" fmla="*/ 11 h 57"/>
                  <a:gd name="T48" fmla="*/ 76 w 83"/>
                  <a:gd name="T49" fmla="*/ 4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</a:cxnLst>
                <a:rect l="0" t="0" r="r" b="b"/>
                <a:pathLst>
                  <a:path w="83" h="57">
                    <a:moveTo>
                      <a:pt x="80" y="3"/>
                    </a:moveTo>
                    <a:cubicBezTo>
                      <a:pt x="78" y="1"/>
                      <a:pt x="76" y="0"/>
                      <a:pt x="73" y="0"/>
                    </a:cubicBezTo>
                    <a:cubicBezTo>
                      <a:pt x="10" y="0"/>
                      <a:pt x="10" y="0"/>
                      <a:pt x="10" y="0"/>
                    </a:cubicBezTo>
                    <a:cubicBezTo>
                      <a:pt x="7" y="0"/>
                      <a:pt x="5" y="1"/>
                      <a:pt x="3" y="3"/>
                    </a:cubicBezTo>
                    <a:cubicBezTo>
                      <a:pt x="2" y="4"/>
                      <a:pt x="0" y="7"/>
                      <a:pt x="0" y="11"/>
                    </a:cubicBezTo>
                    <a:cubicBezTo>
                      <a:pt x="0" y="47"/>
                      <a:pt x="0" y="47"/>
                      <a:pt x="0" y="47"/>
                    </a:cubicBezTo>
                    <a:cubicBezTo>
                      <a:pt x="0" y="53"/>
                      <a:pt x="4" y="57"/>
                      <a:pt x="10" y="57"/>
                    </a:cubicBezTo>
                    <a:cubicBezTo>
                      <a:pt x="73" y="57"/>
                      <a:pt x="73" y="57"/>
                      <a:pt x="73" y="57"/>
                    </a:cubicBezTo>
                    <a:cubicBezTo>
                      <a:pt x="78" y="57"/>
                      <a:pt x="83" y="53"/>
                      <a:pt x="83" y="47"/>
                    </a:cubicBezTo>
                    <a:cubicBezTo>
                      <a:pt x="83" y="11"/>
                      <a:pt x="83" y="11"/>
                      <a:pt x="83" y="11"/>
                    </a:cubicBezTo>
                    <a:cubicBezTo>
                      <a:pt x="83" y="7"/>
                      <a:pt x="81" y="4"/>
                      <a:pt x="80" y="3"/>
                    </a:cubicBezTo>
                    <a:close/>
                    <a:moveTo>
                      <a:pt x="41" y="32"/>
                    </a:moveTo>
                    <a:cubicBezTo>
                      <a:pt x="11" y="7"/>
                      <a:pt x="11" y="7"/>
                      <a:pt x="11" y="7"/>
                    </a:cubicBezTo>
                    <a:cubicBezTo>
                      <a:pt x="72" y="7"/>
                      <a:pt x="72" y="7"/>
                      <a:pt x="72" y="7"/>
                    </a:cubicBezTo>
                    <a:lnTo>
                      <a:pt x="41" y="32"/>
                    </a:lnTo>
                    <a:close/>
                    <a:moveTo>
                      <a:pt x="76" y="47"/>
                    </a:moveTo>
                    <a:cubicBezTo>
                      <a:pt x="76" y="49"/>
                      <a:pt x="75" y="51"/>
                      <a:pt x="73" y="51"/>
                    </a:cubicBezTo>
                    <a:cubicBezTo>
                      <a:pt x="10" y="51"/>
                      <a:pt x="10" y="51"/>
                      <a:pt x="10" y="51"/>
                    </a:cubicBezTo>
                    <a:cubicBezTo>
                      <a:pt x="8" y="51"/>
                      <a:pt x="6" y="49"/>
                      <a:pt x="6" y="47"/>
                    </a:cubicBezTo>
                    <a:cubicBezTo>
                      <a:pt x="6" y="11"/>
                      <a:pt x="6" y="11"/>
                      <a:pt x="6" y="11"/>
                    </a:cubicBezTo>
                    <a:cubicBezTo>
                      <a:pt x="39" y="38"/>
                      <a:pt x="39" y="38"/>
                      <a:pt x="39" y="38"/>
                    </a:cubicBezTo>
                    <a:cubicBezTo>
                      <a:pt x="40" y="39"/>
                      <a:pt x="41" y="39"/>
                      <a:pt x="41" y="39"/>
                    </a:cubicBezTo>
                    <a:cubicBezTo>
                      <a:pt x="42" y="39"/>
                      <a:pt x="43" y="39"/>
                      <a:pt x="44" y="38"/>
                    </a:cubicBezTo>
                    <a:cubicBezTo>
                      <a:pt x="76" y="11"/>
                      <a:pt x="76" y="11"/>
                      <a:pt x="76" y="11"/>
                    </a:cubicBezTo>
                    <a:lnTo>
                      <a:pt x="76" y="47"/>
                    </a:lnTo>
                    <a:close/>
                  </a:path>
                </a:pathLst>
              </a:custGeom>
              <a:grpFill/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Freeform 81">
                <a:extLst>
                  <a:ext uri="{FF2B5EF4-FFF2-40B4-BE49-F238E27FC236}">
                    <a16:creationId xmlns:a16="http://schemas.microsoft.com/office/drawing/2014/main" id="{CBAC0E1B-B156-ADA7-0DE5-69324C3A58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390232" y="3198095"/>
                <a:ext cx="49715" cy="46953"/>
              </a:xfrm>
              <a:custGeom>
                <a:avLst/>
                <a:gdLst>
                  <a:gd name="T0" fmla="*/ 16 w 18"/>
                  <a:gd name="T1" fmla="*/ 17 h 17"/>
                  <a:gd name="T2" fmla="*/ 17 w 18"/>
                  <a:gd name="T3" fmla="*/ 17 h 17"/>
                  <a:gd name="T4" fmla="*/ 18 w 18"/>
                  <a:gd name="T5" fmla="*/ 17 h 17"/>
                  <a:gd name="T6" fmla="*/ 17 w 18"/>
                  <a:gd name="T7" fmla="*/ 15 h 17"/>
                  <a:gd name="T8" fmla="*/ 2 w 18"/>
                  <a:gd name="T9" fmla="*/ 0 h 17"/>
                  <a:gd name="T10" fmla="*/ 1 w 18"/>
                  <a:gd name="T11" fmla="*/ 0 h 17"/>
                  <a:gd name="T12" fmla="*/ 0 w 18"/>
                  <a:gd name="T13" fmla="*/ 0 h 17"/>
                  <a:gd name="T14" fmla="*/ 0 w 18"/>
                  <a:gd name="T15" fmla="*/ 2 h 17"/>
                  <a:gd name="T16" fmla="*/ 16 w 18"/>
                  <a:gd name="T17" fmla="*/ 17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8" h="17">
                    <a:moveTo>
                      <a:pt x="16" y="17"/>
                    </a:moveTo>
                    <a:cubicBezTo>
                      <a:pt x="16" y="17"/>
                      <a:pt x="16" y="17"/>
                      <a:pt x="17" y="17"/>
                    </a:cubicBezTo>
                    <a:cubicBezTo>
                      <a:pt x="17" y="17"/>
                      <a:pt x="17" y="17"/>
                      <a:pt x="18" y="17"/>
                    </a:cubicBezTo>
                    <a:cubicBezTo>
                      <a:pt x="18" y="16"/>
                      <a:pt x="18" y="15"/>
                      <a:pt x="17" y="15"/>
                    </a:cubicBezTo>
                    <a:cubicBezTo>
                      <a:pt x="2" y="0"/>
                      <a:pt x="2" y="0"/>
                      <a:pt x="2" y="0"/>
                    </a:cubicBezTo>
                    <a:cubicBezTo>
                      <a:pt x="2" y="0"/>
                      <a:pt x="2" y="0"/>
                      <a:pt x="1" y="0"/>
                    </a:cubicBezTo>
                    <a:cubicBezTo>
                      <a:pt x="1" y="0"/>
                      <a:pt x="0" y="0"/>
                      <a:pt x="0" y="0"/>
                    </a:cubicBezTo>
                    <a:cubicBezTo>
                      <a:pt x="0" y="1"/>
                      <a:pt x="0" y="2"/>
                      <a:pt x="0" y="2"/>
                    </a:cubicBezTo>
                    <a:lnTo>
                      <a:pt x="16" y="17"/>
                    </a:lnTo>
                    <a:close/>
                  </a:path>
                </a:pathLst>
              </a:custGeom>
              <a:grpFill/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Freeform 82">
                <a:extLst>
                  <a:ext uri="{FF2B5EF4-FFF2-40B4-BE49-F238E27FC236}">
                    <a16:creationId xmlns:a16="http://schemas.microsoft.com/office/drawing/2014/main" id="{AECE5861-CBD7-95E0-A4B2-89E72DF973A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475852" y="3119380"/>
                <a:ext cx="142241" cy="142241"/>
              </a:xfrm>
              <a:custGeom>
                <a:avLst/>
                <a:gdLst>
                  <a:gd name="T0" fmla="*/ 101 w 103"/>
                  <a:gd name="T1" fmla="*/ 77 h 103"/>
                  <a:gd name="T2" fmla="*/ 75 w 103"/>
                  <a:gd name="T3" fmla="*/ 103 h 103"/>
                  <a:gd name="T4" fmla="*/ 43 w 103"/>
                  <a:gd name="T5" fmla="*/ 71 h 103"/>
                  <a:gd name="T6" fmla="*/ 26 w 103"/>
                  <a:gd name="T7" fmla="*/ 103 h 103"/>
                  <a:gd name="T8" fmla="*/ 0 w 103"/>
                  <a:gd name="T9" fmla="*/ 0 h 103"/>
                  <a:gd name="T10" fmla="*/ 103 w 103"/>
                  <a:gd name="T11" fmla="*/ 27 h 103"/>
                  <a:gd name="T12" fmla="*/ 69 w 103"/>
                  <a:gd name="T13" fmla="*/ 45 h 103"/>
                  <a:gd name="T14" fmla="*/ 101 w 103"/>
                  <a:gd name="T15" fmla="*/ 77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03" h="103">
                    <a:moveTo>
                      <a:pt x="101" y="77"/>
                    </a:moveTo>
                    <a:lnTo>
                      <a:pt x="75" y="103"/>
                    </a:lnTo>
                    <a:lnTo>
                      <a:pt x="43" y="71"/>
                    </a:lnTo>
                    <a:lnTo>
                      <a:pt x="26" y="103"/>
                    </a:lnTo>
                    <a:lnTo>
                      <a:pt x="0" y="0"/>
                    </a:lnTo>
                    <a:lnTo>
                      <a:pt x="103" y="27"/>
                    </a:lnTo>
                    <a:lnTo>
                      <a:pt x="69" y="45"/>
                    </a:lnTo>
                    <a:lnTo>
                      <a:pt x="101" y="77"/>
                    </a:lnTo>
                    <a:close/>
                  </a:path>
                </a:pathLst>
              </a:custGeom>
              <a:grpFill/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6" name="箭头: 左右 45">
              <a:extLst>
                <a:ext uri="{FF2B5EF4-FFF2-40B4-BE49-F238E27FC236}">
                  <a16:creationId xmlns:a16="http://schemas.microsoft.com/office/drawing/2014/main" id="{7EFA67DB-7AC3-AF50-3753-64DFE08A9AC3}"/>
                </a:ext>
              </a:extLst>
            </p:cNvPr>
            <p:cNvSpPr/>
            <p:nvPr/>
          </p:nvSpPr>
          <p:spPr>
            <a:xfrm>
              <a:off x="6431063" y="3042166"/>
              <a:ext cx="571755" cy="223746"/>
            </a:xfrm>
            <a:prstGeom prst="leftRightArrow">
              <a:avLst/>
            </a:prstGeom>
            <a:solidFill>
              <a:schemeClr val="tx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箭头: 左右 46">
              <a:extLst>
                <a:ext uri="{FF2B5EF4-FFF2-40B4-BE49-F238E27FC236}">
                  <a16:creationId xmlns:a16="http://schemas.microsoft.com/office/drawing/2014/main" id="{9E5C51D4-4022-3863-0303-92BC1E362296}"/>
                </a:ext>
              </a:extLst>
            </p:cNvPr>
            <p:cNvSpPr/>
            <p:nvPr/>
          </p:nvSpPr>
          <p:spPr>
            <a:xfrm>
              <a:off x="8575448" y="3066571"/>
              <a:ext cx="571755" cy="223746"/>
            </a:xfrm>
            <a:prstGeom prst="leftRightArrow">
              <a:avLst/>
            </a:prstGeom>
            <a:solidFill>
              <a:schemeClr val="tx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32D24C78-91BC-99F4-0A98-0692729A0ED5}"/>
                </a:ext>
              </a:extLst>
            </p:cNvPr>
            <p:cNvSpPr txBox="1"/>
            <p:nvPr/>
          </p:nvSpPr>
          <p:spPr>
            <a:xfrm>
              <a:off x="6786459" y="3276938"/>
              <a:ext cx="1028839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lliance enterpris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39FD1CD1-07D4-D87F-CE66-1AA22FC47B18}"/>
                </a:ext>
              </a:extLst>
            </p:cNvPr>
            <p:cNvSpPr txBox="1"/>
            <p:nvPr/>
          </p:nvSpPr>
          <p:spPr>
            <a:xfrm>
              <a:off x="8119538" y="3183326"/>
              <a:ext cx="974569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sk decompositio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384E5117-E888-E9FD-4010-B93279A82470}"/>
                </a:ext>
              </a:extLst>
            </p:cNvPr>
            <p:cNvSpPr txBox="1"/>
            <p:nvPr/>
          </p:nvSpPr>
          <p:spPr>
            <a:xfrm>
              <a:off x="5119210" y="3631063"/>
              <a:ext cx="198978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arket customers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AB0CD613-FF13-E39C-4FD8-17C48394DF59}"/>
                </a:ext>
              </a:extLst>
            </p:cNvPr>
            <p:cNvSpPr txBox="1"/>
            <p:nvPr/>
          </p:nvSpPr>
          <p:spPr>
            <a:xfrm>
              <a:off x="6391581" y="2806645"/>
              <a:ext cx="134287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lace an orde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201CF487-08A2-40A9-1BEE-0B945DFC4C36}"/>
                </a:ext>
              </a:extLst>
            </p:cNvPr>
            <p:cNvSpPr txBox="1"/>
            <p:nvPr/>
          </p:nvSpPr>
          <p:spPr>
            <a:xfrm>
              <a:off x="9228983" y="2477528"/>
              <a:ext cx="176388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Virtual market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FA7A85C6-DB31-E5C0-F34C-C6053002338E}"/>
                </a:ext>
              </a:extLst>
            </p:cNvPr>
            <p:cNvSpPr txBox="1"/>
            <p:nvPr/>
          </p:nvSpPr>
          <p:spPr>
            <a:xfrm>
              <a:off x="6942330" y="1986402"/>
              <a:ext cx="135748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gotiat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03DAA5E0-4E08-B3EE-6E7E-CF3F2AF9CB59}"/>
                </a:ext>
              </a:extLst>
            </p:cNvPr>
            <p:cNvSpPr txBox="1"/>
            <p:nvPr/>
          </p:nvSpPr>
          <p:spPr>
            <a:xfrm>
              <a:off x="6561845" y="4034210"/>
              <a:ext cx="135748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gotiat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2F8A67DA-B7F5-A2F1-6291-4BB05A999CBC}"/>
                </a:ext>
              </a:extLst>
            </p:cNvPr>
            <p:cNvSpPr txBox="1"/>
            <p:nvPr/>
          </p:nvSpPr>
          <p:spPr>
            <a:xfrm>
              <a:off x="6495786" y="4840139"/>
              <a:ext cx="1467556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otential member enterprises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470EC05E-D035-FEAE-D8E3-49E02121709A}"/>
                </a:ext>
              </a:extLst>
            </p:cNvPr>
            <p:cNvSpPr txBox="1"/>
            <p:nvPr/>
          </p:nvSpPr>
          <p:spPr>
            <a:xfrm>
              <a:off x="8499106" y="2640669"/>
              <a:ext cx="1143176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ervice description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BC85CAA7-7913-B131-A809-EA8D90113BA9}"/>
                </a:ext>
              </a:extLst>
            </p:cNvPr>
            <p:cNvSpPr txBox="1"/>
            <p:nvPr/>
          </p:nvSpPr>
          <p:spPr>
            <a:xfrm>
              <a:off x="6353610" y="1020938"/>
              <a:ext cx="1467556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otential member enterprises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73581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1</Words>
  <Application>Microsoft Office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</dc:creator>
  <cp:lastModifiedBy>Think</cp:lastModifiedBy>
  <cp:revision>1</cp:revision>
  <dcterms:created xsi:type="dcterms:W3CDTF">2022-10-08T11:08:02Z</dcterms:created>
  <dcterms:modified xsi:type="dcterms:W3CDTF">2022-10-08T11:30:57Z</dcterms:modified>
</cp:coreProperties>
</file>